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61" r:id="rId2"/>
    <p:sldId id="257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90" d="100"/>
          <a:sy n="90" d="100"/>
        </p:scale>
        <p:origin x="-944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notesMaster" Target="notesMasters/notesMaster1.xml"/><Relationship Id="rId8" Type="http://schemas.openxmlformats.org/officeDocument/2006/relationships/printerSettings" Target="printerSettings/printerSettings1.bin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A5AB9C-36E9-9448-A372-0D42012B7491}" type="datetimeFigureOut">
              <a:rPr lang="fr-FR" smtClean="0"/>
              <a:t>20/05/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5BD922-F39D-7540-BAF8-04F12A22073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9330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r-FR" dirty="0"/>
              <a:t>Ajouter A</a:t>
            </a:r>
            <a:br>
              <a:rPr lang="fr-FR" dirty="0"/>
            </a:br>
            <a:r>
              <a:rPr lang="fr-FR" dirty="0"/>
              <a:t>Un seul B avec </a:t>
            </a:r>
            <a:r>
              <a:rPr lang="fr-FR" dirty="0" err="1"/>
              <a:t>Fiocruz</a:t>
            </a:r>
            <a:r>
              <a:rPr lang="fr-FR" dirty="0"/>
              <a:t> et </a:t>
            </a:r>
            <a:r>
              <a:rPr lang="fr-FR" dirty="0" err="1"/>
              <a:t>Patoc</a:t>
            </a:r>
            <a:r>
              <a:rPr lang="fr-FR" dirty="0"/>
              <a:t> </a:t>
            </a:r>
          </a:p>
          <a:p>
            <a:r>
              <a:rPr lang="fr-FR" dirty="0"/>
              <a:t>Virer D</a:t>
            </a:r>
          </a:p>
          <a:p>
            <a:r>
              <a:rPr lang="fr-FR" dirty="0"/>
              <a:t>Et </a:t>
            </a:r>
            <a:r>
              <a:rPr lang="fr-FR"/>
              <a:t>mettre sérotypes en C</a:t>
            </a:r>
            <a:endParaRPr lang="fr-FR" dirty="0"/>
          </a:p>
          <a:p>
            <a:endParaRPr lang="fr-FR" dirty="0"/>
          </a:p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00C5ABF-8252-8D4B-9A5B-4E873B6B74EB}" type="slidenum">
              <a:rPr lang="fr-FR" smtClean="0"/>
              <a:t>2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398593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fr-FR" sz="1200" kern="1200" dirty="0" err="1">
                <a:solidFill>
                  <a:srgbClr val="0000FF"/>
                </a:solidFill>
                <a:latin typeface="+mn-lt"/>
                <a:ea typeface="+mn-ea"/>
                <a:cs typeface="Arial"/>
              </a:rPr>
              <a:t>Fig</a:t>
            </a:r>
            <a:r>
              <a:rPr lang="fr-FR" sz="1200" kern="1200" baseline="0" dirty="0">
                <a:solidFill>
                  <a:srgbClr val="0000FF"/>
                </a:solidFill>
                <a:latin typeface="+mn-lt"/>
                <a:ea typeface="+mn-ea"/>
                <a:cs typeface="Arial"/>
              </a:rPr>
              <a:t> 3 alignement à refaire avec </a:t>
            </a:r>
            <a:r>
              <a:rPr lang="fr-FR" sz="1200" kern="1200" baseline="0" dirty="0" err="1">
                <a:solidFill>
                  <a:srgbClr val="0000FF"/>
                </a:solidFill>
                <a:latin typeface="+mn-lt"/>
                <a:ea typeface="+mn-ea"/>
                <a:cs typeface="Arial"/>
              </a:rPr>
              <a:t>sequence</a:t>
            </a:r>
            <a:r>
              <a:rPr lang="fr-FR" sz="1200" kern="1200" baseline="0" dirty="0">
                <a:solidFill>
                  <a:srgbClr val="0000FF"/>
                </a:solidFill>
                <a:latin typeface="+mn-lt"/>
                <a:ea typeface="+mn-ea"/>
                <a:cs typeface="Arial"/>
              </a:rPr>
              <a:t> </a:t>
            </a:r>
            <a:r>
              <a:rPr lang="fr-FR" sz="1200" kern="1200" baseline="0" dirty="0" err="1">
                <a:solidFill>
                  <a:srgbClr val="0000FF"/>
                </a:solidFill>
                <a:latin typeface="+mn-lt"/>
                <a:ea typeface="+mn-ea"/>
                <a:cs typeface="Arial"/>
              </a:rPr>
              <a:t>lepto</a:t>
            </a:r>
            <a:r>
              <a:rPr lang="fr-FR" sz="1200" kern="1200" baseline="0" dirty="0">
                <a:solidFill>
                  <a:srgbClr val="0000FF"/>
                </a:solidFill>
                <a:latin typeface="+mn-lt"/>
                <a:ea typeface="+mn-ea"/>
                <a:cs typeface="Arial"/>
              </a:rPr>
              <a:t> </a:t>
            </a:r>
            <a:r>
              <a:rPr lang="fr-FR" sz="1200" kern="1200" baseline="0" dirty="0" err="1">
                <a:solidFill>
                  <a:srgbClr val="0000FF"/>
                </a:solidFill>
                <a:latin typeface="+mn-lt"/>
                <a:ea typeface="+mn-ea"/>
                <a:cs typeface="Arial"/>
              </a:rPr>
              <a:t>compléte</a:t>
            </a:r>
            <a:r>
              <a:rPr lang="fr-FR" sz="1200" kern="1200" baseline="0" dirty="0">
                <a:solidFill>
                  <a:srgbClr val="0000FF"/>
                </a:solidFill>
                <a:latin typeface="+mn-lt"/>
                <a:ea typeface="+mn-ea"/>
                <a:cs typeface="Arial"/>
              </a:rPr>
              <a:t> </a:t>
            </a:r>
            <a:endParaRPr lang="fr-FR" sz="1200" kern="1200" dirty="0">
              <a:solidFill>
                <a:srgbClr val="0000FF"/>
              </a:solidFill>
              <a:latin typeface="+mn-lt"/>
              <a:ea typeface="+mn-ea"/>
              <a:cs typeface="Arial"/>
            </a:endParaRP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fr-FR" sz="1200" kern="1200" dirty="0">
                <a:solidFill>
                  <a:srgbClr val="0000FF"/>
                </a:solidFill>
                <a:latin typeface="+mn-lt"/>
                <a:ea typeface="+mn-ea"/>
                <a:cs typeface="Arial"/>
              </a:rPr>
              <a:t> </a:t>
            </a:r>
            <a:r>
              <a:rPr lang="fr-FR" sz="1200" kern="1200" dirty="0" err="1">
                <a:solidFill>
                  <a:srgbClr val="0000FF"/>
                </a:solidFill>
                <a:latin typeface="+mn-lt"/>
                <a:ea typeface="+mn-ea"/>
                <a:cs typeface="Arial"/>
              </a:rPr>
              <a:t>Leptospiral</a:t>
            </a:r>
            <a:r>
              <a:rPr lang="fr-FR" sz="1200" i="1" kern="1200" dirty="0">
                <a:solidFill>
                  <a:srgbClr val="0000FF"/>
                </a:solidFill>
                <a:latin typeface="+mn-lt"/>
                <a:ea typeface="+mn-ea"/>
                <a:cs typeface="Arial"/>
              </a:rPr>
              <a:t> </a:t>
            </a:r>
            <a:r>
              <a:rPr lang="fr-FR" sz="1200" kern="1200" dirty="0">
                <a:solidFill>
                  <a:srgbClr val="0000FF"/>
                </a:solidFill>
                <a:latin typeface="+mn-lt"/>
                <a:ea typeface="+mn-ea"/>
                <a:cs typeface="Arial"/>
              </a:rPr>
              <a:t>FLAB</a:t>
            </a:r>
            <a:r>
              <a:rPr lang="fr-FR" sz="1200" i="1" kern="1200" dirty="0">
                <a:solidFill>
                  <a:srgbClr val="0000FF"/>
                </a:solidFill>
                <a:latin typeface="+mn-lt"/>
                <a:ea typeface="+mn-ea"/>
                <a:cs typeface="Arial"/>
              </a:rPr>
              <a:t> </a:t>
            </a:r>
            <a:r>
              <a:rPr lang="fr-FR" sz="1200" kern="1200" dirty="0">
                <a:solidFill>
                  <a:srgbClr val="0000FF"/>
                </a:solidFill>
                <a:latin typeface="+mn-lt"/>
                <a:ea typeface="+mn-ea"/>
                <a:cs typeface="Arial"/>
              </a:rPr>
              <a:t>do have the consensus of TLR5 </a:t>
            </a:r>
            <a:r>
              <a:rPr lang="fr-FR" sz="1200" kern="1200" dirty="0" err="1">
                <a:solidFill>
                  <a:srgbClr val="0000FF"/>
                </a:solidFill>
                <a:latin typeface="+mn-lt"/>
                <a:ea typeface="+mn-ea"/>
                <a:cs typeface="Arial"/>
              </a:rPr>
              <a:t>activating</a:t>
            </a:r>
            <a:r>
              <a:rPr lang="fr-FR" sz="1200" kern="1200" dirty="0">
                <a:solidFill>
                  <a:srgbClr val="0000FF"/>
                </a:solidFill>
                <a:latin typeface="+mn-lt"/>
                <a:ea typeface="+mn-ea"/>
                <a:cs typeface="Arial"/>
              </a:rPr>
              <a:t> </a:t>
            </a:r>
            <a:r>
              <a:rPr lang="fr-FR" sz="1200" kern="1200" dirty="0" err="1">
                <a:solidFill>
                  <a:srgbClr val="0000FF"/>
                </a:solidFill>
                <a:latin typeface="+mn-lt"/>
                <a:ea typeface="+mn-ea"/>
                <a:cs typeface="Arial"/>
              </a:rPr>
              <a:t>flagellins</a:t>
            </a:r>
            <a:endParaRPr lang="fr-FR" sz="1200" kern="1200" dirty="0">
              <a:solidFill>
                <a:srgbClr val="0000FF"/>
              </a:solidFill>
              <a:latin typeface="+mn-lt"/>
              <a:ea typeface="+mn-ea"/>
              <a:cs typeface="Arial"/>
            </a:endParaRPr>
          </a:p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8978A0A-5D16-6B4B-B61F-471AD565C409}" type="slidenum">
              <a:rPr lang="fr-FR" smtClean="0"/>
              <a:t>3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796099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fontAlgn="b"/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up4A</a:t>
            </a: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fr-FR" sz="1200" b="1" i="1" kern="1200" dirty="0">
                <a:solidFill>
                  <a:srgbClr val="0000FF"/>
                </a:solidFill>
                <a:latin typeface="+mn-lt"/>
                <a:ea typeface="+mn-ea"/>
                <a:cs typeface="Arial"/>
              </a:rPr>
              <a:t>Reference: </a:t>
            </a: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fr-FR" sz="1200" b="1" i="1" kern="1200" dirty="0">
              <a:solidFill>
                <a:srgbClr val="0000FF"/>
              </a:solidFill>
              <a:latin typeface="+mn-lt"/>
              <a:ea typeface="+mn-ea"/>
              <a:cs typeface="Arial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conserved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TLR5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binding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and activation hot spot on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flagellin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fr-FR" sz="1200" i="1" dirty="0">
                <a:latin typeface="Arial" panose="020B0604020202020204" pitchFamily="34" charset="0"/>
                <a:cs typeface="Arial" panose="020B0604020202020204" pitchFamily="34" charset="0"/>
              </a:rPr>
              <a:t>Song et al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., 2017,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Sci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. Reports</a:t>
            </a:r>
            <a:endParaRPr lang="fr-FR" sz="1200" b="1" i="1" kern="1200" dirty="0">
              <a:solidFill>
                <a:srgbClr val="0000FF"/>
              </a:solidFill>
              <a:latin typeface="+mn-lt"/>
              <a:ea typeface="+mn-ea"/>
              <a:cs typeface="Arial"/>
            </a:endParaRPr>
          </a:p>
          <a:p>
            <a:pPr fontAlgn="b"/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b"/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b"/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Clustal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alignment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(MEGA software) of the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following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sequences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GeneBank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):</a:t>
            </a:r>
          </a:p>
          <a:p>
            <a:pPr fontAlgn="b"/>
            <a:endParaRPr lang="fr-FR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b"/>
            <a:r>
              <a:rPr lang="fr-FR" sz="1100" i="1" dirty="0">
                <a:latin typeface="Arial" panose="020B0604020202020204" pitchFamily="34" charset="0"/>
                <a:cs typeface="Arial" panose="020B0604020202020204" pitchFamily="34" charset="0"/>
              </a:rPr>
              <a:t>Leptospira </a:t>
            </a:r>
            <a:r>
              <a:rPr lang="fr-FR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interrogans</a:t>
            </a:r>
            <a:r>
              <a:rPr lang="fr-FR" sz="11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100" dirty="0" err="1">
                <a:latin typeface="Arial" panose="020B0604020202020204" pitchFamily="34" charset="0"/>
                <a:cs typeface="Arial" panose="020B0604020202020204" pitchFamily="34" charset="0"/>
              </a:rPr>
              <a:t>serovar</a:t>
            </a:r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100" dirty="0" err="1">
                <a:latin typeface="Arial" panose="020B0604020202020204" pitchFamily="34" charset="0"/>
                <a:cs typeface="Arial" panose="020B0604020202020204" pitchFamily="34" charset="0"/>
              </a:rPr>
              <a:t>Copenhageni</a:t>
            </a:r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100" dirty="0" err="1">
                <a:latin typeface="Arial" panose="020B0604020202020204" pitchFamily="34" charset="0"/>
                <a:cs typeface="Arial" panose="020B0604020202020204" pitchFamily="34" charset="0"/>
              </a:rPr>
              <a:t>strain</a:t>
            </a:r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100" dirty="0" err="1">
                <a:latin typeface="Arial" panose="020B0604020202020204" pitchFamily="34" charset="0"/>
                <a:cs typeface="Arial" panose="020B0604020202020204" pitchFamily="34" charset="0"/>
              </a:rPr>
              <a:t>Fiocruz</a:t>
            </a:r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FlaB1</a:t>
            </a:r>
          </a:p>
          <a:p>
            <a:pPr fontAlgn="b"/>
            <a:r>
              <a:rPr lang="fr-FR" sz="1100" i="1" dirty="0">
                <a:latin typeface="Arial" panose="020B0604020202020204" pitchFamily="34" charset="0"/>
                <a:cs typeface="Arial" panose="020B0604020202020204" pitchFamily="34" charset="0"/>
              </a:rPr>
              <a:t>Leptospira </a:t>
            </a:r>
            <a:r>
              <a:rPr lang="fr-FR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biflexa</a:t>
            </a:r>
            <a:r>
              <a:rPr lang="fr-FR" sz="11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100" dirty="0" err="1">
                <a:latin typeface="Arial" panose="020B0604020202020204" pitchFamily="34" charset="0"/>
                <a:cs typeface="Arial" panose="020B0604020202020204" pitchFamily="34" charset="0"/>
              </a:rPr>
              <a:t>serovar</a:t>
            </a:r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100" dirty="0" err="1">
                <a:latin typeface="Arial" panose="020B0604020202020204" pitchFamily="34" charset="0"/>
                <a:cs typeface="Arial" panose="020B0604020202020204" pitchFamily="34" charset="0"/>
              </a:rPr>
              <a:t>Patoc</a:t>
            </a:r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100" dirty="0" err="1">
                <a:latin typeface="Arial" panose="020B0604020202020204" pitchFamily="34" charset="0"/>
                <a:cs typeface="Arial" panose="020B0604020202020204" pitchFamily="34" charset="0"/>
              </a:rPr>
              <a:t>strain</a:t>
            </a:r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100" dirty="0" err="1">
                <a:latin typeface="Arial" panose="020B0604020202020204" pitchFamily="34" charset="0"/>
                <a:cs typeface="Arial" panose="020B0604020202020204" pitchFamily="34" charset="0"/>
              </a:rPr>
              <a:t>Patoc</a:t>
            </a:r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FlaB1</a:t>
            </a:r>
          </a:p>
          <a:p>
            <a:pPr fontAlgn="b"/>
            <a:endParaRPr lang="fr-FR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b"/>
            <a:r>
              <a:rPr lang="fr-FR" sz="1100" i="1" dirty="0">
                <a:latin typeface="Arial" panose="020B0604020202020204" pitchFamily="34" charset="0"/>
                <a:cs typeface="Arial" panose="020B0604020202020204" pitchFamily="34" charset="0"/>
              </a:rPr>
              <a:t>Borrelia burgdorferi </a:t>
            </a:r>
            <a:r>
              <a:rPr lang="fr-FR" sz="1100" dirty="0" err="1">
                <a:latin typeface="Arial" panose="020B0604020202020204" pitchFamily="34" charset="0"/>
                <a:cs typeface="Arial" panose="020B0604020202020204" pitchFamily="34" charset="0"/>
              </a:rPr>
              <a:t>flagellin</a:t>
            </a:r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 									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CAA45011.1</a:t>
            </a:r>
            <a:endParaRPr lang="fr-FR" sz="11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b"/>
            <a:r>
              <a:rPr lang="fr-FR" sz="1100" i="1" dirty="0">
                <a:latin typeface="Arial" panose="020B0604020202020204" pitchFamily="34" charset="0"/>
                <a:cs typeface="Arial" panose="020B0604020202020204" pitchFamily="34" charset="0"/>
              </a:rPr>
              <a:t>Treponema</a:t>
            </a:r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100" dirty="0" err="1">
                <a:latin typeface="Arial" panose="020B0604020202020204" pitchFamily="34" charset="0"/>
                <a:cs typeface="Arial" panose="020B0604020202020204" pitchFamily="34" charset="0"/>
              </a:rPr>
              <a:t>ssp</a:t>
            </a:r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fr-FR" sz="1100" dirty="0" err="1">
                <a:latin typeface="Arial" panose="020B0604020202020204" pitchFamily="34" charset="0"/>
                <a:cs typeface="Arial" panose="020B0604020202020204" pitchFamily="34" charset="0"/>
              </a:rPr>
              <a:t>Flagellin</a:t>
            </a:r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									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AIW88993.1</a:t>
            </a:r>
            <a:endParaRPr lang="fr-FR" sz="11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b"/>
            <a:endParaRPr lang="fr-FR" sz="11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b"/>
            <a:r>
              <a:rPr lang="fr-FR" sz="1100" i="1" dirty="0">
                <a:latin typeface="Arial" panose="020B0604020202020204" pitchFamily="34" charset="0"/>
                <a:cs typeface="Arial" panose="020B0604020202020204" pitchFamily="34" charset="0"/>
              </a:rPr>
              <a:t>Bacillus subtilis </a:t>
            </a:r>
            <a:r>
              <a:rPr lang="fr-FR" sz="1100" dirty="0" err="1">
                <a:latin typeface="Arial" panose="020B0604020202020204" pitchFamily="34" charset="0"/>
                <a:cs typeface="Arial" panose="020B0604020202020204" pitchFamily="34" charset="0"/>
              </a:rPr>
              <a:t>subsp</a:t>
            </a:r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fr-FR" sz="1100" dirty="0" err="1">
                <a:latin typeface="Arial" panose="020B0604020202020204" pitchFamily="34" charset="0"/>
                <a:cs typeface="Arial" panose="020B0604020202020204" pitchFamily="34" charset="0"/>
              </a:rPr>
              <a:t>spizizenii</a:t>
            </a:r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100" dirty="0" err="1">
                <a:latin typeface="Arial" panose="020B0604020202020204" pitchFamily="34" charset="0"/>
                <a:cs typeface="Arial" panose="020B0604020202020204" pitchFamily="34" charset="0"/>
              </a:rPr>
              <a:t>flagellin</a:t>
            </a:r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							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ADM39502.1</a:t>
            </a:r>
            <a:endParaRPr lang="fr-FR" sz="11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100" i="1" dirty="0">
                <a:latin typeface="Arial" panose="020B0604020202020204" pitchFamily="34" charset="0"/>
                <a:cs typeface="Arial" panose="020B0604020202020204" pitchFamily="34" charset="0"/>
              </a:rPr>
              <a:t>Salmonella enterica </a:t>
            </a:r>
            <a:r>
              <a:rPr lang="fr-FR" sz="1100" dirty="0" err="1">
                <a:latin typeface="Arial" panose="020B0604020202020204" pitchFamily="34" charset="0"/>
                <a:cs typeface="Arial" panose="020B0604020202020204" pitchFamily="34" charset="0"/>
              </a:rPr>
              <a:t>subsp</a:t>
            </a:r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. enterica </a:t>
            </a:r>
            <a:r>
              <a:rPr lang="fr-FR" sz="1100" dirty="0" err="1">
                <a:latin typeface="Arial" panose="020B0604020202020204" pitchFamily="34" charset="0"/>
                <a:cs typeface="Arial" panose="020B0604020202020204" pitchFamily="34" charset="0"/>
              </a:rPr>
              <a:t>serovar</a:t>
            </a:r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100" dirty="0" err="1">
                <a:latin typeface="Arial" panose="020B0604020202020204" pitchFamily="34" charset="0"/>
                <a:cs typeface="Arial" panose="020B0604020202020204" pitchFamily="34" charset="0"/>
              </a:rPr>
              <a:t>Typhimurium</a:t>
            </a:r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FliC</a:t>
            </a:r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r-FR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reference</a:t>
            </a:r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)			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QDQ31983.1</a:t>
            </a:r>
            <a:endParaRPr lang="fr-FR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b"/>
            <a:r>
              <a:rPr lang="it-IT" sz="1100" i="1" dirty="0">
                <a:latin typeface="Arial" panose="020B0604020202020204" pitchFamily="34" charset="0"/>
                <a:cs typeface="Arial" panose="020B0604020202020204" pitchFamily="34" charset="0"/>
              </a:rPr>
              <a:t>Escherichia coli 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O111:H11 str. CVM9455 flagellin 						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EJE83379.1</a:t>
            </a:r>
            <a:endParaRPr lang="fr-FR" sz="1000" b="1" dirty="0">
              <a:solidFill>
                <a:srgbClr val="000000"/>
              </a:solidFill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  <a:p>
            <a:pPr fontAlgn="b"/>
            <a:endParaRPr lang="fr-FR" sz="1100" dirty="0">
              <a:solidFill>
                <a:srgbClr val="000000"/>
              </a:solidFill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  <a:p>
            <a:pPr fontAlgn="b"/>
            <a:r>
              <a:rPr lang="fr-FR" sz="1100" i="1" dirty="0">
                <a:latin typeface="Arial" panose="020B0604020202020204" pitchFamily="34" charset="0"/>
                <a:cs typeface="Arial" panose="020B0604020202020204" pitchFamily="34" charset="0"/>
              </a:rPr>
              <a:t>Helicobacter pylori </a:t>
            </a:r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J99 </a:t>
            </a:r>
            <a:r>
              <a:rPr lang="fr-FR" sz="1100" dirty="0" err="1">
                <a:latin typeface="Arial" panose="020B0604020202020204" pitchFamily="34" charset="0"/>
                <a:cs typeface="Arial" panose="020B0604020202020204" pitchFamily="34" charset="0"/>
              </a:rPr>
              <a:t>flagellin</a:t>
            </a:r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 								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AKE81874.1</a:t>
            </a:r>
            <a:endParaRPr lang="fr-FR" sz="105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b"/>
            <a:r>
              <a:rPr lang="fr-FR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Bartonnela</a:t>
            </a:r>
            <a:r>
              <a:rPr lang="fr-FR" sz="11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bacilliformis</a:t>
            </a:r>
            <a:r>
              <a:rPr lang="fr-FR" sz="11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100" dirty="0" err="1">
                <a:latin typeface="Arial" panose="020B0604020202020204" pitchFamily="34" charset="0"/>
                <a:cs typeface="Arial" panose="020B0604020202020204" pitchFamily="34" charset="0"/>
              </a:rPr>
              <a:t>flagellin</a:t>
            </a:r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								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AAA22899.1</a:t>
            </a:r>
          </a:p>
          <a:p>
            <a:pPr fontAlgn="b"/>
            <a:endParaRPr lang="fr-FR" sz="10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b"/>
            <a:endParaRPr lang="fr-FR" sz="11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8978A0A-5D16-6B4B-B61F-471AD565C409}" type="slidenum">
              <a:rPr lang="fr-FR" smtClean="0"/>
              <a:t>4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251143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107533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fr-FR" sz="1200" b="1" i="1" kern="1200" dirty="0" err="1">
                <a:solidFill>
                  <a:srgbClr val="0000FF"/>
                </a:solidFill>
                <a:latin typeface="+mn-lt"/>
                <a:ea typeface="+mn-ea"/>
                <a:cs typeface="Arial"/>
              </a:rPr>
              <a:t>References</a:t>
            </a:r>
            <a:r>
              <a:rPr lang="fr-FR" sz="1200" b="1" i="1" kern="1200" dirty="0">
                <a:solidFill>
                  <a:srgbClr val="0000FF"/>
                </a:solidFill>
                <a:latin typeface="+mn-lt"/>
                <a:ea typeface="+mn-ea"/>
                <a:cs typeface="Arial"/>
              </a:rPr>
              <a:t>: </a:t>
            </a:r>
          </a:p>
          <a:p>
            <a:endParaRPr lang="fr-FR" dirty="0"/>
          </a:p>
          <a:p>
            <a:r>
              <a:rPr lang="fr-FR" dirty="0"/>
              <a:t>A </a:t>
            </a:r>
            <a:r>
              <a:rPr lang="fr-FR" dirty="0" err="1"/>
              <a:t>novel</a:t>
            </a:r>
            <a:r>
              <a:rPr lang="fr-FR" dirty="0"/>
              <a:t> </a:t>
            </a:r>
            <a:r>
              <a:rPr lang="fr-FR" dirty="0" err="1"/>
              <a:t>glycan</a:t>
            </a:r>
            <a:r>
              <a:rPr lang="fr-FR" dirty="0"/>
              <a:t> modifies the </a:t>
            </a:r>
            <a:r>
              <a:rPr lang="fr-FR" dirty="0" err="1"/>
              <a:t>flagellar</a:t>
            </a:r>
            <a:r>
              <a:rPr lang="fr-FR" dirty="0"/>
              <a:t> filament </a:t>
            </a:r>
            <a:r>
              <a:rPr lang="fr-FR" dirty="0" err="1"/>
              <a:t>proteins</a:t>
            </a:r>
            <a:r>
              <a:rPr lang="fr-FR" dirty="0"/>
              <a:t> of the oral </a:t>
            </a:r>
            <a:r>
              <a:rPr lang="fr-FR" dirty="0" err="1"/>
              <a:t>bacterium</a:t>
            </a:r>
            <a:r>
              <a:rPr lang="fr-FR" dirty="0"/>
              <a:t> </a:t>
            </a:r>
            <a:r>
              <a:rPr lang="fr-FR" dirty="0" err="1"/>
              <a:t>Treponema</a:t>
            </a:r>
            <a:r>
              <a:rPr lang="fr-FR" dirty="0"/>
              <a:t> </a:t>
            </a:r>
            <a:r>
              <a:rPr lang="fr-FR" dirty="0" err="1"/>
              <a:t>denticola</a:t>
            </a:r>
            <a:r>
              <a:rPr lang="fr-FR" dirty="0"/>
              <a:t>. </a:t>
            </a:r>
            <a:r>
              <a:rPr lang="fr-FR" dirty="0" err="1"/>
              <a:t>Kurniyati</a:t>
            </a:r>
            <a:r>
              <a:rPr lang="fr-FR" dirty="0"/>
              <a:t> </a:t>
            </a:r>
            <a:r>
              <a:rPr lang="fr-FR" i="1" dirty="0"/>
              <a:t>et al</a:t>
            </a:r>
            <a:r>
              <a:rPr lang="fr-FR" dirty="0"/>
              <a:t>., 2016, </a:t>
            </a:r>
            <a:r>
              <a:rPr lang="fr-FR" dirty="0" err="1"/>
              <a:t>Molecular</a:t>
            </a:r>
            <a:r>
              <a:rPr lang="fr-FR" dirty="0"/>
              <a:t> </a:t>
            </a:r>
            <a:r>
              <a:rPr lang="fr-FR" dirty="0" err="1"/>
              <a:t>Microbiology</a:t>
            </a:r>
            <a:endParaRPr lang="fr-FR" dirty="0"/>
          </a:p>
          <a:p>
            <a:endParaRPr lang="fr-FR" dirty="0"/>
          </a:p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00C5ABF-8252-8D4B-9A5B-4E873B6B74EB}" type="slidenum">
              <a:rPr lang="fr-FR" smtClean="0"/>
              <a:t>5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091286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92786-7FB2-4942-B7DE-5903420E5F31}" type="datetimeFigureOut">
              <a:rPr lang="fr-FR" smtClean="0"/>
              <a:t>20/05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167F9-BCE0-8A4F-BC20-1E5224E6FB6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993419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92786-7FB2-4942-B7DE-5903420E5F31}" type="datetimeFigureOut">
              <a:rPr lang="fr-FR" smtClean="0"/>
              <a:t>20/05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167F9-BCE0-8A4F-BC20-1E5224E6FB6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772478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92786-7FB2-4942-B7DE-5903420E5F31}" type="datetimeFigureOut">
              <a:rPr lang="fr-FR" smtClean="0"/>
              <a:t>20/05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167F9-BCE0-8A4F-BC20-1E5224E6FB6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9744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92786-7FB2-4942-B7DE-5903420E5F31}" type="datetimeFigureOut">
              <a:rPr lang="fr-FR" smtClean="0"/>
              <a:t>20/05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167F9-BCE0-8A4F-BC20-1E5224E6FB6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35300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92786-7FB2-4942-B7DE-5903420E5F31}" type="datetimeFigureOut">
              <a:rPr lang="fr-FR" smtClean="0"/>
              <a:t>20/05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167F9-BCE0-8A4F-BC20-1E5224E6FB6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781097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92786-7FB2-4942-B7DE-5903420E5F31}" type="datetimeFigureOut">
              <a:rPr lang="fr-FR" smtClean="0"/>
              <a:t>20/05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167F9-BCE0-8A4F-BC20-1E5224E6FB6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2211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92786-7FB2-4942-B7DE-5903420E5F31}" type="datetimeFigureOut">
              <a:rPr lang="fr-FR" smtClean="0"/>
              <a:t>20/05/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167F9-BCE0-8A4F-BC20-1E5224E6FB6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554129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92786-7FB2-4942-B7DE-5903420E5F31}" type="datetimeFigureOut">
              <a:rPr lang="fr-FR" smtClean="0"/>
              <a:t>20/05/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167F9-BCE0-8A4F-BC20-1E5224E6FB6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30461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92786-7FB2-4942-B7DE-5903420E5F31}" type="datetimeFigureOut">
              <a:rPr lang="fr-FR" smtClean="0"/>
              <a:t>20/05/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167F9-BCE0-8A4F-BC20-1E5224E6FB6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479727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92786-7FB2-4942-B7DE-5903420E5F31}" type="datetimeFigureOut">
              <a:rPr lang="fr-FR" smtClean="0"/>
              <a:t>20/05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167F9-BCE0-8A4F-BC20-1E5224E6FB6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848740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92786-7FB2-4942-B7DE-5903420E5F31}" type="datetimeFigureOut">
              <a:rPr lang="fr-FR" smtClean="0"/>
              <a:t>20/05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167F9-BCE0-8A4F-BC20-1E5224E6FB6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08475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992786-7FB2-4942-B7DE-5903420E5F31}" type="datetimeFigureOut">
              <a:rPr lang="fr-FR" smtClean="0"/>
              <a:t>20/05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1167F9-BCE0-8A4F-BC20-1E5224E6FB6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980915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3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298223" y="306495"/>
            <a:ext cx="6632222" cy="63555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/>
              <a:t>Supplementary figures legends </a:t>
            </a:r>
            <a:endParaRPr lang="fr-FR" sz="1100" dirty="0"/>
          </a:p>
          <a:p>
            <a:r>
              <a:rPr lang="en-US" sz="1100" b="1" dirty="0" smtClean="0"/>
              <a:t>Sup Figure 1. BLAST analyses between </a:t>
            </a:r>
            <a:r>
              <a:rPr lang="en-US" sz="1100" b="1" dirty="0" err="1" smtClean="0"/>
              <a:t>flagellin</a:t>
            </a:r>
            <a:r>
              <a:rPr lang="en-US" sz="1100" b="1" dirty="0" smtClean="0"/>
              <a:t> subunits and species</a:t>
            </a:r>
            <a:endParaRPr lang="fr-FR" sz="1100" dirty="0" smtClean="0"/>
          </a:p>
          <a:p>
            <a:r>
              <a:rPr lang="en-US" sz="1100" b="1" dirty="0" smtClean="0"/>
              <a:t>A-C) </a:t>
            </a:r>
            <a:r>
              <a:rPr lang="en-US" sz="1100" dirty="0" smtClean="0"/>
              <a:t>Amino acid sequence homology percentage between </a:t>
            </a:r>
            <a:r>
              <a:rPr lang="en-US" sz="1100" b="1" dirty="0" smtClean="0"/>
              <a:t>A) </a:t>
            </a:r>
            <a:r>
              <a:rPr lang="en-US" sz="1100" i="1" dirty="0" smtClean="0"/>
              <a:t>L. </a:t>
            </a:r>
            <a:r>
              <a:rPr lang="en-US" sz="1100" i="1" dirty="0" err="1" smtClean="0"/>
              <a:t>interrogans</a:t>
            </a:r>
            <a:r>
              <a:rPr lang="en-US" sz="1100" dirty="0" smtClean="0"/>
              <a:t> </a:t>
            </a:r>
            <a:r>
              <a:rPr lang="en-US" sz="1100" dirty="0" err="1" smtClean="0"/>
              <a:t>Copenhageni</a:t>
            </a:r>
            <a:r>
              <a:rPr lang="en-US" sz="1100" dirty="0" smtClean="0"/>
              <a:t> (strain </a:t>
            </a:r>
            <a:r>
              <a:rPr lang="en-US" sz="1100" dirty="0" err="1" smtClean="0"/>
              <a:t>Fiocruz</a:t>
            </a:r>
            <a:r>
              <a:rPr lang="en-US" sz="1100" dirty="0" smtClean="0"/>
              <a:t> L1-130) </a:t>
            </a:r>
            <a:r>
              <a:rPr lang="en-US" sz="1100" dirty="0" err="1" smtClean="0"/>
              <a:t>FlaBs</a:t>
            </a:r>
            <a:r>
              <a:rPr lang="en-US" sz="1100" dirty="0" smtClean="0"/>
              <a:t> (LIC11531, LIC18890, LIC11889, LIC11532) and </a:t>
            </a:r>
            <a:r>
              <a:rPr lang="en-US" sz="1100" dirty="0" err="1" smtClean="0"/>
              <a:t>FlaAs</a:t>
            </a:r>
            <a:r>
              <a:rPr lang="en-US" sz="1100" dirty="0" smtClean="0"/>
              <a:t> (LIC10788, LIC10787), </a:t>
            </a:r>
            <a:r>
              <a:rPr lang="en-US" sz="1100" b="1" dirty="0" smtClean="0"/>
              <a:t>B) </a:t>
            </a:r>
            <a:r>
              <a:rPr lang="en-US" sz="1100" i="1" dirty="0" smtClean="0"/>
              <a:t>L. </a:t>
            </a:r>
            <a:r>
              <a:rPr lang="en-US" sz="1100" i="1" dirty="0" err="1" smtClean="0"/>
              <a:t>interrogans</a:t>
            </a:r>
            <a:r>
              <a:rPr lang="en-US" sz="1100" dirty="0" smtClean="0"/>
              <a:t> </a:t>
            </a:r>
            <a:r>
              <a:rPr lang="en-US" sz="1100" dirty="0" err="1" smtClean="0"/>
              <a:t>Copenhageni</a:t>
            </a:r>
            <a:r>
              <a:rPr lang="en-US" sz="1100" dirty="0" smtClean="0"/>
              <a:t> (strain </a:t>
            </a:r>
            <a:r>
              <a:rPr lang="en-US" sz="1100" dirty="0" err="1" smtClean="0"/>
              <a:t>Fiocruz</a:t>
            </a:r>
            <a:r>
              <a:rPr lang="en-US" sz="1100" dirty="0" smtClean="0"/>
              <a:t> L1-130) </a:t>
            </a:r>
            <a:r>
              <a:rPr lang="en-US" sz="1100" dirty="0" err="1" smtClean="0"/>
              <a:t>FlaBs</a:t>
            </a:r>
            <a:r>
              <a:rPr lang="en-US" sz="1100" dirty="0" smtClean="0"/>
              <a:t> or </a:t>
            </a:r>
            <a:r>
              <a:rPr lang="en-US" sz="1100" i="1" dirty="0" smtClean="0"/>
              <a:t>L. </a:t>
            </a:r>
            <a:r>
              <a:rPr lang="en-US" sz="1100" i="1" dirty="0" err="1" smtClean="0"/>
              <a:t>biflexa</a:t>
            </a:r>
            <a:r>
              <a:rPr lang="en-US" sz="1100" i="1" dirty="0" smtClean="0"/>
              <a:t> </a:t>
            </a:r>
            <a:r>
              <a:rPr lang="en-US" sz="1100" dirty="0" err="1" smtClean="0"/>
              <a:t>Patoc</a:t>
            </a:r>
            <a:r>
              <a:rPr lang="en-US" sz="1100" i="1" dirty="0" smtClean="0"/>
              <a:t> </a:t>
            </a:r>
            <a:r>
              <a:rPr lang="en-US" sz="1100" dirty="0" smtClean="0"/>
              <a:t>strain </a:t>
            </a:r>
            <a:r>
              <a:rPr lang="en-US" sz="1100" dirty="0" err="1" smtClean="0"/>
              <a:t>Patoc</a:t>
            </a:r>
            <a:r>
              <a:rPr lang="en-US" sz="1100" dirty="0" smtClean="0"/>
              <a:t> I </a:t>
            </a:r>
            <a:r>
              <a:rPr lang="en-US" sz="1100" dirty="0" err="1" smtClean="0"/>
              <a:t>FlaBs</a:t>
            </a:r>
            <a:r>
              <a:rPr lang="en-US" sz="1100" dirty="0" smtClean="0"/>
              <a:t> (LEPBIa1589, LEPBIa2133, LEPBIa2132, LEPBIa1872), </a:t>
            </a:r>
            <a:r>
              <a:rPr lang="en-US" sz="1100" b="1" dirty="0" smtClean="0"/>
              <a:t>C) </a:t>
            </a:r>
            <a:r>
              <a:rPr lang="en-US" sz="1100" i="1" dirty="0" smtClean="0"/>
              <a:t>L. </a:t>
            </a:r>
            <a:r>
              <a:rPr lang="en-US" sz="1100" i="1" dirty="0" err="1" smtClean="0"/>
              <a:t>interrogans</a:t>
            </a:r>
            <a:r>
              <a:rPr lang="en-US" sz="1100" dirty="0" smtClean="0"/>
              <a:t> FlaB1 of all serotypes (</a:t>
            </a:r>
            <a:r>
              <a:rPr lang="en-US" sz="1100" dirty="0" err="1" smtClean="0"/>
              <a:t>Fiocruz</a:t>
            </a:r>
            <a:r>
              <a:rPr lang="en-US" sz="1100" dirty="0" smtClean="0"/>
              <a:t> L130 LIC11531, </a:t>
            </a:r>
            <a:r>
              <a:rPr lang="en-US" sz="1100" dirty="0" err="1" smtClean="0"/>
              <a:t>Manilae</a:t>
            </a:r>
            <a:r>
              <a:rPr lang="en-US" sz="1100" dirty="0" smtClean="0"/>
              <a:t> L495 LMANv2_590023, Verdun AKWP_v1_110067, </a:t>
            </a:r>
            <a:r>
              <a:rPr lang="en-US" sz="1100" dirty="0" err="1" smtClean="0"/>
              <a:t>Patoc</a:t>
            </a:r>
            <a:r>
              <a:rPr lang="en-US" sz="1100" dirty="0" smtClean="0"/>
              <a:t> I LEPBIa1589), FlaB2 of all serotypes (</a:t>
            </a:r>
            <a:r>
              <a:rPr lang="en-US" sz="1100" dirty="0" err="1" smtClean="0"/>
              <a:t>Fiocruz</a:t>
            </a:r>
            <a:r>
              <a:rPr lang="en-US" sz="1100" dirty="0" smtClean="0"/>
              <a:t> LIC11890, </a:t>
            </a:r>
            <a:r>
              <a:rPr lang="en-US" sz="1100" dirty="0" err="1" smtClean="0"/>
              <a:t>Manilae</a:t>
            </a:r>
            <a:r>
              <a:rPr lang="en-US" sz="1100" dirty="0" smtClean="0"/>
              <a:t> L495 LMANv2_260016, Verdun AKWP_v1_110429, </a:t>
            </a:r>
            <a:r>
              <a:rPr lang="en-US" sz="1100" dirty="0" err="1" smtClean="0"/>
              <a:t>Patoc</a:t>
            </a:r>
            <a:r>
              <a:rPr lang="en-US" sz="1100" dirty="0" smtClean="0"/>
              <a:t> I LEPBIa2133), FlaB3 of all serotypes (</a:t>
            </a:r>
            <a:r>
              <a:rPr lang="en-US" sz="1100" dirty="0" err="1" smtClean="0"/>
              <a:t>Fiocruz</a:t>
            </a:r>
            <a:r>
              <a:rPr lang="en-US" sz="1100" dirty="0" smtClean="0"/>
              <a:t> LIC11889 , </a:t>
            </a:r>
            <a:r>
              <a:rPr lang="en-US" sz="1100" dirty="0" err="1" smtClean="0"/>
              <a:t>Manilae</a:t>
            </a:r>
            <a:r>
              <a:rPr lang="en-US" sz="1100" dirty="0" smtClean="0"/>
              <a:t> L495 LMANv2_260015, Verdun AKWP_v1_110428, </a:t>
            </a:r>
            <a:r>
              <a:rPr lang="en-US" sz="1100" dirty="0" err="1" smtClean="0"/>
              <a:t>Patoc</a:t>
            </a:r>
            <a:r>
              <a:rPr lang="en-US" sz="1100" dirty="0" smtClean="0"/>
              <a:t> I LEPBIa2132) and FlaB4 of all serotypes (</a:t>
            </a:r>
            <a:r>
              <a:rPr lang="en-US" sz="1100" dirty="0" err="1" smtClean="0"/>
              <a:t>Fiocruz</a:t>
            </a:r>
            <a:r>
              <a:rPr lang="en-US" sz="1100" dirty="0" smtClean="0"/>
              <a:t> LIC11532, </a:t>
            </a:r>
            <a:r>
              <a:rPr lang="en-US" sz="1100" dirty="0" err="1" smtClean="0"/>
              <a:t>Manilae</a:t>
            </a:r>
            <a:r>
              <a:rPr lang="en-US" sz="1100" dirty="0" smtClean="0"/>
              <a:t> L495 LMANv2_590024, Verdun AKWP_v1_110068, </a:t>
            </a:r>
            <a:r>
              <a:rPr lang="en-US" sz="1100" dirty="0" err="1" smtClean="0"/>
              <a:t>Patoc</a:t>
            </a:r>
            <a:r>
              <a:rPr lang="en-US" sz="1100" dirty="0" smtClean="0"/>
              <a:t> I LEPBIa1872).</a:t>
            </a:r>
            <a:endParaRPr lang="fr-FR" sz="1100" dirty="0" smtClean="0"/>
          </a:p>
          <a:p>
            <a:r>
              <a:rPr lang="en-US" sz="1100" b="1" dirty="0"/>
              <a:t> </a:t>
            </a:r>
            <a:endParaRPr lang="fr-FR" sz="1100" dirty="0"/>
          </a:p>
          <a:p>
            <a:r>
              <a:rPr lang="en-US" sz="1100" b="1" dirty="0"/>
              <a:t>Sup Figure 2. Schematics of </a:t>
            </a:r>
            <a:r>
              <a:rPr lang="en-US" sz="1100" b="1" dirty="0" err="1"/>
              <a:t>leptospiral</a:t>
            </a:r>
            <a:r>
              <a:rPr lang="en-US" sz="1100" b="1" dirty="0"/>
              <a:t> filament and </a:t>
            </a:r>
            <a:r>
              <a:rPr lang="en-US" sz="1100" b="1" dirty="0" err="1"/>
              <a:t>FliC</a:t>
            </a:r>
            <a:r>
              <a:rPr lang="en-US" sz="1100" b="1" dirty="0"/>
              <a:t> association with TLR5</a:t>
            </a:r>
            <a:endParaRPr lang="fr-FR" sz="1100" dirty="0"/>
          </a:p>
          <a:p>
            <a:r>
              <a:rPr lang="en-US" sz="1100" dirty="0"/>
              <a:t>Schematic representations of </a:t>
            </a:r>
            <a:r>
              <a:rPr lang="en-US" sz="1100" b="1" dirty="0"/>
              <a:t>A)</a:t>
            </a:r>
            <a:r>
              <a:rPr lang="en-US" sz="1100" dirty="0"/>
              <a:t> the </a:t>
            </a:r>
            <a:r>
              <a:rPr lang="en-US" sz="1100" dirty="0" err="1"/>
              <a:t>leptospiral</a:t>
            </a:r>
            <a:r>
              <a:rPr lang="en-US" sz="1100" dirty="0"/>
              <a:t> </a:t>
            </a:r>
            <a:r>
              <a:rPr lang="en-US" sz="1100" dirty="0" err="1"/>
              <a:t>flagellin</a:t>
            </a:r>
            <a:r>
              <a:rPr lang="en-US" sz="1100" dirty="0"/>
              <a:t> structure adapted from Gibson </a:t>
            </a:r>
            <a:r>
              <a:rPr lang="en-US" sz="1100" i="1" dirty="0"/>
              <a:t>et al.</a:t>
            </a:r>
            <a:r>
              <a:rPr lang="en-US" sz="1100" dirty="0"/>
              <a:t> 2020 and</a:t>
            </a:r>
            <a:r>
              <a:rPr lang="en-US" sz="1100" b="1" dirty="0"/>
              <a:t> B)</a:t>
            </a:r>
            <a:r>
              <a:rPr lang="en-US" sz="1100" dirty="0"/>
              <a:t> the interaction of </a:t>
            </a:r>
            <a:r>
              <a:rPr lang="en-US" sz="1100" dirty="0" err="1"/>
              <a:t>FliC</a:t>
            </a:r>
            <a:r>
              <a:rPr lang="en-US" sz="1100" dirty="0"/>
              <a:t> subunits with TLR5 inducing dimerization of the receptors adapted from Yoon </a:t>
            </a:r>
            <a:r>
              <a:rPr lang="en-US" sz="1100" i="1" dirty="0"/>
              <a:t>et al. </a:t>
            </a:r>
            <a:r>
              <a:rPr lang="en-US" sz="1100" dirty="0"/>
              <a:t>2012. </a:t>
            </a:r>
            <a:endParaRPr lang="fr-FR" sz="1100" dirty="0"/>
          </a:p>
          <a:p>
            <a:r>
              <a:rPr lang="en-US" sz="1100" b="1" dirty="0"/>
              <a:t> </a:t>
            </a:r>
            <a:endParaRPr lang="fr-FR" sz="1100" dirty="0"/>
          </a:p>
          <a:p>
            <a:r>
              <a:rPr lang="en-US" sz="1100" b="1" dirty="0"/>
              <a:t>Sup Figure 3. TLR5 binding and consensus sites in different species</a:t>
            </a:r>
            <a:endParaRPr lang="fr-FR" sz="1100" dirty="0"/>
          </a:p>
          <a:p>
            <a:r>
              <a:rPr lang="en-US" sz="1100" dirty="0" err="1"/>
              <a:t>Clustal</a:t>
            </a:r>
            <a:r>
              <a:rPr lang="en-US" sz="1100" dirty="0"/>
              <a:t> (MEGA software) alignment of the amino acid sequences for the TLR5 binding consensus regions of: </a:t>
            </a:r>
            <a:r>
              <a:rPr lang="en-US" sz="1100" i="1" dirty="0" err="1"/>
              <a:t>Leptospira</a:t>
            </a:r>
            <a:r>
              <a:rPr lang="en-US" sz="1100" i="1" dirty="0"/>
              <a:t> </a:t>
            </a:r>
            <a:r>
              <a:rPr lang="en-US" sz="1100" i="1" dirty="0" err="1"/>
              <a:t>interrogans</a:t>
            </a:r>
            <a:r>
              <a:rPr lang="en-US" sz="1100" dirty="0"/>
              <a:t> </a:t>
            </a:r>
            <a:r>
              <a:rPr lang="en-US" sz="1100" dirty="0" err="1"/>
              <a:t>Copenhageni</a:t>
            </a:r>
            <a:r>
              <a:rPr lang="en-US" sz="1100" dirty="0"/>
              <a:t> (strain </a:t>
            </a:r>
            <a:r>
              <a:rPr lang="en-US" sz="1100" dirty="0" err="1"/>
              <a:t>Fiocruz</a:t>
            </a:r>
            <a:r>
              <a:rPr lang="en-US" sz="1100" dirty="0"/>
              <a:t> L1-130) FlaB1 (LIC11531), </a:t>
            </a:r>
            <a:r>
              <a:rPr lang="en-US" sz="1100" i="1" dirty="0" err="1"/>
              <a:t>L.biflexa</a:t>
            </a:r>
            <a:r>
              <a:rPr lang="en-US" sz="1100" dirty="0"/>
              <a:t> </a:t>
            </a:r>
            <a:r>
              <a:rPr lang="en-US" sz="1100" dirty="0" err="1"/>
              <a:t>Patoc</a:t>
            </a:r>
            <a:r>
              <a:rPr lang="en-US" sz="1100" i="1" dirty="0"/>
              <a:t> </a:t>
            </a:r>
            <a:r>
              <a:rPr lang="en-US" sz="1100" dirty="0"/>
              <a:t>strain </a:t>
            </a:r>
            <a:r>
              <a:rPr lang="en-US" sz="1100" dirty="0" err="1"/>
              <a:t>Patoc</a:t>
            </a:r>
            <a:r>
              <a:rPr lang="en-US" sz="1100" dirty="0"/>
              <a:t> FlaB1 (LEPBIa1589), </a:t>
            </a:r>
            <a:r>
              <a:rPr lang="en-US" sz="1100" i="1" dirty="0" err="1"/>
              <a:t>Borrelia</a:t>
            </a:r>
            <a:r>
              <a:rPr lang="en-US" sz="1100" i="1" dirty="0"/>
              <a:t> </a:t>
            </a:r>
            <a:r>
              <a:rPr lang="en-US" sz="1100" i="1" dirty="0" err="1"/>
              <a:t>burgdorferi</a:t>
            </a:r>
            <a:r>
              <a:rPr lang="en-US" sz="1100" dirty="0"/>
              <a:t> (</a:t>
            </a:r>
            <a:r>
              <a:rPr lang="en-US" sz="1100" dirty="0" err="1"/>
              <a:t>GeneBank</a:t>
            </a:r>
            <a:r>
              <a:rPr lang="en-US" sz="1100" dirty="0"/>
              <a:t> CAA45011.1), </a:t>
            </a:r>
            <a:r>
              <a:rPr lang="en-US" sz="1100" i="1" dirty="0" err="1"/>
              <a:t>Treponema</a:t>
            </a:r>
            <a:r>
              <a:rPr lang="en-US" sz="1100" dirty="0"/>
              <a:t> ssp. (</a:t>
            </a:r>
            <a:r>
              <a:rPr lang="en-US" sz="1100" dirty="0" err="1"/>
              <a:t>GeneBank</a:t>
            </a:r>
            <a:r>
              <a:rPr lang="en-US" sz="1100" dirty="0"/>
              <a:t> AIW88993.1), </a:t>
            </a:r>
            <a:r>
              <a:rPr lang="en-US" sz="1100" i="1" dirty="0"/>
              <a:t>Bacillus </a:t>
            </a:r>
            <a:r>
              <a:rPr lang="en-US" sz="1100" i="1" dirty="0" err="1"/>
              <a:t>subtilis</a:t>
            </a:r>
            <a:r>
              <a:rPr lang="en-US" sz="1100" i="1" dirty="0"/>
              <a:t> </a:t>
            </a:r>
            <a:r>
              <a:rPr lang="en-US" sz="1100" dirty="0"/>
              <a:t>strain W23 (</a:t>
            </a:r>
            <a:r>
              <a:rPr lang="en-US" sz="1100" dirty="0" err="1"/>
              <a:t>GeneBank</a:t>
            </a:r>
            <a:r>
              <a:rPr lang="en-US" sz="1100" dirty="0"/>
              <a:t> ADM39502.1), </a:t>
            </a:r>
            <a:r>
              <a:rPr lang="en-US" sz="1100" i="1" dirty="0"/>
              <a:t>Salmonella </a:t>
            </a:r>
            <a:r>
              <a:rPr lang="en-US" sz="1100" i="1" dirty="0" err="1"/>
              <a:t>enterica</a:t>
            </a:r>
            <a:r>
              <a:rPr lang="en-US" sz="1100" dirty="0"/>
              <a:t> subsp. </a:t>
            </a:r>
            <a:r>
              <a:rPr lang="en-US" sz="1100" i="1" dirty="0" err="1"/>
              <a:t>enterica</a:t>
            </a:r>
            <a:r>
              <a:rPr lang="en-US" sz="1100" dirty="0"/>
              <a:t> </a:t>
            </a:r>
            <a:r>
              <a:rPr lang="en-US" sz="1100" dirty="0" err="1"/>
              <a:t>serovar</a:t>
            </a:r>
            <a:r>
              <a:rPr lang="en-US" sz="1100" dirty="0"/>
              <a:t> </a:t>
            </a:r>
            <a:r>
              <a:rPr lang="en-US" sz="1100" dirty="0" err="1"/>
              <a:t>Typhimurium</a:t>
            </a:r>
            <a:r>
              <a:rPr lang="en-US" sz="1100" dirty="0"/>
              <a:t> (</a:t>
            </a:r>
            <a:r>
              <a:rPr lang="en-US" sz="1100" dirty="0" err="1"/>
              <a:t>GeneBank</a:t>
            </a:r>
            <a:r>
              <a:rPr lang="en-US" sz="1100" dirty="0"/>
              <a:t> QDQ31983.1), </a:t>
            </a:r>
            <a:r>
              <a:rPr lang="en-US" sz="1100" i="1" dirty="0"/>
              <a:t>Escherichia coli</a:t>
            </a:r>
            <a:r>
              <a:rPr lang="en-US" sz="1100" dirty="0"/>
              <a:t> strain 0157:H7 (KKF82802.1), </a:t>
            </a:r>
            <a:r>
              <a:rPr lang="en-US" sz="1100" i="1" dirty="0"/>
              <a:t>Helicobacter pylori</a:t>
            </a:r>
            <a:r>
              <a:rPr lang="en-US" sz="1100" dirty="0"/>
              <a:t> strain J99 (</a:t>
            </a:r>
            <a:r>
              <a:rPr lang="en-US" sz="1100" dirty="0" err="1"/>
              <a:t>GeneBank</a:t>
            </a:r>
            <a:r>
              <a:rPr lang="en-US" sz="1100" dirty="0"/>
              <a:t> AKE81874.1) and </a:t>
            </a:r>
            <a:r>
              <a:rPr lang="en-US" sz="1100" i="1" dirty="0" err="1"/>
              <a:t>Bartonnela</a:t>
            </a:r>
            <a:r>
              <a:rPr lang="en-US" sz="1100" i="1" dirty="0"/>
              <a:t> </a:t>
            </a:r>
            <a:r>
              <a:rPr lang="en-US" sz="1100" i="1" dirty="0" err="1"/>
              <a:t>bacilliformis</a:t>
            </a:r>
            <a:r>
              <a:rPr lang="en-US" sz="1100" i="1" dirty="0"/>
              <a:t> </a:t>
            </a:r>
            <a:r>
              <a:rPr lang="en-US" sz="1100" dirty="0"/>
              <a:t>(</a:t>
            </a:r>
            <a:r>
              <a:rPr lang="en-US" sz="1100" dirty="0" err="1"/>
              <a:t>GeneBank</a:t>
            </a:r>
            <a:r>
              <a:rPr lang="en-US" sz="1100" dirty="0"/>
              <a:t> AAA22899.1).</a:t>
            </a:r>
            <a:endParaRPr lang="fr-FR" sz="1100" dirty="0"/>
          </a:p>
          <a:p>
            <a:r>
              <a:rPr lang="en-US" sz="1100" b="1" dirty="0"/>
              <a:t> </a:t>
            </a:r>
            <a:endParaRPr lang="fr-FR" sz="1100" dirty="0"/>
          </a:p>
          <a:p>
            <a:r>
              <a:rPr lang="en-US" sz="1100" b="1" dirty="0"/>
              <a:t>Sup Figure 4. Glycosylation sites on </a:t>
            </a:r>
            <a:r>
              <a:rPr lang="en-US" sz="1100" b="1" dirty="0" err="1"/>
              <a:t>FlaBs</a:t>
            </a:r>
            <a:endParaRPr lang="fr-FR" sz="1100" dirty="0"/>
          </a:p>
          <a:p>
            <a:r>
              <a:rPr lang="en-US" sz="1100" b="1" dirty="0"/>
              <a:t>A-B) </a:t>
            </a:r>
            <a:r>
              <a:rPr lang="en-US" sz="1100" i="1" dirty="0"/>
              <a:t>In </a:t>
            </a:r>
            <a:r>
              <a:rPr lang="en-US" sz="1100" i="1" dirty="0" err="1"/>
              <a:t>silico</a:t>
            </a:r>
            <a:r>
              <a:rPr lang="en-US" sz="1100" i="1" dirty="0"/>
              <a:t> </a:t>
            </a:r>
            <a:r>
              <a:rPr lang="en-US" sz="1100" dirty="0"/>
              <a:t>(Phyre2 and Chimera </a:t>
            </a:r>
            <a:r>
              <a:rPr lang="en-US" sz="1100" dirty="0" err="1"/>
              <a:t>softwares</a:t>
            </a:r>
            <a:r>
              <a:rPr lang="en-US" sz="1100" dirty="0"/>
              <a:t>) prediction of </a:t>
            </a:r>
            <a:r>
              <a:rPr lang="en-US" sz="1100" b="1" dirty="0"/>
              <a:t>A)</a:t>
            </a:r>
            <a:r>
              <a:rPr lang="en-US" sz="1100" dirty="0"/>
              <a:t> </a:t>
            </a:r>
            <a:r>
              <a:rPr lang="en-US" sz="1100" i="1" dirty="0" err="1"/>
              <a:t>Treponema</a:t>
            </a:r>
            <a:r>
              <a:rPr lang="en-US" sz="1100" i="1" dirty="0"/>
              <a:t> </a:t>
            </a:r>
            <a:r>
              <a:rPr lang="en-US" sz="1100" i="1" dirty="0" err="1"/>
              <a:t>pallidum</a:t>
            </a:r>
            <a:r>
              <a:rPr lang="en-US" sz="1100" i="1" dirty="0"/>
              <a:t> </a:t>
            </a:r>
            <a:r>
              <a:rPr lang="en-US" sz="1100" dirty="0"/>
              <a:t>strain Nichols FlaB1 (P21990) and </a:t>
            </a:r>
            <a:r>
              <a:rPr lang="en-US" sz="1100" b="1" dirty="0"/>
              <a:t>B)</a:t>
            </a:r>
            <a:r>
              <a:rPr lang="en-US" sz="1100" dirty="0"/>
              <a:t> </a:t>
            </a:r>
            <a:r>
              <a:rPr lang="en-US" sz="1100" i="1" dirty="0" err="1"/>
              <a:t>Leptospira</a:t>
            </a:r>
            <a:r>
              <a:rPr lang="en-US" sz="1100" i="1" dirty="0"/>
              <a:t> </a:t>
            </a:r>
            <a:r>
              <a:rPr lang="en-US" sz="1100" i="1" dirty="0" err="1"/>
              <a:t>interrogans</a:t>
            </a:r>
            <a:r>
              <a:rPr lang="en-US" sz="1100" dirty="0"/>
              <a:t> </a:t>
            </a:r>
            <a:r>
              <a:rPr lang="en-US" sz="1100" dirty="0" err="1"/>
              <a:t>Copenhageni</a:t>
            </a:r>
            <a:r>
              <a:rPr lang="en-US" sz="1100" dirty="0"/>
              <a:t> (strain </a:t>
            </a:r>
            <a:r>
              <a:rPr lang="en-US" sz="1100" dirty="0" err="1"/>
              <a:t>Fiocruz</a:t>
            </a:r>
            <a:r>
              <a:rPr lang="en-US" sz="1100" dirty="0"/>
              <a:t> L1-130) FlaB1 (LIC11531) with TLR5 binding consensus 2 (yellow) and potential glycosylation positions (pink) highlighted. </a:t>
            </a:r>
            <a:r>
              <a:rPr lang="en-US" sz="1100" b="1" dirty="0"/>
              <a:t>C) </a:t>
            </a:r>
            <a:r>
              <a:rPr lang="en-US" sz="1100" dirty="0" err="1"/>
              <a:t>Clustal</a:t>
            </a:r>
            <a:r>
              <a:rPr lang="en-US" sz="1100" dirty="0"/>
              <a:t> (MEGA software) alignment of the amino acid sequences for region with potential glycosylation of: </a:t>
            </a:r>
            <a:r>
              <a:rPr lang="en-US" sz="1100" i="1" dirty="0" err="1"/>
              <a:t>Treponema</a:t>
            </a:r>
            <a:r>
              <a:rPr lang="en-US" sz="1100" i="1" dirty="0"/>
              <a:t> </a:t>
            </a:r>
            <a:r>
              <a:rPr lang="en-US" sz="1100" i="1" dirty="0" err="1"/>
              <a:t>denticola</a:t>
            </a:r>
            <a:r>
              <a:rPr lang="en-US" sz="1100" dirty="0"/>
              <a:t> </a:t>
            </a:r>
            <a:r>
              <a:rPr lang="en-US" sz="1100" dirty="0" err="1"/>
              <a:t>FlaB</a:t>
            </a:r>
            <a:r>
              <a:rPr lang="en-US" sz="1100" dirty="0"/>
              <a:t> (</a:t>
            </a:r>
            <a:r>
              <a:rPr lang="en-US" sz="1100" dirty="0" err="1"/>
              <a:t>GeneBank</a:t>
            </a:r>
            <a:r>
              <a:rPr lang="en-US" sz="1100" dirty="0"/>
              <a:t> WP_010697276.1), </a:t>
            </a:r>
            <a:r>
              <a:rPr lang="en-US" sz="1100" i="1" dirty="0" err="1"/>
              <a:t>Borrelia</a:t>
            </a:r>
            <a:r>
              <a:rPr lang="en-US" sz="1100" i="1" dirty="0"/>
              <a:t> </a:t>
            </a:r>
            <a:r>
              <a:rPr lang="en-US" sz="1100" i="1" dirty="0" err="1"/>
              <a:t>burgdorferi</a:t>
            </a:r>
            <a:r>
              <a:rPr lang="en-US" sz="1100" dirty="0"/>
              <a:t> (</a:t>
            </a:r>
            <a:r>
              <a:rPr lang="en-US" sz="1100" dirty="0" err="1"/>
              <a:t>GeneBank</a:t>
            </a:r>
            <a:r>
              <a:rPr lang="en-US" sz="1100" dirty="0"/>
              <a:t> CAA45011.1), </a:t>
            </a:r>
            <a:r>
              <a:rPr lang="en-US" sz="1100" i="1" dirty="0"/>
              <a:t>L. </a:t>
            </a:r>
            <a:r>
              <a:rPr lang="en-US" sz="1100" i="1" dirty="0" err="1"/>
              <a:t>biflexa</a:t>
            </a:r>
            <a:r>
              <a:rPr lang="en-US" sz="1100" dirty="0"/>
              <a:t> </a:t>
            </a:r>
            <a:r>
              <a:rPr lang="en-US" sz="1100" dirty="0" err="1"/>
              <a:t>Patoc</a:t>
            </a:r>
            <a:r>
              <a:rPr lang="en-US" sz="1100" dirty="0"/>
              <a:t> (strain </a:t>
            </a:r>
            <a:r>
              <a:rPr lang="en-US" sz="1100" dirty="0" err="1"/>
              <a:t>Patoc</a:t>
            </a:r>
            <a:r>
              <a:rPr lang="en-US" sz="1100" dirty="0"/>
              <a:t>) FlaB1 (LEPBIa1589), FlaB2 (LEPBIa2133), FlaB3 (LEPBIa2132), FlaB4 (LEPBIa1872), </a:t>
            </a:r>
            <a:r>
              <a:rPr lang="en-US" sz="1100" i="1" dirty="0"/>
              <a:t>L. </a:t>
            </a:r>
            <a:r>
              <a:rPr lang="en-US" sz="1100" i="1" dirty="0" err="1"/>
              <a:t>interrogans</a:t>
            </a:r>
            <a:r>
              <a:rPr lang="en-US" sz="1100" dirty="0"/>
              <a:t> </a:t>
            </a:r>
            <a:r>
              <a:rPr lang="en-US" sz="1100" dirty="0" err="1"/>
              <a:t>Copenhageni</a:t>
            </a:r>
            <a:r>
              <a:rPr lang="en-US" sz="1100" dirty="0"/>
              <a:t> (strain </a:t>
            </a:r>
            <a:r>
              <a:rPr lang="en-US" sz="1100" dirty="0" err="1"/>
              <a:t>Fiocruz</a:t>
            </a:r>
            <a:r>
              <a:rPr lang="en-US" sz="1100" dirty="0"/>
              <a:t> L1-130) FlaB1 (LIC11531), FlaB2 (LIC18890), FlaB3 (LIC11889), FlaB4 (LIC11532),</a:t>
            </a:r>
            <a:r>
              <a:rPr lang="en-US" sz="1100" i="1" dirty="0"/>
              <a:t> L. </a:t>
            </a:r>
            <a:r>
              <a:rPr lang="en-US" sz="1100" i="1" dirty="0" err="1"/>
              <a:t>interrogans</a:t>
            </a:r>
            <a:r>
              <a:rPr lang="en-US" sz="1100" i="1" dirty="0"/>
              <a:t> </a:t>
            </a:r>
            <a:r>
              <a:rPr lang="en-US" sz="1100" dirty="0" err="1"/>
              <a:t>Manilae</a:t>
            </a:r>
            <a:r>
              <a:rPr lang="en-US" sz="1100" i="1" dirty="0"/>
              <a:t> </a:t>
            </a:r>
            <a:r>
              <a:rPr lang="en-US" sz="1100" dirty="0"/>
              <a:t>(strain L495) FlaB1 (LMANv2_590023), FlaB2 (LMANv2_260016), FlaB3 (LMANv2_260015), FlaB4 (LMANv2_590024) and </a:t>
            </a:r>
            <a:r>
              <a:rPr lang="en-US" sz="1100" i="1" dirty="0"/>
              <a:t>L. </a:t>
            </a:r>
            <a:r>
              <a:rPr lang="en-US" sz="1100" i="1" dirty="0" err="1"/>
              <a:t>interrogans</a:t>
            </a:r>
            <a:r>
              <a:rPr lang="en-US" sz="1100" i="1" dirty="0"/>
              <a:t> </a:t>
            </a:r>
            <a:r>
              <a:rPr lang="en-US" sz="1100" dirty="0" err="1"/>
              <a:t>Icterohaemorrhagiae</a:t>
            </a:r>
            <a:r>
              <a:rPr lang="en-US" sz="1100" i="1" dirty="0"/>
              <a:t> </a:t>
            </a:r>
            <a:r>
              <a:rPr lang="en-US" sz="1100" dirty="0"/>
              <a:t>(strain Verdun) FlaB1 (AKWP_v1_110067), FlaB2 (AKWP_v1_110429), FlaB3 (AKWP_v1_110428) and FlaB4 (AKWP_v1_110068). </a:t>
            </a:r>
            <a:endParaRPr lang="fr-FR" sz="1100" dirty="0"/>
          </a:p>
          <a:p>
            <a:r>
              <a:rPr lang="en-US" sz="1100" b="1" dirty="0"/>
              <a:t> </a:t>
            </a:r>
            <a:endParaRPr lang="fr-FR" sz="1100" dirty="0"/>
          </a:p>
          <a:p>
            <a:r>
              <a:rPr lang="en-US" sz="1100" dirty="0"/>
              <a:t> </a:t>
            </a:r>
            <a:endParaRPr lang="fr-FR" sz="1100" dirty="0"/>
          </a:p>
          <a:p>
            <a:r>
              <a:rPr lang="fr-FR" sz="1100" dirty="0"/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21083895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Tableau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4937688"/>
              </p:ext>
            </p:extLst>
          </p:nvPr>
        </p:nvGraphicFramePr>
        <p:xfrm>
          <a:off x="531629" y="994659"/>
          <a:ext cx="3090259" cy="1567680"/>
        </p:xfrm>
        <a:graphic>
          <a:graphicData uri="http://schemas.openxmlformats.org/drawingml/2006/table">
            <a:tbl>
              <a:tblPr firstRow="1" bandRow="1">
                <a:tableStyleId>{F5AB1C69-6EDB-4FF4-983F-18BD219EF322}</a:tableStyleId>
              </a:tblPr>
              <a:tblGrid>
                <a:gridCol w="1362259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57600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57600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5760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360000">
                <a:tc>
                  <a:txBody>
                    <a:bodyPr/>
                    <a:lstStyle/>
                    <a:p>
                      <a:pPr algn="ctr"/>
                      <a:r>
                        <a:rPr lang="fr-FR" sz="1200" b="0" dirty="0">
                          <a:solidFill>
                            <a:srgbClr val="000000"/>
                          </a:solidFill>
                        </a:rPr>
                        <a:t>BLAST-P </a:t>
                      </a:r>
                      <a:r>
                        <a:rPr lang="fr-FR" sz="1200" b="0" dirty="0" err="1">
                          <a:solidFill>
                            <a:srgbClr val="000000"/>
                          </a:solidFill>
                        </a:rPr>
                        <a:t>identity</a:t>
                      </a:r>
                      <a:r>
                        <a:rPr lang="fr-FR" sz="1200" b="0" baseline="0" dirty="0">
                          <a:solidFill>
                            <a:srgbClr val="000000"/>
                          </a:solidFill>
                        </a:rPr>
                        <a:t> %</a:t>
                      </a:r>
                      <a:endParaRPr lang="fr-FR" sz="1200" b="0" dirty="0">
                        <a:solidFill>
                          <a:srgbClr val="000000"/>
                        </a:solidFill>
                      </a:endParaRPr>
                    </a:p>
                    <a:p>
                      <a:pPr algn="ctr"/>
                      <a:r>
                        <a:rPr lang="fr-FR" sz="1200" b="1" dirty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fr-FR" sz="1400" b="1" dirty="0" err="1">
                          <a:solidFill>
                            <a:srgbClr val="000000"/>
                          </a:solidFill>
                        </a:rPr>
                        <a:t>Fiocruz</a:t>
                      </a:r>
                      <a:endParaRPr lang="fr-FR" sz="1200" b="1" dirty="0">
                        <a:solidFill>
                          <a:srgbClr val="000000"/>
                        </a:solidFill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dirty="0"/>
                        <a:t>FlaB2</a:t>
                      </a:r>
                    </a:p>
                  </a:txBody>
                  <a:tcPr anchor="ctr"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dirty="0"/>
                        <a:t>FlaB3</a:t>
                      </a:r>
                    </a:p>
                  </a:txBody>
                  <a:tcPr anchor="ctr"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dirty="0"/>
                        <a:t>FlaB4</a:t>
                      </a:r>
                    </a:p>
                  </a:txBody>
                  <a:tcPr anchor="ctr"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1" dirty="0">
                          <a:solidFill>
                            <a:schemeClr val="bg1"/>
                          </a:solidFill>
                        </a:rPr>
                        <a:t>FlaB1</a:t>
                      </a:r>
                    </a:p>
                  </a:txBody>
                  <a:tcPr anchor="ctr"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72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67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51%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1" dirty="0">
                          <a:solidFill>
                            <a:schemeClr val="bg1"/>
                          </a:solidFill>
                        </a:rPr>
                        <a:t>FlaB2</a:t>
                      </a:r>
                    </a:p>
                  </a:txBody>
                  <a:tcPr anchor="ctr"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/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72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55%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1" dirty="0">
                          <a:solidFill>
                            <a:schemeClr val="bg1"/>
                          </a:solidFill>
                        </a:rPr>
                        <a:t>FlaB3</a:t>
                      </a:r>
                    </a:p>
                  </a:txBody>
                  <a:tcPr anchor="ctr"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/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/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57%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</a:tbl>
          </a:graphicData>
        </a:graphic>
      </p:graphicFrame>
      <p:sp>
        <p:nvSpPr>
          <p:cNvPr id="15" name="ZoneTexte 14"/>
          <p:cNvSpPr txBox="1"/>
          <p:nvPr/>
        </p:nvSpPr>
        <p:spPr>
          <a:xfrm>
            <a:off x="3962533" y="700793"/>
            <a:ext cx="4346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17" name="Tableau 1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08705510"/>
              </p:ext>
            </p:extLst>
          </p:nvPr>
        </p:nvGraphicFramePr>
        <p:xfrm>
          <a:off x="531629" y="2742138"/>
          <a:ext cx="3092173" cy="1567680"/>
        </p:xfrm>
        <a:graphic>
          <a:graphicData uri="http://schemas.openxmlformats.org/drawingml/2006/table">
            <a:tbl>
              <a:tblPr firstRow="1" bandRow="1">
                <a:tableStyleId>{F5AB1C69-6EDB-4FF4-983F-18BD219EF322}</a:tableStyleId>
              </a:tblPr>
              <a:tblGrid>
                <a:gridCol w="1364173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57600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57600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5760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360000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dirty="0">
                          <a:solidFill>
                            <a:srgbClr val="000000"/>
                          </a:solidFill>
                        </a:rPr>
                        <a:t>BLAST-P </a:t>
                      </a:r>
                      <a:r>
                        <a:rPr lang="fr-FR" sz="1200" b="0" dirty="0" err="1">
                          <a:solidFill>
                            <a:srgbClr val="000000"/>
                          </a:solidFill>
                        </a:rPr>
                        <a:t>identity</a:t>
                      </a:r>
                      <a:r>
                        <a:rPr lang="fr-FR" sz="1200" b="0" baseline="0" dirty="0">
                          <a:solidFill>
                            <a:srgbClr val="000000"/>
                          </a:solidFill>
                        </a:rPr>
                        <a:t> % </a:t>
                      </a:r>
                      <a:r>
                        <a:rPr lang="fr-FR" sz="1400" b="1" dirty="0" err="1">
                          <a:solidFill>
                            <a:srgbClr val="000000"/>
                          </a:solidFill>
                        </a:rPr>
                        <a:t>Patoc</a:t>
                      </a:r>
                      <a:endParaRPr lang="fr-FR" sz="1400" b="1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dirty="0"/>
                        <a:t>FlaB2</a:t>
                      </a:r>
                    </a:p>
                  </a:txBody>
                  <a:tcPr anchor="ctr">
                    <a:solidFill>
                      <a:srgbClr val="9BBB5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dirty="0"/>
                        <a:t>FlaB3</a:t>
                      </a:r>
                    </a:p>
                  </a:txBody>
                  <a:tcPr anchor="ctr">
                    <a:solidFill>
                      <a:srgbClr val="9BBB5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dirty="0"/>
                        <a:t>FlaB4</a:t>
                      </a:r>
                    </a:p>
                  </a:txBody>
                  <a:tcPr anchor="ctr">
                    <a:solidFill>
                      <a:srgbClr val="9BBB5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1" dirty="0">
                          <a:solidFill>
                            <a:schemeClr val="bg1"/>
                          </a:solidFill>
                        </a:rPr>
                        <a:t>FlaB1</a:t>
                      </a:r>
                    </a:p>
                  </a:txBody>
                  <a:tcPr anchor="ctr">
                    <a:solidFill>
                      <a:srgbClr val="9BBB59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69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64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49%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1" dirty="0">
                          <a:solidFill>
                            <a:schemeClr val="bg1"/>
                          </a:solidFill>
                        </a:rPr>
                        <a:t>FlaB2</a:t>
                      </a:r>
                    </a:p>
                  </a:txBody>
                  <a:tcPr anchor="ctr">
                    <a:solidFill>
                      <a:srgbClr val="9BBB59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/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68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52%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1" dirty="0">
                          <a:solidFill>
                            <a:schemeClr val="bg1"/>
                          </a:solidFill>
                        </a:rPr>
                        <a:t>FlaB3</a:t>
                      </a:r>
                    </a:p>
                  </a:txBody>
                  <a:tcPr anchor="ctr">
                    <a:solidFill>
                      <a:srgbClr val="9BBB59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/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/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55%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</a:tbl>
          </a:graphicData>
        </a:graphic>
      </p:graphicFrame>
      <p:graphicFrame>
        <p:nvGraphicFramePr>
          <p:cNvPr id="20" name="Tableau 1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16524931"/>
              </p:ext>
            </p:extLst>
          </p:nvPr>
        </p:nvGraphicFramePr>
        <p:xfrm>
          <a:off x="4439328" y="991442"/>
          <a:ext cx="3665561" cy="1207680"/>
        </p:xfrm>
        <a:graphic>
          <a:graphicData uri="http://schemas.openxmlformats.org/drawingml/2006/table">
            <a:tbl>
              <a:tblPr firstRow="1" bandRow="1">
                <a:tableStyleId>{F5AB1C69-6EDB-4FF4-983F-18BD219EF322}</a:tableStyleId>
              </a:tblPr>
              <a:tblGrid>
                <a:gridCol w="1505561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360000">
                <a:tc>
                  <a:txBody>
                    <a:bodyPr/>
                    <a:lstStyle/>
                    <a:p>
                      <a:pPr algn="ctr"/>
                      <a:r>
                        <a:rPr lang="fr-FR" sz="1200" b="0" dirty="0">
                          <a:solidFill>
                            <a:srgbClr val="000000"/>
                          </a:solidFill>
                        </a:rPr>
                        <a:t>BLAST-P</a:t>
                      </a:r>
                      <a:r>
                        <a:rPr lang="fr-FR" sz="1200" b="0" baseline="0" dirty="0">
                          <a:solidFill>
                            <a:srgbClr val="000000"/>
                          </a:solidFill>
                        </a:rPr>
                        <a:t> (</a:t>
                      </a:r>
                      <a:r>
                        <a:rPr lang="fr-FR" sz="1200" b="0" dirty="0" err="1">
                          <a:solidFill>
                            <a:srgbClr val="000000"/>
                          </a:solidFill>
                        </a:rPr>
                        <a:t>Identity</a:t>
                      </a:r>
                      <a:r>
                        <a:rPr lang="fr-FR" sz="1200" b="0" baseline="0" dirty="0">
                          <a:solidFill>
                            <a:srgbClr val="000000"/>
                          </a:solidFill>
                        </a:rPr>
                        <a:t> %)</a:t>
                      </a:r>
                      <a:endParaRPr lang="fr-FR" sz="1200" b="0" dirty="0">
                        <a:solidFill>
                          <a:srgbClr val="000000"/>
                        </a:solidFill>
                      </a:endParaRPr>
                    </a:p>
                    <a:p>
                      <a:pPr algn="ctr"/>
                      <a:r>
                        <a:rPr lang="fr-FR" sz="1400" b="1" dirty="0">
                          <a:solidFill>
                            <a:srgbClr val="000000"/>
                          </a:solidFill>
                        </a:rPr>
                        <a:t>FlaB1</a:t>
                      </a: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dirty="0" err="1"/>
                        <a:t>Manilae</a:t>
                      </a:r>
                      <a:endParaRPr lang="fr-FR" sz="1200" b="0" dirty="0">
                        <a:solidFill>
                          <a:srgbClr val="000000"/>
                        </a:solidFill>
                      </a:endParaRPr>
                    </a:p>
                  </a:txBody>
                  <a:tcPr anchor="ctr"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dirty="0"/>
                        <a:t>Verdun</a:t>
                      </a:r>
                      <a:endParaRPr lang="fr-FR" sz="1200" b="0" dirty="0">
                        <a:solidFill>
                          <a:srgbClr val="000000"/>
                        </a:solidFill>
                      </a:endParaRPr>
                    </a:p>
                  </a:txBody>
                  <a:tcPr anchor="ctr"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err="1"/>
                        <a:t>Patoc</a:t>
                      </a:r>
                      <a:endParaRPr lang="fr-FR" sz="1200" b="0" dirty="0">
                        <a:solidFill>
                          <a:srgbClr val="000000"/>
                        </a:solidFill>
                      </a:endParaRPr>
                    </a:p>
                  </a:txBody>
                  <a:tcPr anchor="ctr">
                    <a:solidFill>
                      <a:srgbClr val="9BBB5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1" dirty="0" err="1"/>
                        <a:t>Fiocruz</a:t>
                      </a:r>
                      <a:endParaRPr lang="fr-FR" sz="1200" b="1" dirty="0">
                        <a:solidFill>
                          <a:srgbClr val="000000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99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100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92%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1" dirty="0" err="1"/>
                        <a:t>Manilae</a:t>
                      </a:r>
                      <a:endParaRPr lang="fr-FR" sz="1200" b="1" dirty="0">
                        <a:solidFill>
                          <a:srgbClr val="000000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/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99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91%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  <p:graphicFrame>
        <p:nvGraphicFramePr>
          <p:cNvPr id="21" name="Tableau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83798477"/>
              </p:ext>
            </p:extLst>
          </p:nvPr>
        </p:nvGraphicFramePr>
        <p:xfrm>
          <a:off x="4439328" y="3955728"/>
          <a:ext cx="3651294" cy="847680"/>
        </p:xfrm>
        <a:graphic>
          <a:graphicData uri="http://schemas.openxmlformats.org/drawingml/2006/table">
            <a:tbl>
              <a:tblPr firstRow="1" bandRow="1">
                <a:tableStyleId>{F5AB1C69-6EDB-4FF4-983F-18BD219EF322}</a:tableStyleId>
              </a:tblPr>
              <a:tblGrid>
                <a:gridCol w="1491294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360000">
                <a:tc>
                  <a:txBody>
                    <a:bodyPr/>
                    <a:lstStyle/>
                    <a:p>
                      <a:pPr algn="ctr"/>
                      <a:r>
                        <a:rPr lang="fr-FR" sz="1200" b="0" dirty="0">
                          <a:solidFill>
                            <a:srgbClr val="000000"/>
                          </a:solidFill>
                        </a:rPr>
                        <a:t>BLAST-P</a:t>
                      </a:r>
                      <a:r>
                        <a:rPr lang="fr-FR" sz="1200" b="0" baseline="0" dirty="0">
                          <a:solidFill>
                            <a:srgbClr val="000000"/>
                          </a:solidFill>
                        </a:rPr>
                        <a:t> (</a:t>
                      </a:r>
                      <a:r>
                        <a:rPr lang="fr-FR" sz="1200" b="0" dirty="0" err="1">
                          <a:solidFill>
                            <a:srgbClr val="000000"/>
                          </a:solidFill>
                        </a:rPr>
                        <a:t>Identity</a:t>
                      </a:r>
                      <a:r>
                        <a:rPr lang="fr-FR" sz="1200" b="0" baseline="0" dirty="0">
                          <a:solidFill>
                            <a:srgbClr val="000000"/>
                          </a:solidFill>
                        </a:rPr>
                        <a:t> %)</a:t>
                      </a:r>
                      <a:endParaRPr lang="fr-FR" sz="1200" b="0" dirty="0">
                        <a:solidFill>
                          <a:srgbClr val="000000"/>
                        </a:solidFill>
                      </a:endParaRPr>
                    </a:p>
                    <a:p>
                      <a:pPr algn="ctr"/>
                      <a:r>
                        <a:rPr lang="fr-FR" sz="1400" b="1" dirty="0">
                          <a:solidFill>
                            <a:srgbClr val="000000"/>
                          </a:solidFill>
                        </a:rPr>
                        <a:t>FlaB3</a:t>
                      </a:r>
                    </a:p>
                  </a:txBody>
                  <a:tcPr anchor="ctr"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dirty="0" err="1"/>
                        <a:t>Manilae</a:t>
                      </a:r>
                      <a:endParaRPr lang="fr-FR" sz="1200" b="0" dirty="0">
                        <a:solidFill>
                          <a:srgbClr val="000000"/>
                        </a:solidFill>
                      </a:endParaRPr>
                    </a:p>
                  </a:txBody>
                  <a:tcPr anchor="ctr"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dirty="0"/>
                        <a:t>Verdun</a:t>
                      </a:r>
                      <a:endParaRPr lang="fr-FR" sz="1200" b="0" dirty="0">
                        <a:solidFill>
                          <a:srgbClr val="000000"/>
                        </a:solidFill>
                      </a:endParaRPr>
                    </a:p>
                  </a:txBody>
                  <a:tcPr anchor="ctr"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err="1"/>
                        <a:t>Patoc</a:t>
                      </a:r>
                      <a:endParaRPr lang="fr-FR" sz="1200" b="0" dirty="0">
                        <a:solidFill>
                          <a:srgbClr val="000000"/>
                        </a:solidFill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1" dirty="0" err="1"/>
                        <a:t>Fiocruz</a:t>
                      </a:r>
                      <a:endParaRPr lang="fr-FR" sz="1200" b="1" dirty="0">
                        <a:solidFill>
                          <a:srgbClr val="000000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100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100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78%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</a:tbl>
          </a:graphicData>
        </a:graphic>
      </p:graphicFrame>
      <p:graphicFrame>
        <p:nvGraphicFramePr>
          <p:cNvPr id="22" name="Tableau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42279713"/>
              </p:ext>
            </p:extLst>
          </p:nvPr>
        </p:nvGraphicFramePr>
        <p:xfrm>
          <a:off x="4439328" y="2473585"/>
          <a:ext cx="3655401" cy="1207680"/>
        </p:xfrm>
        <a:graphic>
          <a:graphicData uri="http://schemas.openxmlformats.org/drawingml/2006/table">
            <a:tbl>
              <a:tblPr firstRow="1" bandRow="1">
                <a:tableStyleId>{F5AB1C69-6EDB-4FF4-983F-18BD219EF322}</a:tableStyleId>
              </a:tblPr>
              <a:tblGrid>
                <a:gridCol w="1495401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360000">
                <a:tc>
                  <a:txBody>
                    <a:bodyPr/>
                    <a:lstStyle/>
                    <a:p>
                      <a:pPr algn="ctr"/>
                      <a:r>
                        <a:rPr lang="fr-FR" sz="1200" b="0" dirty="0">
                          <a:solidFill>
                            <a:srgbClr val="000000"/>
                          </a:solidFill>
                        </a:rPr>
                        <a:t>BLAST-P</a:t>
                      </a:r>
                      <a:r>
                        <a:rPr lang="fr-FR" sz="1200" b="0" baseline="0" dirty="0">
                          <a:solidFill>
                            <a:srgbClr val="000000"/>
                          </a:solidFill>
                        </a:rPr>
                        <a:t> (</a:t>
                      </a:r>
                      <a:r>
                        <a:rPr lang="fr-FR" sz="1200" b="0" dirty="0" err="1">
                          <a:solidFill>
                            <a:srgbClr val="000000"/>
                          </a:solidFill>
                        </a:rPr>
                        <a:t>Identity</a:t>
                      </a:r>
                      <a:r>
                        <a:rPr lang="fr-FR" sz="1200" b="0" baseline="0" dirty="0">
                          <a:solidFill>
                            <a:srgbClr val="000000"/>
                          </a:solidFill>
                        </a:rPr>
                        <a:t> %)</a:t>
                      </a:r>
                      <a:endParaRPr lang="fr-FR" sz="1200" b="0" dirty="0">
                        <a:solidFill>
                          <a:srgbClr val="000000"/>
                        </a:solidFill>
                      </a:endParaRPr>
                    </a:p>
                    <a:p>
                      <a:pPr algn="ctr"/>
                      <a:r>
                        <a:rPr lang="fr-FR" sz="1400" b="1" dirty="0">
                          <a:solidFill>
                            <a:srgbClr val="000000"/>
                          </a:solidFill>
                        </a:rPr>
                        <a:t>FlaB2</a:t>
                      </a:r>
                    </a:p>
                  </a:txBody>
                  <a:tcPr anchor="ctr"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1" dirty="0" err="1"/>
                        <a:t>Manilae</a:t>
                      </a:r>
                      <a:endParaRPr lang="fr-FR" sz="1200" b="1" dirty="0">
                        <a:solidFill>
                          <a:srgbClr val="000000"/>
                        </a:solidFill>
                      </a:endParaRPr>
                    </a:p>
                  </a:txBody>
                  <a:tcPr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1" dirty="0"/>
                        <a:t>Verdun</a:t>
                      </a:r>
                      <a:endParaRPr lang="fr-FR" sz="1200" b="1" dirty="0">
                        <a:solidFill>
                          <a:srgbClr val="000000"/>
                        </a:solidFill>
                      </a:endParaRPr>
                    </a:p>
                  </a:txBody>
                  <a:tcPr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err="1"/>
                        <a:t>Patoc</a:t>
                      </a:r>
                      <a:endParaRPr lang="fr-FR" sz="1200" b="0" dirty="0">
                        <a:solidFill>
                          <a:srgbClr val="000000"/>
                        </a:solidFill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1" dirty="0" err="1"/>
                        <a:t>Fiocruz</a:t>
                      </a:r>
                      <a:endParaRPr lang="fr-FR" sz="1200" b="1" dirty="0">
                        <a:solidFill>
                          <a:srgbClr val="000000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99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100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dirty="0"/>
                        <a:t>87%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1" dirty="0" err="1"/>
                        <a:t>Manilae</a:t>
                      </a:r>
                      <a:endParaRPr lang="fr-FR" sz="1200" b="1" dirty="0">
                        <a:solidFill>
                          <a:srgbClr val="000000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/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99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dirty="0"/>
                        <a:t>87%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  <p:graphicFrame>
        <p:nvGraphicFramePr>
          <p:cNvPr id="23" name="Tableau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0016820"/>
              </p:ext>
            </p:extLst>
          </p:nvPr>
        </p:nvGraphicFramePr>
        <p:xfrm>
          <a:off x="4439328" y="5077871"/>
          <a:ext cx="3665561" cy="847680"/>
        </p:xfrm>
        <a:graphic>
          <a:graphicData uri="http://schemas.openxmlformats.org/drawingml/2006/table">
            <a:tbl>
              <a:tblPr firstRow="1" bandRow="1">
                <a:tableStyleId>{F5AB1C69-6EDB-4FF4-983F-18BD219EF322}</a:tableStyleId>
              </a:tblPr>
              <a:tblGrid>
                <a:gridCol w="1505561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360000">
                <a:tc>
                  <a:txBody>
                    <a:bodyPr/>
                    <a:lstStyle/>
                    <a:p>
                      <a:pPr algn="ctr"/>
                      <a:r>
                        <a:rPr lang="fr-FR" sz="1200" b="0" dirty="0">
                          <a:solidFill>
                            <a:srgbClr val="000000"/>
                          </a:solidFill>
                        </a:rPr>
                        <a:t>BLAST-P</a:t>
                      </a:r>
                      <a:r>
                        <a:rPr lang="fr-FR" sz="1200" b="0" baseline="0" dirty="0">
                          <a:solidFill>
                            <a:srgbClr val="000000"/>
                          </a:solidFill>
                        </a:rPr>
                        <a:t> (</a:t>
                      </a:r>
                      <a:r>
                        <a:rPr lang="fr-FR" sz="1200" b="0" dirty="0" err="1">
                          <a:solidFill>
                            <a:srgbClr val="000000"/>
                          </a:solidFill>
                        </a:rPr>
                        <a:t>Identity</a:t>
                      </a:r>
                      <a:r>
                        <a:rPr lang="fr-FR" sz="1200" b="0" baseline="0" dirty="0">
                          <a:solidFill>
                            <a:srgbClr val="000000"/>
                          </a:solidFill>
                        </a:rPr>
                        <a:t> %)</a:t>
                      </a:r>
                      <a:endParaRPr lang="fr-FR" sz="1200" b="0" dirty="0">
                        <a:solidFill>
                          <a:srgbClr val="000000"/>
                        </a:solidFill>
                      </a:endParaRPr>
                    </a:p>
                    <a:p>
                      <a:pPr algn="ctr"/>
                      <a:r>
                        <a:rPr lang="fr-FR" sz="1400" b="1" dirty="0">
                          <a:solidFill>
                            <a:srgbClr val="000000"/>
                          </a:solidFill>
                        </a:rPr>
                        <a:t>FlaB4</a:t>
                      </a:r>
                    </a:p>
                  </a:txBody>
                  <a:tcPr anchor="ctr">
                    <a:solidFill>
                      <a:srgbClr val="EEECE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dirty="0" err="1"/>
                        <a:t>Manilae</a:t>
                      </a:r>
                      <a:endParaRPr lang="fr-FR" sz="1200" b="0" dirty="0">
                        <a:solidFill>
                          <a:srgbClr val="000000"/>
                        </a:solidFill>
                      </a:endParaRPr>
                    </a:p>
                  </a:txBody>
                  <a:tcPr anchor="ctr"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dirty="0"/>
                        <a:t>Verdun</a:t>
                      </a:r>
                      <a:endParaRPr lang="fr-FR" sz="1200" b="0" dirty="0">
                        <a:solidFill>
                          <a:srgbClr val="000000"/>
                        </a:solidFill>
                      </a:endParaRPr>
                    </a:p>
                  </a:txBody>
                  <a:tcPr anchor="ctr"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err="1"/>
                        <a:t>Patoc</a:t>
                      </a:r>
                      <a:endParaRPr lang="fr-FR" sz="1200" b="0" dirty="0">
                        <a:solidFill>
                          <a:srgbClr val="000000"/>
                        </a:solidFill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1" dirty="0" err="1"/>
                        <a:t>Fiocruz</a:t>
                      </a:r>
                      <a:endParaRPr lang="fr-FR" sz="1200" b="1" dirty="0">
                        <a:solidFill>
                          <a:srgbClr val="000000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100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100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62%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</a:tbl>
          </a:graphicData>
        </a:graphic>
      </p:graphicFrame>
      <p:sp>
        <p:nvSpPr>
          <p:cNvPr id="2" name="ZoneTexte 1"/>
          <p:cNvSpPr txBox="1"/>
          <p:nvPr/>
        </p:nvSpPr>
        <p:spPr>
          <a:xfrm>
            <a:off x="188857" y="146910"/>
            <a:ext cx="68033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/>
              <a:t>Sup Figure 1.  </a:t>
            </a:r>
            <a:r>
              <a:rPr lang="fr-FR" sz="1600" dirty="0"/>
              <a:t>BLAST analyses </a:t>
            </a:r>
            <a:r>
              <a:rPr lang="fr-FR" sz="1600" dirty="0" err="1"/>
              <a:t>between</a:t>
            </a:r>
            <a:r>
              <a:rPr lang="fr-FR" sz="1600" dirty="0"/>
              <a:t> </a:t>
            </a:r>
            <a:r>
              <a:rPr lang="fr-FR" sz="1600" dirty="0" err="1"/>
              <a:t>leptospiral</a:t>
            </a:r>
            <a:r>
              <a:rPr lang="fr-FR" sz="1600" dirty="0"/>
              <a:t>  </a:t>
            </a:r>
            <a:r>
              <a:rPr lang="fr-FR" sz="1600" dirty="0" err="1"/>
              <a:t>flagellin</a:t>
            </a:r>
            <a:r>
              <a:rPr lang="fr-FR" sz="1600" dirty="0"/>
              <a:t> </a:t>
            </a:r>
            <a:r>
              <a:rPr lang="fr-FR" sz="1600" dirty="0" err="1"/>
              <a:t>subunits</a:t>
            </a:r>
            <a:r>
              <a:rPr lang="fr-FR" sz="1600" dirty="0"/>
              <a:t> and </a:t>
            </a:r>
            <a:r>
              <a:rPr lang="fr-FR" sz="1600" dirty="0" err="1"/>
              <a:t>species</a:t>
            </a:r>
            <a:endParaRPr lang="fr-FR" sz="1600" dirty="0"/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xmlns="" id="{BBCAA9C3-6F0E-458A-A4E3-20344BE864A3}"/>
              </a:ext>
            </a:extLst>
          </p:cNvPr>
          <p:cNvSpPr txBox="1"/>
          <p:nvPr/>
        </p:nvSpPr>
        <p:spPr>
          <a:xfrm>
            <a:off x="98897" y="700793"/>
            <a:ext cx="4346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3965400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ZoneTexte 13">
            <a:extLst>
              <a:ext uri="{FF2B5EF4-FFF2-40B4-BE49-F238E27FC236}">
                <a16:creationId xmlns:a16="http://schemas.microsoft.com/office/drawing/2014/main" xmlns="" id="{7FD7D848-F02C-44D7-90AD-E7A86FF6D24A}"/>
              </a:ext>
            </a:extLst>
          </p:cNvPr>
          <p:cNvSpPr txBox="1"/>
          <p:nvPr/>
        </p:nvSpPr>
        <p:spPr>
          <a:xfrm>
            <a:off x="355093" y="712553"/>
            <a:ext cx="3056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A</a:t>
            </a:r>
          </a:p>
        </p:txBody>
      </p:sp>
      <p:sp>
        <p:nvSpPr>
          <p:cNvPr id="71" name="ZoneTexte 70">
            <a:extLst>
              <a:ext uri="{FF2B5EF4-FFF2-40B4-BE49-F238E27FC236}">
                <a16:creationId xmlns:a16="http://schemas.microsoft.com/office/drawing/2014/main" xmlns="" id="{C5BBEA4F-352B-4318-BE55-14D244A2E833}"/>
              </a:ext>
            </a:extLst>
          </p:cNvPr>
          <p:cNvSpPr txBox="1"/>
          <p:nvPr/>
        </p:nvSpPr>
        <p:spPr>
          <a:xfrm>
            <a:off x="193240" y="2887867"/>
            <a:ext cx="38333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Adapted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 « An </a:t>
            </a:r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asymmetric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sheath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controls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flagellar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supercoiling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motility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 in the </a:t>
            </a:r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leptospira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spirochete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. Gibson </a:t>
            </a:r>
            <a:r>
              <a:rPr lang="fr-FR" sz="900" i="1" dirty="0">
                <a:latin typeface="Arial" panose="020B0604020202020204" pitchFamily="34" charset="0"/>
                <a:cs typeface="Arial" panose="020B0604020202020204" pitchFamily="34" charset="0"/>
              </a:rPr>
              <a:t>et al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., </a:t>
            </a:r>
            <a:r>
              <a:rPr lang="fr-FR" sz="900" i="1" dirty="0" err="1">
                <a:latin typeface="Arial" panose="020B0604020202020204" pitchFamily="34" charset="0"/>
                <a:cs typeface="Arial" panose="020B0604020202020204" pitchFamily="34" charset="0"/>
              </a:rPr>
              <a:t>eLife</a:t>
            </a:r>
            <a:r>
              <a:rPr lang="fr-FR" sz="9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(2020) »</a:t>
            </a:r>
          </a:p>
        </p:txBody>
      </p:sp>
      <p:grpSp>
        <p:nvGrpSpPr>
          <p:cNvPr id="80" name="Groupe 79">
            <a:extLst>
              <a:ext uri="{FF2B5EF4-FFF2-40B4-BE49-F238E27FC236}">
                <a16:creationId xmlns:a16="http://schemas.microsoft.com/office/drawing/2014/main" xmlns="" id="{7EB0DEB5-FD9B-4A44-B721-FBD44D5F0701}"/>
              </a:ext>
            </a:extLst>
          </p:cNvPr>
          <p:cNvGrpSpPr/>
          <p:nvPr/>
        </p:nvGrpSpPr>
        <p:grpSpPr>
          <a:xfrm>
            <a:off x="4952774" y="2410258"/>
            <a:ext cx="1861933" cy="58931"/>
            <a:chOff x="4118954" y="2309526"/>
            <a:chExt cx="1884971" cy="57155"/>
          </a:xfrm>
        </p:grpSpPr>
        <p:cxnSp>
          <p:nvCxnSpPr>
            <p:cNvPr id="81" name="Connecteur droit 80">
              <a:extLst>
                <a:ext uri="{FF2B5EF4-FFF2-40B4-BE49-F238E27FC236}">
                  <a16:creationId xmlns:a16="http://schemas.microsoft.com/office/drawing/2014/main" xmlns="" id="{79C39CBD-8DD1-4F05-B93E-92E807E6C5BB}"/>
                </a:ext>
              </a:extLst>
            </p:cNvPr>
            <p:cNvCxnSpPr>
              <a:cxnSpLocks/>
            </p:cNvCxnSpPr>
            <p:nvPr/>
          </p:nvCxnSpPr>
          <p:spPr>
            <a:xfrm>
              <a:off x="4118954" y="2309526"/>
              <a:ext cx="1884971" cy="0"/>
            </a:xfrm>
            <a:prstGeom prst="line">
              <a:avLst/>
            </a:prstGeom>
            <a:ln w="9525">
              <a:solidFill>
                <a:srgbClr val="00206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Connecteur droit 81">
              <a:extLst>
                <a:ext uri="{FF2B5EF4-FFF2-40B4-BE49-F238E27FC236}">
                  <a16:creationId xmlns:a16="http://schemas.microsoft.com/office/drawing/2014/main" xmlns="" id="{57108D70-AEAD-4827-A059-D3DDE7D04EB1}"/>
                </a:ext>
              </a:extLst>
            </p:cNvPr>
            <p:cNvCxnSpPr>
              <a:cxnSpLocks/>
            </p:cNvCxnSpPr>
            <p:nvPr/>
          </p:nvCxnSpPr>
          <p:spPr>
            <a:xfrm>
              <a:off x="4118954" y="2366681"/>
              <a:ext cx="1884971" cy="0"/>
            </a:xfrm>
            <a:prstGeom prst="line">
              <a:avLst/>
            </a:prstGeom>
            <a:ln w="9525">
              <a:solidFill>
                <a:srgbClr val="00206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5" name="Forme libre : forme 74">
            <a:extLst>
              <a:ext uri="{FF2B5EF4-FFF2-40B4-BE49-F238E27FC236}">
                <a16:creationId xmlns:a16="http://schemas.microsoft.com/office/drawing/2014/main" xmlns="" id="{03BA3BDC-D323-4F67-B254-930F0B35DE99}"/>
              </a:ext>
            </a:extLst>
          </p:cNvPr>
          <p:cNvSpPr/>
          <p:nvPr/>
        </p:nvSpPr>
        <p:spPr>
          <a:xfrm flipH="1">
            <a:off x="5698823" y="1553503"/>
            <a:ext cx="989893" cy="1196025"/>
          </a:xfrm>
          <a:custGeom>
            <a:avLst/>
            <a:gdLst>
              <a:gd name="connsiteX0" fmla="*/ 181262 w 1109760"/>
              <a:gd name="connsiteY0" fmla="*/ 624831 h 1204849"/>
              <a:gd name="connsiteX1" fmla="*/ 403512 w 1109760"/>
              <a:gd name="connsiteY1" fmla="*/ 320031 h 1204849"/>
              <a:gd name="connsiteX2" fmla="*/ 714662 w 1109760"/>
              <a:gd name="connsiteY2" fmla="*/ 281931 h 1204849"/>
              <a:gd name="connsiteX3" fmla="*/ 905162 w 1109760"/>
              <a:gd name="connsiteY3" fmla="*/ 389881 h 1204849"/>
              <a:gd name="connsiteX4" fmla="*/ 898812 w 1109760"/>
              <a:gd name="connsiteY4" fmla="*/ 1107431 h 1204849"/>
              <a:gd name="connsiteX5" fmla="*/ 1051212 w 1109760"/>
              <a:gd name="connsiteY5" fmla="*/ 1113781 h 1204849"/>
              <a:gd name="connsiteX6" fmla="*/ 1102012 w 1109760"/>
              <a:gd name="connsiteY6" fmla="*/ 326381 h 1204849"/>
              <a:gd name="connsiteX7" fmla="*/ 898812 w 1109760"/>
              <a:gd name="connsiteY7" fmla="*/ 78731 h 1204849"/>
              <a:gd name="connsiteX8" fmla="*/ 371762 w 1109760"/>
              <a:gd name="connsiteY8" fmla="*/ 15231 h 1204849"/>
              <a:gd name="connsiteX9" fmla="*/ 16162 w 1109760"/>
              <a:gd name="connsiteY9" fmla="*/ 332731 h 1204849"/>
              <a:gd name="connsiteX10" fmla="*/ 73312 w 1109760"/>
              <a:gd name="connsiteY10" fmla="*/ 574031 h 1204849"/>
              <a:gd name="connsiteX11" fmla="*/ 181262 w 1109760"/>
              <a:gd name="connsiteY11" fmla="*/ 624831 h 1204849"/>
              <a:gd name="connsiteX0" fmla="*/ 181262 w 1109760"/>
              <a:gd name="connsiteY0" fmla="*/ 624831 h 1204849"/>
              <a:gd name="connsiteX1" fmla="*/ 403512 w 1109760"/>
              <a:gd name="connsiteY1" fmla="*/ 320031 h 1204849"/>
              <a:gd name="connsiteX2" fmla="*/ 905162 w 1109760"/>
              <a:gd name="connsiteY2" fmla="*/ 389881 h 1204849"/>
              <a:gd name="connsiteX3" fmla="*/ 898812 w 1109760"/>
              <a:gd name="connsiteY3" fmla="*/ 1107431 h 1204849"/>
              <a:gd name="connsiteX4" fmla="*/ 1051212 w 1109760"/>
              <a:gd name="connsiteY4" fmla="*/ 1113781 h 1204849"/>
              <a:gd name="connsiteX5" fmla="*/ 1102012 w 1109760"/>
              <a:gd name="connsiteY5" fmla="*/ 326381 h 1204849"/>
              <a:gd name="connsiteX6" fmla="*/ 898812 w 1109760"/>
              <a:gd name="connsiteY6" fmla="*/ 78731 h 1204849"/>
              <a:gd name="connsiteX7" fmla="*/ 371762 w 1109760"/>
              <a:gd name="connsiteY7" fmla="*/ 15231 h 1204849"/>
              <a:gd name="connsiteX8" fmla="*/ 16162 w 1109760"/>
              <a:gd name="connsiteY8" fmla="*/ 332731 h 1204849"/>
              <a:gd name="connsiteX9" fmla="*/ 73312 w 1109760"/>
              <a:gd name="connsiteY9" fmla="*/ 574031 h 1204849"/>
              <a:gd name="connsiteX10" fmla="*/ 181262 w 1109760"/>
              <a:gd name="connsiteY10" fmla="*/ 624831 h 1204849"/>
              <a:gd name="connsiteX0" fmla="*/ 181262 w 1109760"/>
              <a:gd name="connsiteY0" fmla="*/ 624831 h 1208005"/>
              <a:gd name="connsiteX1" fmla="*/ 403512 w 1109760"/>
              <a:gd name="connsiteY1" fmla="*/ 320031 h 1208005"/>
              <a:gd name="connsiteX2" fmla="*/ 838487 w 1109760"/>
              <a:gd name="connsiteY2" fmla="*/ 337493 h 1208005"/>
              <a:gd name="connsiteX3" fmla="*/ 898812 w 1109760"/>
              <a:gd name="connsiteY3" fmla="*/ 1107431 h 1208005"/>
              <a:gd name="connsiteX4" fmla="*/ 1051212 w 1109760"/>
              <a:gd name="connsiteY4" fmla="*/ 1113781 h 1208005"/>
              <a:gd name="connsiteX5" fmla="*/ 1102012 w 1109760"/>
              <a:gd name="connsiteY5" fmla="*/ 326381 h 1208005"/>
              <a:gd name="connsiteX6" fmla="*/ 898812 w 1109760"/>
              <a:gd name="connsiteY6" fmla="*/ 78731 h 1208005"/>
              <a:gd name="connsiteX7" fmla="*/ 371762 w 1109760"/>
              <a:gd name="connsiteY7" fmla="*/ 15231 h 1208005"/>
              <a:gd name="connsiteX8" fmla="*/ 16162 w 1109760"/>
              <a:gd name="connsiteY8" fmla="*/ 332731 h 1208005"/>
              <a:gd name="connsiteX9" fmla="*/ 73312 w 1109760"/>
              <a:gd name="connsiteY9" fmla="*/ 574031 h 1208005"/>
              <a:gd name="connsiteX10" fmla="*/ 181262 w 1109760"/>
              <a:gd name="connsiteY10" fmla="*/ 624831 h 1208005"/>
              <a:gd name="connsiteX0" fmla="*/ 181262 w 1109760"/>
              <a:gd name="connsiteY0" fmla="*/ 624831 h 1208005"/>
              <a:gd name="connsiteX1" fmla="*/ 403512 w 1109760"/>
              <a:gd name="connsiteY1" fmla="*/ 320031 h 1208005"/>
              <a:gd name="connsiteX2" fmla="*/ 838487 w 1109760"/>
              <a:gd name="connsiteY2" fmla="*/ 337493 h 1208005"/>
              <a:gd name="connsiteX3" fmla="*/ 898812 w 1109760"/>
              <a:gd name="connsiteY3" fmla="*/ 1107431 h 1208005"/>
              <a:gd name="connsiteX4" fmla="*/ 1051212 w 1109760"/>
              <a:gd name="connsiteY4" fmla="*/ 1113781 h 1208005"/>
              <a:gd name="connsiteX5" fmla="*/ 1102012 w 1109760"/>
              <a:gd name="connsiteY5" fmla="*/ 326381 h 1208005"/>
              <a:gd name="connsiteX6" fmla="*/ 898812 w 1109760"/>
              <a:gd name="connsiteY6" fmla="*/ 78731 h 1208005"/>
              <a:gd name="connsiteX7" fmla="*/ 371762 w 1109760"/>
              <a:gd name="connsiteY7" fmla="*/ 15231 h 1208005"/>
              <a:gd name="connsiteX8" fmla="*/ 16162 w 1109760"/>
              <a:gd name="connsiteY8" fmla="*/ 332731 h 1208005"/>
              <a:gd name="connsiteX9" fmla="*/ 73312 w 1109760"/>
              <a:gd name="connsiteY9" fmla="*/ 574031 h 1208005"/>
              <a:gd name="connsiteX10" fmla="*/ 181262 w 1109760"/>
              <a:gd name="connsiteY10" fmla="*/ 624831 h 1208005"/>
              <a:gd name="connsiteX0" fmla="*/ 181262 w 1109760"/>
              <a:gd name="connsiteY0" fmla="*/ 624831 h 1206850"/>
              <a:gd name="connsiteX1" fmla="*/ 403512 w 1109760"/>
              <a:gd name="connsiteY1" fmla="*/ 320031 h 1206850"/>
              <a:gd name="connsiteX2" fmla="*/ 876587 w 1109760"/>
              <a:gd name="connsiteY2" fmla="*/ 356543 h 1206850"/>
              <a:gd name="connsiteX3" fmla="*/ 898812 w 1109760"/>
              <a:gd name="connsiteY3" fmla="*/ 1107431 h 1206850"/>
              <a:gd name="connsiteX4" fmla="*/ 1051212 w 1109760"/>
              <a:gd name="connsiteY4" fmla="*/ 1113781 h 1206850"/>
              <a:gd name="connsiteX5" fmla="*/ 1102012 w 1109760"/>
              <a:gd name="connsiteY5" fmla="*/ 326381 h 1206850"/>
              <a:gd name="connsiteX6" fmla="*/ 898812 w 1109760"/>
              <a:gd name="connsiteY6" fmla="*/ 78731 h 1206850"/>
              <a:gd name="connsiteX7" fmla="*/ 371762 w 1109760"/>
              <a:gd name="connsiteY7" fmla="*/ 15231 h 1206850"/>
              <a:gd name="connsiteX8" fmla="*/ 16162 w 1109760"/>
              <a:gd name="connsiteY8" fmla="*/ 332731 h 1206850"/>
              <a:gd name="connsiteX9" fmla="*/ 73312 w 1109760"/>
              <a:gd name="connsiteY9" fmla="*/ 574031 h 1206850"/>
              <a:gd name="connsiteX10" fmla="*/ 181262 w 1109760"/>
              <a:gd name="connsiteY10" fmla="*/ 624831 h 1206850"/>
              <a:gd name="connsiteX0" fmla="*/ 169944 w 1098442"/>
              <a:gd name="connsiteY0" fmla="*/ 624831 h 1206850"/>
              <a:gd name="connsiteX1" fmla="*/ 392194 w 1098442"/>
              <a:gd name="connsiteY1" fmla="*/ 320031 h 1206850"/>
              <a:gd name="connsiteX2" fmla="*/ 865269 w 1098442"/>
              <a:gd name="connsiteY2" fmla="*/ 356543 h 1206850"/>
              <a:gd name="connsiteX3" fmla="*/ 887494 w 1098442"/>
              <a:gd name="connsiteY3" fmla="*/ 1107431 h 1206850"/>
              <a:gd name="connsiteX4" fmla="*/ 1039894 w 1098442"/>
              <a:gd name="connsiteY4" fmla="*/ 1113781 h 1206850"/>
              <a:gd name="connsiteX5" fmla="*/ 1090694 w 1098442"/>
              <a:gd name="connsiteY5" fmla="*/ 326381 h 1206850"/>
              <a:gd name="connsiteX6" fmla="*/ 887494 w 1098442"/>
              <a:gd name="connsiteY6" fmla="*/ 78731 h 1206850"/>
              <a:gd name="connsiteX7" fmla="*/ 360444 w 1098442"/>
              <a:gd name="connsiteY7" fmla="*/ 15231 h 1206850"/>
              <a:gd name="connsiteX8" fmla="*/ 4844 w 1098442"/>
              <a:gd name="connsiteY8" fmla="*/ 332731 h 1206850"/>
              <a:gd name="connsiteX9" fmla="*/ 169944 w 1098442"/>
              <a:gd name="connsiteY9" fmla="*/ 624831 h 1206850"/>
              <a:gd name="connsiteX0" fmla="*/ 70966 w 999464"/>
              <a:gd name="connsiteY0" fmla="*/ 624161 h 1206180"/>
              <a:gd name="connsiteX1" fmla="*/ 293216 w 999464"/>
              <a:gd name="connsiteY1" fmla="*/ 319361 h 1206180"/>
              <a:gd name="connsiteX2" fmla="*/ 766291 w 999464"/>
              <a:gd name="connsiteY2" fmla="*/ 355873 h 1206180"/>
              <a:gd name="connsiteX3" fmla="*/ 788516 w 999464"/>
              <a:gd name="connsiteY3" fmla="*/ 1106761 h 1206180"/>
              <a:gd name="connsiteX4" fmla="*/ 940916 w 999464"/>
              <a:gd name="connsiteY4" fmla="*/ 1113111 h 1206180"/>
              <a:gd name="connsiteX5" fmla="*/ 991716 w 999464"/>
              <a:gd name="connsiteY5" fmla="*/ 325711 h 1206180"/>
              <a:gd name="connsiteX6" fmla="*/ 788516 w 999464"/>
              <a:gd name="connsiteY6" fmla="*/ 78061 h 1206180"/>
              <a:gd name="connsiteX7" fmla="*/ 261466 w 999464"/>
              <a:gd name="connsiteY7" fmla="*/ 14561 h 1206180"/>
              <a:gd name="connsiteX8" fmla="*/ 10641 w 999464"/>
              <a:gd name="connsiteY8" fmla="*/ 322536 h 1206180"/>
              <a:gd name="connsiteX9" fmla="*/ 70966 w 999464"/>
              <a:gd name="connsiteY9" fmla="*/ 624161 h 1206180"/>
              <a:gd name="connsiteX0" fmla="*/ 44821 w 1006656"/>
              <a:gd name="connsiteY0" fmla="*/ 571773 h 1206180"/>
              <a:gd name="connsiteX1" fmla="*/ 300408 w 1006656"/>
              <a:gd name="connsiteY1" fmla="*/ 319361 h 1206180"/>
              <a:gd name="connsiteX2" fmla="*/ 773483 w 1006656"/>
              <a:gd name="connsiteY2" fmla="*/ 355873 h 1206180"/>
              <a:gd name="connsiteX3" fmla="*/ 795708 w 1006656"/>
              <a:gd name="connsiteY3" fmla="*/ 1106761 h 1206180"/>
              <a:gd name="connsiteX4" fmla="*/ 948108 w 1006656"/>
              <a:gd name="connsiteY4" fmla="*/ 1113111 h 1206180"/>
              <a:gd name="connsiteX5" fmla="*/ 998908 w 1006656"/>
              <a:gd name="connsiteY5" fmla="*/ 325711 h 1206180"/>
              <a:gd name="connsiteX6" fmla="*/ 795708 w 1006656"/>
              <a:gd name="connsiteY6" fmla="*/ 78061 h 1206180"/>
              <a:gd name="connsiteX7" fmla="*/ 268658 w 1006656"/>
              <a:gd name="connsiteY7" fmla="*/ 14561 h 1206180"/>
              <a:gd name="connsiteX8" fmla="*/ 17833 w 1006656"/>
              <a:gd name="connsiteY8" fmla="*/ 322536 h 1206180"/>
              <a:gd name="connsiteX9" fmla="*/ 44821 w 1006656"/>
              <a:gd name="connsiteY9" fmla="*/ 571773 h 1206180"/>
              <a:gd name="connsiteX0" fmla="*/ 60979 w 1022814"/>
              <a:gd name="connsiteY0" fmla="*/ 571773 h 1206180"/>
              <a:gd name="connsiteX1" fmla="*/ 316566 w 1022814"/>
              <a:gd name="connsiteY1" fmla="*/ 319361 h 1206180"/>
              <a:gd name="connsiteX2" fmla="*/ 789641 w 1022814"/>
              <a:gd name="connsiteY2" fmla="*/ 355873 h 1206180"/>
              <a:gd name="connsiteX3" fmla="*/ 811866 w 1022814"/>
              <a:gd name="connsiteY3" fmla="*/ 1106761 h 1206180"/>
              <a:gd name="connsiteX4" fmla="*/ 964266 w 1022814"/>
              <a:gd name="connsiteY4" fmla="*/ 1113111 h 1206180"/>
              <a:gd name="connsiteX5" fmla="*/ 1015066 w 1022814"/>
              <a:gd name="connsiteY5" fmla="*/ 325711 h 1206180"/>
              <a:gd name="connsiteX6" fmla="*/ 811866 w 1022814"/>
              <a:gd name="connsiteY6" fmla="*/ 78061 h 1206180"/>
              <a:gd name="connsiteX7" fmla="*/ 284816 w 1022814"/>
              <a:gd name="connsiteY7" fmla="*/ 14561 h 1206180"/>
              <a:gd name="connsiteX8" fmla="*/ 33991 w 1022814"/>
              <a:gd name="connsiteY8" fmla="*/ 322536 h 1206180"/>
              <a:gd name="connsiteX9" fmla="*/ 60979 w 1022814"/>
              <a:gd name="connsiteY9" fmla="*/ 571773 h 1206180"/>
              <a:gd name="connsiteX0" fmla="*/ 60979 w 1022814"/>
              <a:gd name="connsiteY0" fmla="*/ 531159 h 1165566"/>
              <a:gd name="connsiteX1" fmla="*/ 316566 w 1022814"/>
              <a:gd name="connsiteY1" fmla="*/ 278747 h 1165566"/>
              <a:gd name="connsiteX2" fmla="*/ 789641 w 1022814"/>
              <a:gd name="connsiteY2" fmla="*/ 315259 h 1165566"/>
              <a:gd name="connsiteX3" fmla="*/ 811866 w 1022814"/>
              <a:gd name="connsiteY3" fmla="*/ 1066147 h 1165566"/>
              <a:gd name="connsiteX4" fmla="*/ 964266 w 1022814"/>
              <a:gd name="connsiteY4" fmla="*/ 1072497 h 1165566"/>
              <a:gd name="connsiteX5" fmla="*/ 1015066 w 1022814"/>
              <a:gd name="connsiteY5" fmla="*/ 285097 h 1165566"/>
              <a:gd name="connsiteX6" fmla="*/ 811866 w 1022814"/>
              <a:gd name="connsiteY6" fmla="*/ 37447 h 1165566"/>
              <a:gd name="connsiteX7" fmla="*/ 303866 w 1022814"/>
              <a:gd name="connsiteY7" fmla="*/ 26334 h 1165566"/>
              <a:gd name="connsiteX8" fmla="*/ 33991 w 1022814"/>
              <a:gd name="connsiteY8" fmla="*/ 281922 h 1165566"/>
              <a:gd name="connsiteX9" fmla="*/ 60979 w 1022814"/>
              <a:gd name="connsiteY9" fmla="*/ 531159 h 1165566"/>
              <a:gd name="connsiteX0" fmla="*/ 60979 w 1022814"/>
              <a:gd name="connsiteY0" fmla="*/ 531159 h 1165566"/>
              <a:gd name="connsiteX1" fmla="*/ 316566 w 1022814"/>
              <a:gd name="connsiteY1" fmla="*/ 278747 h 1165566"/>
              <a:gd name="connsiteX2" fmla="*/ 789641 w 1022814"/>
              <a:gd name="connsiteY2" fmla="*/ 315259 h 1165566"/>
              <a:gd name="connsiteX3" fmla="*/ 811866 w 1022814"/>
              <a:gd name="connsiteY3" fmla="*/ 1066147 h 1165566"/>
              <a:gd name="connsiteX4" fmla="*/ 964266 w 1022814"/>
              <a:gd name="connsiteY4" fmla="*/ 1072497 h 1165566"/>
              <a:gd name="connsiteX5" fmla="*/ 1015066 w 1022814"/>
              <a:gd name="connsiteY5" fmla="*/ 285097 h 1165566"/>
              <a:gd name="connsiteX6" fmla="*/ 811866 w 1022814"/>
              <a:gd name="connsiteY6" fmla="*/ 37447 h 1165566"/>
              <a:gd name="connsiteX7" fmla="*/ 303866 w 1022814"/>
              <a:gd name="connsiteY7" fmla="*/ 26334 h 1165566"/>
              <a:gd name="connsiteX8" fmla="*/ 33991 w 1022814"/>
              <a:gd name="connsiteY8" fmla="*/ 281922 h 1165566"/>
              <a:gd name="connsiteX9" fmla="*/ 60979 w 1022814"/>
              <a:gd name="connsiteY9" fmla="*/ 531159 h 1165566"/>
              <a:gd name="connsiteX0" fmla="*/ 66297 w 1028132"/>
              <a:gd name="connsiteY0" fmla="*/ 531159 h 1165566"/>
              <a:gd name="connsiteX1" fmla="*/ 321884 w 1028132"/>
              <a:gd name="connsiteY1" fmla="*/ 278747 h 1165566"/>
              <a:gd name="connsiteX2" fmla="*/ 794959 w 1028132"/>
              <a:gd name="connsiteY2" fmla="*/ 315259 h 1165566"/>
              <a:gd name="connsiteX3" fmla="*/ 817184 w 1028132"/>
              <a:gd name="connsiteY3" fmla="*/ 1066147 h 1165566"/>
              <a:gd name="connsiteX4" fmla="*/ 969584 w 1028132"/>
              <a:gd name="connsiteY4" fmla="*/ 1072497 h 1165566"/>
              <a:gd name="connsiteX5" fmla="*/ 1020384 w 1028132"/>
              <a:gd name="connsiteY5" fmla="*/ 285097 h 1165566"/>
              <a:gd name="connsiteX6" fmla="*/ 817184 w 1028132"/>
              <a:gd name="connsiteY6" fmla="*/ 37447 h 1165566"/>
              <a:gd name="connsiteX7" fmla="*/ 309184 w 1028132"/>
              <a:gd name="connsiteY7" fmla="*/ 26334 h 1165566"/>
              <a:gd name="connsiteX8" fmla="*/ 39309 w 1028132"/>
              <a:gd name="connsiteY8" fmla="*/ 281922 h 1165566"/>
              <a:gd name="connsiteX9" fmla="*/ 66297 w 1028132"/>
              <a:gd name="connsiteY9" fmla="*/ 531159 h 1165566"/>
              <a:gd name="connsiteX0" fmla="*/ 28 w 961863"/>
              <a:gd name="connsiteY0" fmla="*/ 531159 h 1165566"/>
              <a:gd name="connsiteX1" fmla="*/ 255615 w 961863"/>
              <a:gd name="connsiteY1" fmla="*/ 278747 h 1165566"/>
              <a:gd name="connsiteX2" fmla="*/ 728690 w 961863"/>
              <a:gd name="connsiteY2" fmla="*/ 315259 h 1165566"/>
              <a:gd name="connsiteX3" fmla="*/ 750915 w 961863"/>
              <a:gd name="connsiteY3" fmla="*/ 1066147 h 1165566"/>
              <a:gd name="connsiteX4" fmla="*/ 903315 w 961863"/>
              <a:gd name="connsiteY4" fmla="*/ 1072497 h 1165566"/>
              <a:gd name="connsiteX5" fmla="*/ 954115 w 961863"/>
              <a:gd name="connsiteY5" fmla="*/ 285097 h 1165566"/>
              <a:gd name="connsiteX6" fmla="*/ 750915 w 961863"/>
              <a:gd name="connsiteY6" fmla="*/ 37447 h 1165566"/>
              <a:gd name="connsiteX7" fmla="*/ 242915 w 961863"/>
              <a:gd name="connsiteY7" fmla="*/ 26334 h 1165566"/>
              <a:gd name="connsiteX8" fmla="*/ 28 w 961863"/>
              <a:gd name="connsiteY8" fmla="*/ 531159 h 1165566"/>
              <a:gd name="connsiteX0" fmla="*/ 25 w 976148"/>
              <a:gd name="connsiteY0" fmla="*/ 564224 h 1184344"/>
              <a:gd name="connsiteX1" fmla="*/ 269900 w 976148"/>
              <a:gd name="connsiteY1" fmla="*/ 297525 h 1184344"/>
              <a:gd name="connsiteX2" fmla="*/ 742975 w 976148"/>
              <a:gd name="connsiteY2" fmla="*/ 334037 h 1184344"/>
              <a:gd name="connsiteX3" fmla="*/ 765200 w 976148"/>
              <a:gd name="connsiteY3" fmla="*/ 1084925 h 1184344"/>
              <a:gd name="connsiteX4" fmla="*/ 917600 w 976148"/>
              <a:gd name="connsiteY4" fmla="*/ 1091275 h 1184344"/>
              <a:gd name="connsiteX5" fmla="*/ 968400 w 976148"/>
              <a:gd name="connsiteY5" fmla="*/ 303875 h 1184344"/>
              <a:gd name="connsiteX6" fmla="*/ 765200 w 976148"/>
              <a:gd name="connsiteY6" fmla="*/ 56225 h 1184344"/>
              <a:gd name="connsiteX7" fmla="*/ 257200 w 976148"/>
              <a:gd name="connsiteY7" fmla="*/ 45112 h 1184344"/>
              <a:gd name="connsiteX8" fmla="*/ 25 w 976148"/>
              <a:gd name="connsiteY8" fmla="*/ 564224 h 1184344"/>
              <a:gd name="connsiteX0" fmla="*/ 32195 w 1008318"/>
              <a:gd name="connsiteY0" fmla="*/ 564224 h 1184344"/>
              <a:gd name="connsiteX1" fmla="*/ 302070 w 1008318"/>
              <a:gd name="connsiteY1" fmla="*/ 297525 h 1184344"/>
              <a:gd name="connsiteX2" fmla="*/ 775145 w 1008318"/>
              <a:gd name="connsiteY2" fmla="*/ 334037 h 1184344"/>
              <a:gd name="connsiteX3" fmla="*/ 797370 w 1008318"/>
              <a:gd name="connsiteY3" fmla="*/ 1084925 h 1184344"/>
              <a:gd name="connsiteX4" fmla="*/ 949770 w 1008318"/>
              <a:gd name="connsiteY4" fmla="*/ 1091275 h 1184344"/>
              <a:gd name="connsiteX5" fmla="*/ 1000570 w 1008318"/>
              <a:gd name="connsiteY5" fmla="*/ 303875 h 1184344"/>
              <a:gd name="connsiteX6" fmla="*/ 797370 w 1008318"/>
              <a:gd name="connsiteY6" fmla="*/ 56225 h 1184344"/>
              <a:gd name="connsiteX7" fmla="*/ 289370 w 1008318"/>
              <a:gd name="connsiteY7" fmla="*/ 45112 h 1184344"/>
              <a:gd name="connsiteX8" fmla="*/ 32195 w 1008318"/>
              <a:gd name="connsiteY8" fmla="*/ 564224 h 1184344"/>
              <a:gd name="connsiteX0" fmla="*/ 1267 w 977390"/>
              <a:gd name="connsiteY0" fmla="*/ 564224 h 1184344"/>
              <a:gd name="connsiteX1" fmla="*/ 356867 w 977390"/>
              <a:gd name="connsiteY1" fmla="*/ 254662 h 1184344"/>
              <a:gd name="connsiteX2" fmla="*/ 744217 w 977390"/>
              <a:gd name="connsiteY2" fmla="*/ 334037 h 1184344"/>
              <a:gd name="connsiteX3" fmla="*/ 766442 w 977390"/>
              <a:gd name="connsiteY3" fmla="*/ 1084925 h 1184344"/>
              <a:gd name="connsiteX4" fmla="*/ 918842 w 977390"/>
              <a:gd name="connsiteY4" fmla="*/ 1091275 h 1184344"/>
              <a:gd name="connsiteX5" fmla="*/ 969642 w 977390"/>
              <a:gd name="connsiteY5" fmla="*/ 303875 h 1184344"/>
              <a:gd name="connsiteX6" fmla="*/ 766442 w 977390"/>
              <a:gd name="connsiteY6" fmla="*/ 56225 h 1184344"/>
              <a:gd name="connsiteX7" fmla="*/ 258442 w 977390"/>
              <a:gd name="connsiteY7" fmla="*/ 45112 h 1184344"/>
              <a:gd name="connsiteX8" fmla="*/ 1267 w 977390"/>
              <a:gd name="connsiteY8" fmla="*/ 564224 h 1184344"/>
              <a:gd name="connsiteX0" fmla="*/ 28708 w 1004831"/>
              <a:gd name="connsiteY0" fmla="*/ 564224 h 1184344"/>
              <a:gd name="connsiteX1" fmla="*/ 384308 w 1004831"/>
              <a:gd name="connsiteY1" fmla="*/ 254662 h 1184344"/>
              <a:gd name="connsiteX2" fmla="*/ 771658 w 1004831"/>
              <a:gd name="connsiteY2" fmla="*/ 334037 h 1184344"/>
              <a:gd name="connsiteX3" fmla="*/ 793883 w 1004831"/>
              <a:gd name="connsiteY3" fmla="*/ 1084925 h 1184344"/>
              <a:gd name="connsiteX4" fmla="*/ 946283 w 1004831"/>
              <a:gd name="connsiteY4" fmla="*/ 1091275 h 1184344"/>
              <a:gd name="connsiteX5" fmla="*/ 997083 w 1004831"/>
              <a:gd name="connsiteY5" fmla="*/ 303875 h 1184344"/>
              <a:gd name="connsiteX6" fmla="*/ 793883 w 1004831"/>
              <a:gd name="connsiteY6" fmla="*/ 56225 h 1184344"/>
              <a:gd name="connsiteX7" fmla="*/ 285883 w 1004831"/>
              <a:gd name="connsiteY7" fmla="*/ 45112 h 1184344"/>
              <a:gd name="connsiteX8" fmla="*/ 28708 w 1004831"/>
              <a:gd name="connsiteY8" fmla="*/ 564224 h 1184344"/>
              <a:gd name="connsiteX0" fmla="*/ 28708 w 1004831"/>
              <a:gd name="connsiteY0" fmla="*/ 564224 h 1184344"/>
              <a:gd name="connsiteX1" fmla="*/ 384308 w 1004831"/>
              <a:gd name="connsiteY1" fmla="*/ 254662 h 1184344"/>
              <a:gd name="connsiteX2" fmla="*/ 771658 w 1004831"/>
              <a:gd name="connsiteY2" fmla="*/ 334037 h 1184344"/>
              <a:gd name="connsiteX3" fmla="*/ 793883 w 1004831"/>
              <a:gd name="connsiteY3" fmla="*/ 1084925 h 1184344"/>
              <a:gd name="connsiteX4" fmla="*/ 946283 w 1004831"/>
              <a:gd name="connsiteY4" fmla="*/ 1091275 h 1184344"/>
              <a:gd name="connsiteX5" fmla="*/ 997083 w 1004831"/>
              <a:gd name="connsiteY5" fmla="*/ 303875 h 1184344"/>
              <a:gd name="connsiteX6" fmla="*/ 793883 w 1004831"/>
              <a:gd name="connsiteY6" fmla="*/ 56225 h 1184344"/>
              <a:gd name="connsiteX7" fmla="*/ 285883 w 1004831"/>
              <a:gd name="connsiteY7" fmla="*/ 45112 h 1184344"/>
              <a:gd name="connsiteX8" fmla="*/ 28708 w 1004831"/>
              <a:gd name="connsiteY8" fmla="*/ 564224 h 1184344"/>
              <a:gd name="connsiteX0" fmla="*/ 27614 w 1003737"/>
              <a:gd name="connsiteY0" fmla="*/ 558025 h 1178145"/>
              <a:gd name="connsiteX1" fmla="*/ 383214 w 1003737"/>
              <a:gd name="connsiteY1" fmla="*/ 248463 h 1178145"/>
              <a:gd name="connsiteX2" fmla="*/ 770564 w 1003737"/>
              <a:gd name="connsiteY2" fmla="*/ 327838 h 1178145"/>
              <a:gd name="connsiteX3" fmla="*/ 792789 w 1003737"/>
              <a:gd name="connsiteY3" fmla="*/ 1078726 h 1178145"/>
              <a:gd name="connsiteX4" fmla="*/ 945189 w 1003737"/>
              <a:gd name="connsiteY4" fmla="*/ 1085076 h 1178145"/>
              <a:gd name="connsiteX5" fmla="*/ 995989 w 1003737"/>
              <a:gd name="connsiteY5" fmla="*/ 297676 h 1178145"/>
              <a:gd name="connsiteX6" fmla="*/ 792789 w 1003737"/>
              <a:gd name="connsiteY6" fmla="*/ 50026 h 1178145"/>
              <a:gd name="connsiteX7" fmla="*/ 284789 w 1003737"/>
              <a:gd name="connsiteY7" fmla="*/ 38913 h 1178145"/>
              <a:gd name="connsiteX8" fmla="*/ 27614 w 1003737"/>
              <a:gd name="connsiteY8" fmla="*/ 558025 h 1178145"/>
              <a:gd name="connsiteX0" fmla="*/ 31579 w 1007702"/>
              <a:gd name="connsiteY0" fmla="*/ 564224 h 1184344"/>
              <a:gd name="connsiteX1" fmla="*/ 387179 w 1007702"/>
              <a:gd name="connsiteY1" fmla="*/ 254662 h 1184344"/>
              <a:gd name="connsiteX2" fmla="*/ 774529 w 1007702"/>
              <a:gd name="connsiteY2" fmla="*/ 334037 h 1184344"/>
              <a:gd name="connsiteX3" fmla="*/ 796754 w 1007702"/>
              <a:gd name="connsiteY3" fmla="*/ 1084925 h 1184344"/>
              <a:gd name="connsiteX4" fmla="*/ 949154 w 1007702"/>
              <a:gd name="connsiteY4" fmla="*/ 1091275 h 1184344"/>
              <a:gd name="connsiteX5" fmla="*/ 999954 w 1007702"/>
              <a:gd name="connsiteY5" fmla="*/ 303875 h 1184344"/>
              <a:gd name="connsiteX6" fmla="*/ 796754 w 1007702"/>
              <a:gd name="connsiteY6" fmla="*/ 56225 h 1184344"/>
              <a:gd name="connsiteX7" fmla="*/ 288754 w 1007702"/>
              <a:gd name="connsiteY7" fmla="*/ 45112 h 1184344"/>
              <a:gd name="connsiteX8" fmla="*/ 31579 w 1007702"/>
              <a:gd name="connsiteY8" fmla="*/ 564224 h 1184344"/>
              <a:gd name="connsiteX0" fmla="*/ 2502 w 978625"/>
              <a:gd name="connsiteY0" fmla="*/ 545503 h 1165623"/>
              <a:gd name="connsiteX1" fmla="*/ 358102 w 978625"/>
              <a:gd name="connsiteY1" fmla="*/ 235941 h 1165623"/>
              <a:gd name="connsiteX2" fmla="*/ 745452 w 978625"/>
              <a:gd name="connsiteY2" fmla="*/ 315316 h 1165623"/>
              <a:gd name="connsiteX3" fmla="*/ 767677 w 978625"/>
              <a:gd name="connsiteY3" fmla="*/ 1066204 h 1165623"/>
              <a:gd name="connsiteX4" fmla="*/ 920077 w 978625"/>
              <a:gd name="connsiteY4" fmla="*/ 1072554 h 1165623"/>
              <a:gd name="connsiteX5" fmla="*/ 970877 w 978625"/>
              <a:gd name="connsiteY5" fmla="*/ 285154 h 1165623"/>
              <a:gd name="connsiteX6" fmla="*/ 767677 w 978625"/>
              <a:gd name="connsiteY6" fmla="*/ 37504 h 1165623"/>
              <a:gd name="connsiteX7" fmla="*/ 240627 w 978625"/>
              <a:gd name="connsiteY7" fmla="*/ 54966 h 1165623"/>
              <a:gd name="connsiteX8" fmla="*/ 2502 w 978625"/>
              <a:gd name="connsiteY8" fmla="*/ 545503 h 1165623"/>
              <a:gd name="connsiteX0" fmla="*/ 34870 w 1010993"/>
              <a:gd name="connsiteY0" fmla="*/ 545503 h 1165623"/>
              <a:gd name="connsiteX1" fmla="*/ 390470 w 1010993"/>
              <a:gd name="connsiteY1" fmla="*/ 235941 h 1165623"/>
              <a:gd name="connsiteX2" fmla="*/ 777820 w 1010993"/>
              <a:gd name="connsiteY2" fmla="*/ 315316 h 1165623"/>
              <a:gd name="connsiteX3" fmla="*/ 800045 w 1010993"/>
              <a:gd name="connsiteY3" fmla="*/ 1066204 h 1165623"/>
              <a:gd name="connsiteX4" fmla="*/ 952445 w 1010993"/>
              <a:gd name="connsiteY4" fmla="*/ 1072554 h 1165623"/>
              <a:gd name="connsiteX5" fmla="*/ 1003245 w 1010993"/>
              <a:gd name="connsiteY5" fmla="*/ 285154 h 1165623"/>
              <a:gd name="connsiteX6" fmla="*/ 800045 w 1010993"/>
              <a:gd name="connsiteY6" fmla="*/ 37504 h 1165623"/>
              <a:gd name="connsiteX7" fmla="*/ 272995 w 1010993"/>
              <a:gd name="connsiteY7" fmla="*/ 54966 h 1165623"/>
              <a:gd name="connsiteX8" fmla="*/ 34870 w 1010993"/>
              <a:gd name="connsiteY8" fmla="*/ 545503 h 1165623"/>
              <a:gd name="connsiteX0" fmla="*/ 25644 w 1001767"/>
              <a:gd name="connsiteY0" fmla="*/ 545503 h 1165623"/>
              <a:gd name="connsiteX1" fmla="*/ 381244 w 1001767"/>
              <a:gd name="connsiteY1" fmla="*/ 235941 h 1165623"/>
              <a:gd name="connsiteX2" fmla="*/ 768594 w 1001767"/>
              <a:gd name="connsiteY2" fmla="*/ 315316 h 1165623"/>
              <a:gd name="connsiteX3" fmla="*/ 790819 w 1001767"/>
              <a:gd name="connsiteY3" fmla="*/ 1066204 h 1165623"/>
              <a:gd name="connsiteX4" fmla="*/ 943219 w 1001767"/>
              <a:gd name="connsiteY4" fmla="*/ 1072554 h 1165623"/>
              <a:gd name="connsiteX5" fmla="*/ 994019 w 1001767"/>
              <a:gd name="connsiteY5" fmla="*/ 285154 h 1165623"/>
              <a:gd name="connsiteX6" fmla="*/ 790819 w 1001767"/>
              <a:gd name="connsiteY6" fmla="*/ 37504 h 1165623"/>
              <a:gd name="connsiteX7" fmla="*/ 263769 w 1001767"/>
              <a:gd name="connsiteY7" fmla="*/ 54966 h 1165623"/>
              <a:gd name="connsiteX8" fmla="*/ 25644 w 1001767"/>
              <a:gd name="connsiteY8" fmla="*/ 545503 h 1165623"/>
              <a:gd name="connsiteX0" fmla="*/ 32997 w 1009120"/>
              <a:gd name="connsiteY0" fmla="*/ 545503 h 1165623"/>
              <a:gd name="connsiteX1" fmla="*/ 388597 w 1009120"/>
              <a:gd name="connsiteY1" fmla="*/ 235941 h 1165623"/>
              <a:gd name="connsiteX2" fmla="*/ 775947 w 1009120"/>
              <a:gd name="connsiteY2" fmla="*/ 315316 h 1165623"/>
              <a:gd name="connsiteX3" fmla="*/ 798172 w 1009120"/>
              <a:gd name="connsiteY3" fmla="*/ 1066204 h 1165623"/>
              <a:gd name="connsiteX4" fmla="*/ 950572 w 1009120"/>
              <a:gd name="connsiteY4" fmla="*/ 1072554 h 1165623"/>
              <a:gd name="connsiteX5" fmla="*/ 1001372 w 1009120"/>
              <a:gd name="connsiteY5" fmla="*/ 285154 h 1165623"/>
              <a:gd name="connsiteX6" fmla="*/ 798172 w 1009120"/>
              <a:gd name="connsiteY6" fmla="*/ 37504 h 1165623"/>
              <a:gd name="connsiteX7" fmla="*/ 271122 w 1009120"/>
              <a:gd name="connsiteY7" fmla="*/ 54966 h 1165623"/>
              <a:gd name="connsiteX8" fmla="*/ 32997 w 1009120"/>
              <a:gd name="connsiteY8" fmla="*/ 545503 h 1165623"/>
              <a:gd name="connsiteX0" fmla="*/ 27071 w 1041294"/>
              <a:gd name="connsiteY0" fmla="*/ 518458 h 1163978"/>
              <a:gd name="connsiteX1" fmla="*/ 420771 w 1041294"/>
              <a:gd name="connsiteY1" fmla="*/ 234296 h 1163978"/>
              <a:gd name="connsiteX2" fmla="*/ 808121 w 1041294"/>
              <a:gd name="connsiteY2" fmla="*/ 313671 h 1163978"/>
              <a:gd name="connsiteX3" fmla="*/ 830346 w 1041294"/>
              <a:gd name="connsiteY3" fmla="*/ 1064559 h 1163978"/>
              <a:gd name="connsiteX4" fmla="*/ 982746 w 1041294"/>
              <a:gd name="connsiteY4" fmla="*/ 1070909 h 1163978"/>
              <a:gd name="connsiteX5" fmla="*/ 1033546 w 1041294"/>
              <a:gd name="connsiteY5" fmla="*/ 283509 h 1163978"/>
              <a:gd name="connsiteX6" fmla="*/ 830346 w 1041294"/>
              <a:gd name="connsiteY6" fmla="*/ 35859 h 1163978"/>
              <a:gd name="connsiteX7" fmla="*/ 303296 w 1041294"/>
              <a:gd name="connsiteY7" fmla="*/ 53321 h 1163978"/>
              <a:gd name="connsiteX8" fmla="*/ 27071 w 1041294"/>
              <a:gd name="connsiteY8" fmla="*/ 518458 h 1163978"/>
              <a:gd name="connsiteX0" fmla="*/ 27071 w 1041294"/>
              <a:gd name="connsiteY0" fmla="*/ 518458 h 1163978"/>
              <a:gd name="connsiteX1" fmla="*/ 128627 w 1041294"/>
              <a:gd name="connsiteY1" fmla="*/ 481207 h 1163978"/>
              <a:gd name="connsiteX2" fmla="*/ 420771 w 1041294"/>
              <a:gd name="connsiteY2" fmla="*/ 234296 h 1163978"/>
              <a:gd name="connsiteX3" fmla="*/ 808121 w 1041294"/>
              <a:gd name="connsiteY3" fmla="*/ 313671 h 1163978"/>
              <a:gd name="connsiteX4" fmla="*/ 830346 w 1041294"/>
              <a:gd name="connsiteY4" fmla="*/ 1064559 h 1163978"/>
              <a:gd name="connsiteX5" fmla="*/ 982746 w 1041294"/>
              <a:gd name="connsiteY5" fmla="*/ 1070909 h 1163978"/>
              <a:gd name="connsiteX6" fmla="*/ 1033546 w 1041294"/>
              <a:gd name="connsiteY6" fmla="*/ 283509 h 1163978"/>
              <a:gd name="connsiteX7" fmla="*/ 830346 w 1041294"/>
              <a:gd name="connsiteY7" fmla="*/ 35859 h 1163978"/>
              <a:gd name="connsiteX8" fmla="*/ 303296 w 1041294"/>
              <a:gd name="connsiteY8" fmla="*/ 53321 h 1163978"/>
              <a:gd name="connsiteX9" fmla="*/ 27071 w 1041294"/>
              <a:gd name="connsiteY9" fmla="*/ 518458 h 1163978"/>
              <a:gd name="connsiteX0" fmla="*/ 4966 w 1019189"/>
              <a:gd name="connsiteY0" fmla="*/ 518458 h 1163978"/>
              <a:gd name="connsiteX1" fmla="*/ 125572 w 1019189"/>
              <a:gd name="connsiteY1" fmla="*/ 509782 h 1163978"/>
              <a:gd name="connsiteX2" fmla="*/ 398666 w 1019189"/>
              <a:gd name="connsiteY2" fmla="*/ 234296 h 1163978"/>
              <a:gd name="connsiteX3" fmla="*/ 786016 w 1019189"/>
              <a:gd name="connsiteY3" fmla="*/ 313671 h 1163978"/>
              <a:gd name="connsiteX4" fmla="*/ 808241 w 1019189"/>
              <a:gd name="connsiteY4" fmla="*/ 1064559 h 1163978"/>
              <a:gd name="connsiteX5" fmla="*/ 960641 w 1019189"/>
              <a:gd name="connsiteY5" fmla="*/ 1070909 h 1163978"/>
              <a:gd name="connsiteX6" fmla="*/ 1011441 w 1019189"/>
              <a:gd name="connsiteY6" fmla="*/ 283509 h 1163978"/>
              <a:gd name="connsiteX7" fmla="*/ 808241 w 1019189"/>
              <a:gd name="connsiteY7" fmla="*/ 35859 h 1163978"/>
              <a:gd name="connsiteX8" fmla="*/ 281191 w 1019189"/>
              <a:gd name="connsiteY8" fmla="*/ 53321 h 1163978"/>
              <a:gd name="connsiteX9" fmla="*/ 4966 w 1019189"/>
              <a:gd name="connsiteY9" fmla="*/ 518458 h 1163978"/>
              <a:gd name="connsiteX0" fmla="*/ 2845 w 1017068"/>
              <a:gd name="connsiteY0" fmla="*/ 518458 h 1163978"/>
              <a:gd name="connsiteX1" fmla="*/ 123451 w 1017068"/>
              <a:gd name="connsiteY1" fmla="*/ 509782 h 1163978"/>
              <a:gd name="connsiteX2" fmla="*/ 396545 w 1017068"/>
              <a:gd name="connsiteY2" fmla="*/ 234296 h 1163978"/>
              <a:gd name="connsiteX3" fmla="*/ 783895 w 1017068"/>
              <a:gd name="connsiteY3" fmla="*/ 313671 h 1163978"/>
              <a:gd name="connsiteX4" fmla="*/ 806120 w 1017068"/>
              <a:gd name="connsiteY4" fmla="*/ 1064559 h 1163978"/>
              <a:gd name="connsiteX5" fmla="*/ 958520 w 1017068"/>
              <a:gd name="connsiteY5" fmla="*/ 1070909 h 1163978"/>
              <a:gd name="connsiteX6" fmla="*/ 1009320 w 1017068"/>
              <a:gd name="connsiteY6" fmla="*/ 283509 h 1163978"/>
              <a:gd name="connsiteX7" fmla="*/ 806120 w 1017068"/>
              <a:gd name="connsiteY7" fmla="*/ 35859 h 1163978"/>
              <a:gd name="connsiteX8" fmla="*/ 279070 w 1017068"/>
              <a:gd name="connsiteY8" fmla="*/ 53321 h 1163978"/>
              <a:gd name="connsiteX9" fmla="*/ 2845 w 1017068"/>
              <a:gd name="connsiteY9" fmla="*/ 518458 h 1163978"/>
              <a:gd name="connsiteX0" fmla="*/ 2845 w 1017068"/>
              <a:gd name="connsiteY0" fmla="*/ 518458 h 1163978"/>
              <a:gd name="connsiteX1" fmla="*/ 123451 w 1017068"/>
              <a:gd name="connsiteY1" fmla="*/ 509782 h 1163978"/>
              <a:gd name="connsiteX2" fmla="*/ 396545 w 1017068"/>
              <a:gd name="connsiteY2" fmla="*/ 234296 h 1163978"/>
              <a:gd name="connsiteX3" fmla="*/ 783895 w 1017068"/>
              <a:gd name="connsiteY3" fmla="*/ 313671 h 1163978"/>
              <a:gd name="connsiteX4" fmla="*/ 806120 w 1017068"/>
              <a:gd name="connsiteY4" fmla="*/ 1064559 h 1163978"/>
              <a:gd name="connsiteX5" fmla="*/ 958520 w 1017068"/>
              <a:gd name="connsiteY5" fmla="*/ 1070909 h 1163978"/>
              <a:gd name="connsiteX6" fmla="*/ 1009320 w 1017068"/>
              <a:gd name="connsiteY6" fmla="*/ 283509 h 1163978"/>
              <a:gd name="connsiteX7" fmla="*/ 806120 w 1017068"/>
              <a:gd name="connsiteY7" fmla="*/ 35859 h 1163978"/>
              <a:gd name="connsiteX8" fmla="*/ 279070 w 1017068"/>
              <a:gd name="connsiteY8" fmla="*/ 53321 h 1163978"/>
              <a:gd name="connsiteX9" fmla="*/ 2845 w 1017068"/>
              <a:gd name="connsiteY9" fmla="*/ 518458 h 1163978"/>
              <a:gd name="connsiteX0" fmla="*/ 2307 w 1057805"/>
              <a:gd name="connsiteY0" fmla="*/ 491437 h 1162357"/>
              <a:gd name="connsiteX1" fmla="*/ 164188 w 1057805"/>
              <a:gd name="connsiteY1" fmla="*/ 508161 h 1162357"/>
              <a:gd name="connsiteX2" fmla="*/ 437282 w 1057805"/>
              <a:gd name="connsiteY2" fmla="*/ 232675 h 1162357"/>
              <a:gd name="connsiteX3" fmla="*/ 824632 w 1057805"/>
              <a:gd name="connsiteY3" fmla="*/ 312050 h 1162357"/>
              <a:gd name="connsiteX4" fmla="*/ 846857 w 1057805"/>
              <a:gd name="connsiteY4" fmla="*/ 1062938 h 1162357"/>
              <a:gd name="connsiteX5" fmla="*/ 999257 w 1057805"/>
              <a:gd name="connsiteY5" fmla="*/ 1069288 h 1162357"/>
              <a:gd name="connsiteX6" fmla="*/ 1050057 w 1057805"/>
              <a:gd name="connsiteY6" fmla="*/ 281888 h 1162357"/>
              <a:gd name="connsiteX7" fmla="*/ 846857 w 1057805"/>
              <a:gd name="connsiteY7" fmla="*/ 34238 h 1162357"/>
              <a:gd name="connsiteX8" fmla="*/ 319807 w 1057805"/>
              <a:gd name="connsiteY8" fmla="*/ 51700 h 1162357"/>
              <a:gd name="connsiteX9" fmla="*/ 2307 w 1057805"/>
              <a:gd name="connsiteY9" fmla="*/ 491437 h 1162357"/>
              <a:gd name="connsiteX0" fmla="*/ 1226 w 1056724"/>
              <a:gd name="connsiteY0" fmla="*/ 491437 h 1162357"/>
              <a:gd name="connsiteX1" fmla="*/ 163107 w 1056724"/>
              <a:gd name="connsiteY1" fmla="*/ 508161 h 1162357"/>
              <a:gd name="connsiteX2" fmla="*/ 436201 w 1056724"/>
              <a:gd name="connsiteY2" fmla="*/ 232675 h 1162357"/>
              <a:gd name="connsiteX3" fmla="*/ 823551 w 1056724"/>
              <a:gd name="connsiteY3" fmla="*/ 312050 h 1162357"/>
              <a:gd name="connsiteX4" fmla="*/ 845776 w 1056724"/>
              <a:gd name="connsiteY4" fmla="*/ 1062938 h 1162357"/>
              <a:gd name="connsiteX5" fmla="*/ 998176 w 1056724"/>
              <a:gd name="connsiteY5" fmla="*/ 1069288 h 1162357"/>
              <a:gd name="connsiteX6" fmla="*/ 1048976 w 1056724"/>
              <a:gd name="connsiteY6" fmla="*/ 281888 h 1162357"/>
              <a:gd name="connsiteX7" fmla="*/ 845776 w 1056724"/>
              <a:gd name="connsiteY7" fmla="*/ 34238 h 1162357"/>
              <a:gd name="connsiteX8" fmla="*/ 318726 w 1056724"/>
              <a:gd name="connsiteY8" fmla="*/ 51700 h 1162357"/>
              <a:gd name="connsiteX9" fmla="*/ 1226 w 1056724"/>
              <a:gd name="connsiteY9" fmla="*/ 491437 h 1162357"/>
              <a:gd name="connsiteX0" fmla="*/ 2682 w 1058180"/>
              <a:gd name="connsiteY0" fmla="*/ 491437 h 1162357"/>
              <a:gd name="connsiteX1" fmla="*/ 155038 w 1058180"/>
              <a:gd name="connsiteY1" fmla="*/ 524036 h 1162357"/>
              <a:gd name="connsiteX2" fmla="*/ 437657 w 1058180"/>
              <a:gd name="connsiteY2" fmla="*/ 232675 h 1162357"/>
              <a:gd name="connsiteX3" fmla="*/ 825007 w 1058180"/>
              <a:gd name="connsiteY3" fmla="*/ 312050 h 1162357"/>
              <a:gd name="connsiteX4" fmla="*/ 847232 w 1058180"/>
              <a:gd name="connsiteY4" fmla="*/ 1062938 h 1162357"/>
              <a:gd name="connsiteX5" fmla="*/ 999632 w 1058180"/>
              <a:gd name="connsiteY5" fmla="*/ 1069288 h 1162357"/>
              <a:gd name="connsiteX6" fmla="*/ 1050432 w 1058180"/>
              <a:gd name="connsiteY6" fmla="*/ 281888 h 1162357"/>
              <a:gd name="connsiteX7" fmla="*/ 847232 w 1058180"/>
              <a:gd name="connsiteY7" fmla="*/ 34238 h 1162357"/>
              <a:gd name="connsiteX8" fmla="*/ 320182 w 1058180"/>
              <a:gd name="connsiteY8" fmla="*/ 51700 h 1162357"/>
              <a:gd name="connsiteX9" fmla="*/ 2682 w 1058180"/>
              <a:gd name="connsiteY9" fmla="*/ 491437 h 1162357"/>
              <a:gd name="connsiteX0" fmla="*/ 3677 w 1002025"/>
              <a:gd name="connsiteY0" fmla="*/ 450959 h 1159979"/>
              <a:gd name="connsiteX1" fmla="*/ 98883 w 1002025"/>
              <a:gd name="connsiteY1" fmla="*/ 521658 h 1159979"/>
              <a:gd name="connsiteX2" fmla="*/ 381502 w 1002025"/>
              <a:gd name="connsiteY2" fmla="*/ 230297 h 1159979"/>
              <a:gd name="connsiteX3" fmla="*/ 768852 w 1002025"/>
              <a:gd name="connsiteY3" fmla="*/ 309672 h 1159979"/>
              <a:gd name="connsiteX4" fmla="*/ 791077 w 1002025"/>
              <a:gd name="connsiteY4" fmla="*/ 1060560 h 1159979"/>
              <a:gd name="connsiteX5" fmla="*/ 943477 w 1002025"/>
              <a:gd name="connsiteY5" fmla="*/ 1066910 h 1159979"/>
              <a:gd name="connsiteX6" fmla="*/ 994277 w 1002025"/>
              <a:gd name="connsiteY6" fmla="*/ 279510 h 1159979"/>
              <a:gd name="connsiteX7" fmla="*/ 791077 w 1002025"/>
              <a:gd name="connsiteY7" fmla="*/ 31860 h 1159979"/>
              <a:gd name="connsiteX8" fmla="*/ 264027 w 1002025"/>
              <a:gd name="connsiteY8" fmla="*/ 49322 h 1159979"/>
              <a:gd name="connsiteX9" fmla="*/ 3677 w 1002025"/>
              <a:gd name="connsiteY9" fmla="*/ 450959 h 1159979"/>
              <a:gd name="connsiteX0" fmla="*/ 3302 w 1001650"/>
              <a:gd name="connsiteY0" fmla="*/ 450959 h 1159979"/>
              <a:gd name="connsiteX1" fmla="*/ 104858 w 1001650"/>
              <a:gd name="connsiteY1" fmla="*/ 524833 h 1159979"/>
              <a:gd name="connsiteX2" fmla="*/ 381127 w 1001650"/>
              <a:gd name="connsiteY2" fmla="*/ 230297 h 1159979"/>
              <a:gd name="connsiteX3" fmla="*/ 768477 w 1001650"/>
              <a:gd name="connsiteY3" fmla="*/ 309672 h 1159979"/>
              <a:gd name="connsiteX4" fmla="*/ 790702 w 1001650"/>
              <a:gd name="connsiteY4" fmla="*/ 1060560 h 1159979"/>
              <a:gd name="connsiteX5" fmla="*/ 943102 w 1001650"/>
              <a:gd name="connsiteY5" fmla="*/ 1066910 h 1159979"/>
              <a:gd name="connsiteX6" fmla="*/ 993902 w 1001650"/>
              <a:gd name="connsiteY6" fmla="*/ 279510 h 1159979"/>
              <a:gd name="connsiteX7" fmla="*/ 790702 w 1001650"/>
              <a:gd name="connsiteY7" fmla="*/ 31860 h 1159979"/>
              <a:gd name="connsiteX8" fmla="*/ 263652 w 1001650"/>
              <a:gd name="connsiteY8" fmla="*/ 49322 h 1159979"/>
              <a:gd name="connsiteX9" fmla="*/ 3302 w 1001650"/>
              <a:gd name="connsiteY9" fmla="*/ 450959 h 1159979"/>
              <a:gd name="connsiteX0" fmla="*/ 2458 w 1000806"/>
              <a:gd name="connsiteY0" fmla="*/ 450959 h 1159979"/>
              <a:gd name="connsiteX1" fmla="*/ 120683 w 1000806"/>
              <a:gd name="connsiteY1" fmla="*/ 520071 h 1159979"/>
              <a:gd name="connsiteX2" fmla="*/ 380283 w 1000806"/>
              <a:gd name="connsiteY2" fmla="*/ 230297 h 1159979"/>
              <a:gd name="connsiteX3" fmla="*/ 767633 w 1000806"/>
              <a:gd name="connsiteY3" fmla="*/ 309672 h 1159979"/>
              <a:gd name="connsiteX4" fmla="*/ 789858 w 1000806"/>
              <a:gd name="connsiteY4" fmla="*/ 1060560 h 1159979"/>
              <a:gd name="connsiteX5" fmla="*/ 942258 w 1000806"/>
              <a:gd name="connsiteY5" fmla="*/ 1066910 h 1159979"/>
              <a:gd name="connsiteX6" fmla="*/ 993058 w 1000806"/>
              <a:gd name="connsiteY6" fmla="*/ 279510 h 1159979"/>
              <a:gd name="connsiteX7" fmla="*/ 789858 w 1000806"/>
              <a:gd name="connsiteY7" fmla="*/ 31860 h 1159979"/>
              <a:gd name="connsiteX8" fmla="*/ 262808 w 1000806"/>
              <a:gd name="connsiteY8" fmla="*/ 49322 h 1159979"/>
              <a:gd name="connsiteX9" fmla="*/ 2458 w 1000806"/>
              <a:gd name="connsiteY9" fmla="*/ 450959 h 1159979"/>
              <a:gd name="connsiteX0" fmla="*/ 3725 w 1002073"/>
              <a:gd name="connsiteY0" fmla="*/ 450959 h 1159979"/>
              <a:gd name="connsiteX1" fmla="*/ 98138 w 1002073"/>
              <a:gd name="connsiteY1" fmla="*/ 534359 h 1159979"/>
              <a:gd name="connsiteX2" fmla="*/ 381550 w 1002073"/>
              <a:gd name="connsiteY2" fmla="*/ 230297 h 1159979"/>
              <a:gd name="connsiteX3" fmla="*/ 768900 w 1002073"/>
              <a:gd name="connsiteY3" fmla="*/ 309672 h 1159979"/>
              <a:gd name="connsiteX4" fmla="*/ 791125 w 1002073"/>
              <a:gd name="connsiteY4" fmla="*/ 1060560 h 1159979"/>
              <a:gd name="connsiteX5" fmla="*/ 943525 w 1002073"/>
              <a:gd name="connsiteY5" fmla="*/ 1066910 h 1159979"/>
              <a:gd name="connsiteX6" fmla="*/ 994325 w 1002073"/>
              <a:gd name="connsiteY6" fmla="*/ 279510 h 1159979"/>
              <a:gd name="connsiteX7" fmla="*/ 791125 w 1002073"/>
              <a:gd name="connsiteY7" fmla="*/ 31860 h 1159979"/>
              <a:gd name="connsiteX8" fmla="*/ 264075 w 1002073"/>
              <a:gd name="connsiteY8" fmla="*/ 49322 h 1159979"/>
              <a:gd name="connsiteX9" fmla="*/ 3725 w 1002073"/>
              <a:gd name="connsiteY9" fmla="*/ 450959 h 1159979"/>
              <a:gd name="connsiteX0" fmla="*/ 3725 w 1002073"/>
              <a:gd name="connsiteY0" fmla="*/ 450959 h 1159979"/>
              <a:gd name="connsiteX1" fmla="*/ 98138 w 1002073"/>
              <a:gd name="connsiteY1" fmla="*/ 534359 h 1159979"/>
              <a:gd name="connsiteX2" fmla="*/ 381550 w 1002073"/>
              <a:gd name="connsiteY2" fmla="*/ 230297 h 1159979"/>
              <a:gd name="connsiteX3" fmla="*/ 768900 w 1002073"/>
              <a:gd name="connsiteY3" fmla="*/ 309672 h 1159979"/>
              <a:gd name="connsiteX4" fmla="*/ 791125 w 1002073"/>
              <a:gd name="connsiteY4" fmla="*/ 1060560 h 1159979"/>
              <a:gd name="connsiteX5" fmla="*/ 943525 w 1002073"/>
              <a:gd name="connsiteY5" fmla="*/ 1066910 h 1159979"/>
              <a:gd name="connsiteX6" fmla="*/ 994325 w 1002073"/>
              <a:gd name="connsiteY6" fmla="*/ 279510 h 1159979"/>
              <a:gd name="connsiteX7" fmla="*/ 791125 w 1002073"/>
              <a:gd name="connsiteY7" fmla="*/ 31860 h 1159979"/>
              <a:gd name="connsiteX8" fmla="*/ 264075 w 1002073"/>
              <a:gd name="connsiteY8" fmla="*/ 49322 h 1159979"/>
              <a:gd name="connsiteX9" fmla="*/ 3725 w 1002073"/>
              <a:gd name="connsiteY9" fmla="*/ 450959 h 1159979"/>
              <a:gd name="connsiteX0" fmla="*/ 5180 w 1003528"/>
              <a:gd name="connsiteY0" fmla="*/ 450959 h 1159979"/>
              <a:gd name="connsiteX1" fmla="*/ 99593 w 1003528"/>
              <a:gd name="connsiteY1" fmla="*/ 534359 h 1159979"/>
              <a:gd name="connsiteX2" fmla="*/ 383005 w 1003528"/>
              <a:gd name="connsiteY2" fmla="*/ 230297 h 1159979"/>
              <a:gd name="connsiteX3" fmla="*/ 770355 w 1003528"/>
              <a:gd name="connsiteY3" fmla="*/ 309672 h 1159979"/>
              <a:gd name="connsiteX4" fmla="*/ 792580 w 1003528"/>
              <a:gd name="connsiteY4" fmla="*/ 1060560 h 1159979"/>
              <a:gd name="connsiteX5" fmla="*/ 944980 w 1003528"/>
              <a:gd name="connsiteY5" fmla="*/ 1066910 h 1159979"/>
              <a:gd name="connsiteX6" fmla="*/ 995780 w 1003528"/>
              <a:gd name="connsiteY6" fmla="*/ 279510 h 1159979"/>
              <a:gd name="connsiteX7" fmla="*/ 792580 w 1003528"/>
              <a:gd name="connsiteY7" fmla="*/ 31860 h 1159979"/>
              <a:gd name="connsiteX8" fmla="*/ 265530 w 1003528"/>
              <a:gd name="connsiteY8" fmla="*/ 49322 h 1159979"/>
              <a:gd name="connsiteX9" fmla="*/ 5180 w 1003528"/>
              <a:gd name="connsiteY9" fmla="*/ 450959 h 1159979"/>
              <a:gd name="connsiteX0" fmla="*/ 3793 w 1002141"/>
              <a:gd name="connsiteY0" fmla="*/ 450959 h 1159979"/>
              <a:gd name="connsiteX1" fmla="*/ 114874 w 1002141"/>
              <a:gd name="connsiteY1" fmla="*/ 512928 h 1159979"/>
              <a:gd name="connsiteX2" fmla="*/ 381618 w 1002141"/>
              <a:gd name="connsiteY2" fmla="*/ 230297 h 1159979"/>
              <a:gd name="connsiteX3" fmla="*/ 768968 w 1002141"/>
              <a:gd name="connsiteY3" fmla="*/ 309672 h 1159979"/>
              <a:gd name="connsiteX4" fmla="*/ 791193 w 1002141"/>
              <a:gd name="connsiteY4" fmla="*/ 1060560 h 1159979"/>
              <a:gd name="connsiteX5" fmla="*/ 943593 w 1002141"/>
              <a:gd name="connsiteY5" fmla="*/ 1066910 h 1159979"/>
              <a:gd name="connsiteX6" fmla="*/ 994393 w 1002141"/>
              <a:gd name="connsiteY6" fmla="*/ 279510 h 1159979"/>
              <a:gd name="connsiteX7" fmla="*/ 791193 w 1002141"/>
              <a:gd name="connsiteY7" fmla="*/ 31860 h 1159979"/>
              <a:gd name="connsiteX8" fmla="*/ 264143 w 1002141"/>
              <a:gd name="connsiteY8" fmla="*/ 49322 h 1159979"/>
              <a:gd name="connsiteX9" fmla="*/ 3793 w 1002141"/>
              <a:gd name="connsiteY9" fmla="*/ 450959 h 115997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1002141" h="1159979">
                <a:moveTo>
                  <a:pt x="3793" y="450959"/>
                </a:moveTo>
                <a:cubicBezTo>
                  <a:pt x="-21085" y="528227"/>
                  <a:pt x="83389" y="540444"/>
                  <a:pt x="114874" y="512928"/>
                </a:cubicBezTo>
                <a:cubicBezTo>
                  <a:pt x="116991" y="516368"/>
                  <a:pt x="272602" y="264173"/>
                  <a:pt x="381618" y="230297"/>
                </a:cubicBezTo>
                <a:cubicBezTo>
                  <a:pt x="490634" y="196421"/>
                  <a:pt x="700706" y="171295"/>
                  <a:pt x="768968" y="309672"/>
                </a:cubicBezTo>
                <a:cubicBezTo>
                  <a:pt x="837230" y="448049"/>
                  <a:pt x="762089" y="934354"/>
                  <a:pt x="791193" y="1060560"/>
                </a:cubicBezTo>
                <a:cubicBezTo>
                  <a:pt x="820297" y="1186766"/>
                  <a:pt x="909726" y="1197085"/>
                  <a:pt x="943593" y="1066910"/>
                </a:cubicBezTo>
                <a:cubicBezTo>
                  <a:pt x="977460" y="936735"/>
                  <a:pt x="1019793" y="452018"/>
                  <a:pt x="994393" y="279510"/>
                </a:cubicBezTo>
                <a:cubicBezTo>
                  <a:pt x="968993" y="107002"/>
                  <a:pt x="912901" y="70225"/>
                  <a:pt x="791193" y="31860"/>
                </a:cubicBezTo>
                <a:cubicBezTo>
                  <a:pt x="669485" y="-6505"/>
                  <a:pt x="395376" y="-20528"/>
                  <a:pt x="264143" y="49322"/>
                </a:cubicBezTo>
                <a:cubicBezTo>
                  <a:pt x="132910" y="119172"/>
                  <a:pt x="28671" y="373691"/>
                  <a:pt x="3793" y="450959"/>
                </a:cubicBezTo>
                <a:close/>
              </a:path>
            </a:pathLst>
          </a:custGeom>
          <a:solidFill>
            <a:srgbClr val="002060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grpSp>
        <p:nvGrpSpPr>
          <p:cNvPr id="2" name="Groupe 1">
            <a:extLst>
              <a:ext uri="{FF2B5EF4-FFF2-40B4-BE49-F238E27FC236}">
                <a16:creationId xmlns:a16="http://schemas.microsoft.com/office/drawing/2014/main" xmlns="" id="{440CC04B-F783-4036-A4B3-2A32FF907CA6}"/>
              </a:ext>
            </a:extLst>
          </p:cNvPr>
          <p:cNvGrpSpPr/>
          <p:nvPr/>
        </p:nvGrpSpPr>
        <p:grpSpPr>
          <a:xfrm>
            <a:off x="5916902" y="1137882"/>
            <a:ext cx="431770" cy="978503"/>
            <a:chOff x="5895742" y="1125764"/>
            <a:chExt cx="431770" cy="978503"/>
          </a:xfrm>
        </p:grpSpPr>
        <p:sp>
          <p:nvSpPr>
            <p:cNvPr id="79" name="Forme libre : forme 78">
              <a:extLst>
                <a:ext uri="{FF2B5EF4-FFF2-40B4-BE49-F238E27FC236}">
                  <a16:creationId xmlns:a16="http://schemas.microsoft.com/office/drawing/2014/main" xmlns="" id="{9B802E9C-90E5-4D61-858A-A1484040F9ED}"/>
                </a:ext>
              </a:extLst>
            </p:cNvPr>
            <p:cNvSpPr/>
            <p:nvPr/>
          </p:nvSpPr>
          <p:spPr>
            <a:xfrm rot="2325573" flipH="1">
              <a:off x="6037485" y="1125764"/>
              <a:ext cx="279809" cy="517683"/>
            </a:xfrm>
            <a:custGeom>
              <a:avLst/>
              <a:gdLst>
                <a:gd name="connsiteX0" fmla="*/ 62304 w 379300"/>
                <a:gd name="connsiteY0" fmla="*/ 785593 h 805215"/>
                <a:gd name="connsiteX1" fmla="*/ 57542 w 379300"/>
                <a:gd name="connsiteY1" fmla="*/ 566518 h 805215"/>
                <a:gd name="connsiteX2" fmla="*/ 9917 w 379300"/>
                <a:gd name="connsiteY2" fmla="*/ 185518 h 805215"/>
                <a:gd name="connsiteX3" fmla="*/ 276617 w 379300"/>
                <a:gd name="connsiteY3" fmla="*/ 4543 h 805215"/>
                <a:gd name="connsiteX4" fmla="*/ 348054 w 379300"/>
                <a:gd name="connsiteY4" fmla="*/ 71218 h 805215"/>
                <a:gd name="connsiteX5" fmla="*/ 333767 w 379300"/>
                <a:gd name="connsiteY5" fmla="*/ 252193 h 805215"/>
                <a:gd name="connsiteX6" fmla="*/ 376629 w 379300"/>
                <a:gd name="connsiteY6" fmla="*/ 447456 h 805215"/>
                <a:gd name="connsiteX7" fmla="*/ 371867 w 379300"/>
                <a:gd name="connsiteY7" fmla="*/ 614143 h 805215"/>
                <a:gd name="connsiteX8" fmla="*/ 348054 w 379300"/>
                <a:gd name="connsiteY8" fmla="*/ 699868 h 805215"/>
                <a:gd name="connsiteX9" fmla="*/ 324242 w 379300"/>
                <a:gd name="connsiteY9" fmla="*/ 790356 h 805215"/>
                <a:gd name="connsiteX10" fmla="*/ 62304 w 379300"/>
                <a:gd name="connsiteY10" fmla="*/ 785593 h 805215"/>
                <a:gd name="connsiteX0" fmla="*/ 62304 w 378253"/>
                <a:gd name="connsiteY0" fmla="*/ 789101 h 808723"/>
                <a:gd name="connsiteX1" fmla="*/ 57542 w 378253"/>
                <a:gd name="connsiteY1" fmla="*/ 570026 h 808723"/>
                <a:gd name="connsiteX2" fmla="*/ 9917 w 378253"/>
                <a:gd name="connsiteY2" fmla="*/ 189026 h 808723"/>
                <a:gd name="connsiteX3" fmla="*/ 276617 w 378253"/>
                <a:gd name="connsiteY3" fmla="*/ 8051 h 808723"/>
                <a:gd name="connsiteX4" fmla="*/ 348054 w 378253"/>
                <a:gd name="connsiteY4" fmla="*/ 74726 h 808723"/>
                <a:gd name="connsiteX5" fmla="*/ 376629 w 378253"/>
                <a:gd name="connsiteY5" fmla="*/ 450964 h 808723"/>
                <a:gd name="connsiteX6" fmla="*/ 371867 w 378253"/>
                <a:gd name="connsiteY6" fmla="*/ 617651 h 808723"/>
                <a:gd name="connsiteX7" fmla="*/ 348054 w 378253"/>
                <a:gd name="connsiteY7" fmla="*/ 703376 h 808723"/>
                <a:gd name="connsiteX8" fmla="*/ 324242 w 378253"/>
                <a:gd name="connsiteY8" fmla="*/ 793864 h 808723"/>
                <a:gd name="connsiteX9" fmla="*/ 62304 w 378253"/>
                <a:gd name="connsiteY9" fmla="*/ 789101 h 808723"/>
                <a:gd name="connsiteX0" fmla="*/ 62304 w 379182"/>
                <a:gd name="connsiteY0" fmla="*/ 789101 h 816188"/>
                <a:gd name="connsiteX1" fmla="*/ 57542 w 379182"/>
                <a:gd name="connsiteY1" fmla="*/ 570026 h 816188"/>
                <a:gd name="connsiteX2" fmla="*/ 9917 w 379182"/>
                <a:gd name="connsiteY2" fmla="*/ 189026 h 816188"/>
                <a:gd name="connsiteX3" fmla="*/ 276617 w 379182"/>
                <a:gd name="connsiteY3" fmla="*/ 8051 h 816188"/>
                <a:gd name="connsiteX4" fmla="*/ 348054 w 379182"/>
                <a:gd name="connsiteY4" fmla="*/ 74726 h 816188"/>
                <a:gd name="connsiteX5" fmla="*/ 376629 w 379182"/>
                <a:gd name="connsiteY5" fmla="*/ 450964 h 816188"/>
                <a:gd name="connsiteX6" fmla="*/ 371867 w 379182"/>
                <a:gd name="connsiteY6" fmla="*/ 617651 h 816188"/>
                <a:gd name="connsiteX7" fmla="*/ 324242 w 379182"/>
                <a:gd name="connsiteY7" fmla="*/ 793864 h 816188"/>
                <a:gd name="connsiteX8" fmla="*/ 62304 w 379182"/>
                <a:gd name="connsiteY8" fmla="*/ 789101 h 8161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379182" h="816188">
                  <a:moveTo>
                    <a:pt x="62304" y="789101"/>
                  </a:moveTo>
                  <a:cubicBezTo>
                    <a:pt x="17854" y="751795"/>
                    <a:pt x="66273" y="670038"/>
                    <a:pt x="57542" y="570026"/>
                  </a:cubicBezTo>
                  <a:cubicBezTo>
                    <a:pt x="48811" y="470013"/>
                    <a:pt x="-26595" y="282688"/>
                    <a:pt x="9917" y="189026"/>
                  </a:cubicBezTo>
                  <a:cubicBezTo>
                    <a:pt x="46429" y="95364"/>
                    <a:pt x="220261" y="27101"/>
                    <a:pt x="276617" y="8051"/>
                  </a:cubicBezTo>
                  <a:cubicBezTo>
                    <a:pt x="332973" y="-10999"/>
                    <a:pt x="331385" y="907"/>
                    <a:pt x="348054" y="74726"/>
                  </a:cubicBezTo>
                  <a:cubicBezTo>
                    <a:pt x="364723" y="148545"/>
                    <a:pt x="372660" y="360477"/>
                    <a:pt x="376629" y="450964"/>
                  </a:cubicBezTo>
                  <a:cubicBezTo>
                    <a:pt x="380598" y="541451"/>
                    <a:pt x="380598" y="560501"/>
                    <a:pt x="371867" y="617651"/>
                  </a:cubicBezTo>
                  <a:cubicBezTo>
                    <a:pt x="363136" y="674801"/>
                    <a:pt x="375836" y="765289"/>
                    <a:pt x="324242" y="793864"/>
                  </a:cubicBezTo>
                  <a:cubicBezTo>
                    <a:pt x="272648" y="822439"/>
                    <a:pt x="106754" y="826407"/>
                    <a:pt x="62304" y="789101"/>
                  </a:cubicBezTo>
                  <a:close/>
                </a:path>
              </a:pathLst>
            </a:custGeom>
            <a:solidFill>
              <a:srgbClr val="A6A6A6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78" name="Forme libre : forme 77">
              <a:extLst>
                <a:ext uri="{FF2B5EF4-FFF2-40B4-BE49-F238E27FC236}">
                  <a16:creationId xmlns:a16="http://schemas.microsoft.com/office/drawing/2014/main" xmlns="" id="{126F3687-54ED-4BF1-BB62-EEDFC4B24EF7}"/>
                </a:ext>
              </a:extLst>
            </p:cNvPr>
            <p:cNvSpPr/>
            <p:nvPr/>
          </p:nvSpPr>
          <p:spPr>
            <a:xfrm rot="339379" flipH="1">
              <a:off x="5895742" y="1500975"/>
              <a:ext cx="431770" cy="603292"/>
            </a:xfrm>
            <a:custGeom>
              <a:avLst/>
              <a:gdLst>
                <a:gd name="connsiteX0" fmla="*/ 106968 w 592856"/>
                <a:gd name="connsiteY0" fmla="*/ 650916 h 685860"/>
                <a:gd name="connsiteX1" fmla="*/ 249843 w 592856"/>
                <a:gd name="connsiteY1" fmla="*/ 536616 h 685860"/>
                <a:gd name="connsiteX2" fmla="*/ 364143 w 592856"/>
                <a:gd name="connsiteY2" fmla="*/ 417553 h 685860"/>
                <a:gd name="connsiteX3" fmla="*/ 592743 w 592856"/>
                <a:gd name="connsiteY3" fmla="*/ 31791 h 685860"/>
                <a:gd name="connsiteX4" fmla="*/ 392718 w 592856"/>
                <a:gd name="connsiteY4" fmla="*/ 27028 h 685860"/>
                <a:gd name="connsiteX5" fmla="*/ 240318 w 592856"/>
                <a:gd name="connsiteY5" fmla="*/ 69891 h 685860"/>
                <a:gd name="connsiteX6" fmla="*/ 54580 w 592856"/>
                <a:gd name="connsiteY6" fmla="*/ 422316 h 685860"/>
                <a:gd name="connsiteX7" fmla="*/ 2193 w 592856"/>
                <a:gd name="connsiteY7" fmla="*/ 669966 h 685860"/>
                <a:gd name="connsiteX8" fmla="*/ 106968 w 592856"/>
                <a:gd name="connsiteY8" fmla="*/ 650916 h 685860"/>
                <a:gd name="connsiteX0" fmla="*/ 106968 w 594286"/>
                <a:gd name="connsiteY0" fmla="*/ 649707 h 684651"/>
                <a:gd name="connsiteX1" fmla="*/ 249843 w 594286"/>
                <a:gd name="connsiteY1" fmla="*/ 535407 h 684651"/>
                <a:gd name="connsiteX2" fmla="*/ 364143 w 594286"/>
                <a:gd name="connsiteY2" fmla="*/ 416344 h 684651"/>
                <a:gd name="connsiteX3" fmla="*/ 592743 w 594286"/>
                <a:gd name="connsiteY3" fmla="*/ 30582 h 684651"/>
                <a:gd name="connsiteX4" fmla="*/ 240318 w 594286"/>
                <a:gd name="connsiteY4" fmla="*/ 68682 h 684651"/>
                <a:gd name="connsiteX5" fmla="*/ 54580 w 594286"/>
                <a:gd name="connsiteY5" fmla="*/ 421107 h 684651"/>
                <a:gd name="connsiteX6" fmla="*/ 2193 w 594286"/>
                <a:gd name="connsiteY6" fmla="*/ 668757 h 684651"/>
                <a:gd name="connsiteX7" fmla="*/ 106968 w 594286"/>
                <a:gd name="connsiteY7" fmla="*/ 649707 h 68465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594286" h="684651">
                  <a:moveTo>
                    <a:pt x="106968" y="649707"/>
                  </a:moveTo>
                  <a:cubicBezTo>
                    <a:pt x="148243" y="627482"/>
                    <a:pt x="206981" y="574301"/>
                    <a:pt x="249843" y="535407"/>
                  </a:cubicBezTo>
                  <a:cubicBezTo>
                    <a:pt x="292705" y="496513"/>
                    <a:pt x="306993" y="500481"/>
                    <a:pt x="364143" y="416344"/>
                  </a:cubicBezTo>
                  <a:cubicBezTo>
                    <a:pt x="421293" y="332207"/>
                    <a:pt x="613381" y="88526"/>
                    <a:pt x="592743" y="30582"/>
                  </a:cubicBezTo>
                  <a:cubicBezTo>
                    <a:pt x="572106" y="-27362"/>
                    <a:pt x="330012" y="3595"/>
                    <a:pt x="240318" y="68682"/>
                  </a:cubicBezTo>
                  <a:cubicBezTo>
                    <a:pt x="183962" y="134563"/>
                    <a:pt x="94267" y="321095"/>
                    <a:pt x="54580" y="421107"/>
                  </a:cubicBezTo>
                  <a:cubicBezTo>
                    <a:pt x="14893" y="521119"/>
                    <a:pt x="-7332" y="633038"/>
                    <a:pt x="2193" y="668757"/>
                  </a:cubicBezTo>
                  <a:cubicBezTo>
                    <a:pt x="11718" y="704476"/>
                    <a:pt x="65693" y="671932"/>
                    <a:pt x="106968" y="649707"/>
                  </a:cubicBezTo>
                  <a:close/>
                </a:path>
              </a:pathLst>
            </a:custGeom>
            <a:solidFill>
              <a:srgbClr val="A6A6A6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</p:grpSp>
      <p:cxnSp>
        <p:nvCxnSpPr>
          <p:cNvPr id="83" name="Connecteur droit 82">
            <a:extLst>
              <a:ext uri="{FF2B5EF4-FFF2-40B4-BE49-F238E27FC236}">
                <a16:creationId xmlns:a16="http://schemas.microsoft.com/office/drawing/2014/main" xmlns="" id="{956F9881-C562-47DF-8240-5FAC522FA367}"/>
              </a:ext>
            </a:extLst>
          </p:cNvPr>
          <p:cNvCxnSpPr>
            <a:cxnSpLocks/>
          </p:cNvCxnSpPr>
          <p:nvPr/>
        </p:nvCxnSpPr>
        <p:spPr>
          <a:xfrm flipH="1">
            <a:off x="6299515" y="1768929"/>
            <a:ext cx="495976" cy="0"/>
          </a:xfrm>
          <a:prstGeom prst="line">
            <a:avLst/>
          </a:prstGeom>
          <a:ln w="63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4" name="Connecteur droit 83">
            <a:extLst>
              <a:ext uri="{FF2B5EF4-FFF2-40B4-BE49-F238E27FC236}">
                <a16:creationId xmlns:a16="http://schemas.microsoft.com/office/drawing/2014/main" xmlns="" id="{4C317382-5D5C-4904-85F5-C4E3DDDC84DD}"/>
              </a:ext>
            </a:extLst>
          </p:cNvPr>
          <p:cNvCxnSpPr>
            <a:cxnSpLocks/>
          </p:cNvCxnSpPr>
          <p:nvPr/>
        </p:nvCxnSpPr>
        <p:spPr>
          <a:xfrm flipH="1">
            <a:off x="6226283" y="1314860"/>
            <a:ext cx="694268" cy="0"/>
          </a:xfrm>
          <a:prstGeom prst="line">
            <a:avLst/>
          </a:prstGeom>
          <a:ln w="63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5" name="ZoneTexte 84">
            <a:extLst>
              <a:ext uri="{FF2B5EF4-FFF2-40B4-BE49-F238E27FC236}">
                <a16:creationId xmlns:a16="http://schemas.microsoft.com/office/drawing/2014/main" xmlns="" id="{A6EC2B9C-7908-481C-9FFE-D60605030B14}"/>
              </a:ext>
            </a:extLst>
          </p:cNvPr>
          <p:cNvSpPr txBox="1"/>
          <p:nvPr/>
        </p:nvSpPr>
        <p:spPr>
          <a:xfrm>
            <a:off x="6920550" y="1232749"/>
            <a:ext cx="8119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b="1" dirty="0">
                <a:latin typeface="Arial" panose="020B0604020202020204" pitchFamily="34" charset="0"/>
                <a:cs typeface="Arial" panose="020B0604020202020204" pitchFamily="34" charset="0"/>
              </a:rPr>
              <a:t>D2 &amp; D3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6" name="Connecteur droit 85">
            <a:extLst>
              <a:ext uri="{FF2B5EF4-FFF2-40B4-BE49-F238E27FC236}">
                <a16:creationId xmlns:a16="http://schemas.microsoft.com/office/drawing/2014/main" xmlns="" id="{71FB0DC9-C729-49E0-AEC7-51C0AD0BD5F7}"/>
              </a:ext>
            </a:extLst>
          </p:cNvPr>
          <p:cNvCxnSpPr>
            <a:cxnSpLocks/>
          </p:cNvCxnSpPr>
          <p:nvPr/>
        </p:nvCxnSpPr>
        <p:spPr>
          <a:xfrm flipH="1" flipV="1">
            <a:off x="4939240" y="1940811"/>
            <a:ext cx="317231" cy="1"/>
          </a:xfrm>
          <a:prstGeom prst="line">
            <a:avLst/>
          </a:prstGeom>
          <a:ln w="63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7" name="ZoneTexte 86">
            <a:extLst>
              <a:ext uri="{FF2B5EF4-FFF2-40B4-BE49-F238E27FC236}">
                <a16:creationId xmlns:a16="http://schemas.microsoft.com/office/drawing/2014/main" xmlns="" id="{4B61DBCB-A9E8-4532-8402-D113A740AB15}"/>
              </a:ext>
            </a:extLst>
          </p:cNvPr>
          <p:cNvSpPr txBox="1"/>
          <p:nvPr/>
        </p:nvSpPr>
        <p:spPr>
          <a:xfrm>
            <a:off x="4297224" y="1807236"/>
            <a:ext cx="685395" cy="4306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50" b="1" dirty="0">
                <a:latin typeface="Arial" panose="020B0604020202020204" pitchFamily="34" charset="0"/>
                <a:cs typeface="Arial" panose="020B0604020202020204" pitchFamily="34" charset="0"/>
              </a:rPr>
              <a:t>TLR5</a:t>
            </a:r>
          </a:p>
          <a:p>
            <a:pPr algn="r"/>
            <a:r>
              <a:rPr lang="fr-FR" sz="1050" b="1" dirty="0">
                <a:latin typeface="Arial" panose="020B0604020202020204" pitchFamily="34" charset="0"/>
                <a:cs typeface="Arial" panose="020B0604020202020204" pitchFamily="34" charset="0"/>
              </a:rPr>
              <a:t>dimer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ZoneTexte 87">
            <a:extLst>
              <a:ext uri="{FF2B5EF4-FFF2-40B4-BE49-F238E27FC236}">
                <a16:creationId xmlns:a16="http://schemas.microsoft.com/office/drawing/2014/main" xmlns="" id="{4C42FFAF-20FD-4CDE-BFE6-B9F18B66ABF1}"/>
              </a:ext>
            </a:extLst>
          </p:cNvPr>
          <p:cNvSpPr txBox="1"/>
          <p:nvPr/>
        </p:nvSpPr>
        <p:spPr>
          <a:xfrm rot="19946545">
            <a:off x="5190688" y="909562"/>
            <a:ext cx="696949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err="1">
                <a:solidFill>
                  <a:srgbClr val="7F7F7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iC</a:t>
            </a:r>
            <a:endParaRPr lang="fr-FR" sz="1100" b="1" dirty="0">
              <a:solidFill>
                <a:srgbClr val="7F7F7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ZoneTexte 88">
            <a:extLst>
              <a:ext uri="{FF2B5EF4-FFF2-40B4-BE49-F238E27FC236}">
                <a16:creationId xmlns:a16="http://schemas.microsoft.com/office/drawing/2014/main" xmlns="" id="{B0B58FEB-ADBB-4CDC-8475-CFB15A286145}"/>
              </a:ext>
            </a:extLst>
          </p:cNvPr>
          <p:cNvSpPr txBox="1"/>
          <p:nvPr/>
        </p:nvSpPr>
        <p:spPr>
          <a:xfrm rot="1778814">
            <a:off x="6197288" y="1044027"/>
            <a:ext cx="814137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err="1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iC</a:t>
            </a:r>
            <a:endParaRPr lang="fr-FR" sz="1100" b="1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ZoneTexte 90">
            <a:extLst>
              <a:ext uri="{FF2B5EF4-FFF2-40B4-BE49-F238E27FC236}">
                <a16:creationId xmlns:a16="http://schemas.microsoft.com/office/drawing/2014/main" xmlns="" id="{1F8AED14-9869-475C-B50A-2221D94068C3}"/>
              </a:ext>
            </a:extLst>
          </p:cNvPr>
          <p:cNvSpPr txBox="1"/>
          <p:nvPr/>
        </p:nvSpPr>
        <p:spPr>
          <a:xfrm>
            <a:off x="6775744" y="1661740"/>
            <a:ext cx="81192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b="1" dirty="0">
                <a:latin typeface="Arial" panose="020B0604020202020204" pitchFamily="34" charset="0"/>
                <a:cs typeface="Arial" panose="020B0604020202020204" pitchFamily="34" charset="0"/>
              </a:rPr>
              <a:t>D0 &amp; D1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ZoneTexte 92">
            <a:extLst>
              <a:ext uri="{FF2B5EF4-FFF2-40B4-BE49-F238E27FC236}">
                <a16:creationId xmlns:a16="http://schemas.microsoft.com/office/drawing/2014/main" xmlns="" id="{1E9B1B73-1E6D-4B58-8463-9244D8A6DB62}"/>
              </a:ext>
            </a:extLst>
          </p:cNvPr>
          <p:cNvSpPr txBox="1"/>
          <p:nvPr/>
        </p:nvSpPr>
        <p:spPr>
          <a:xfrm>
            <a:off x="4432824" y="2882003"/>
            <a:ext cx="3154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Adapted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 « Structural basis of TLR5-Flagellin Recognition and </a:t>
            </a:r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Signaling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. Yoon </a:t>
            </a:r>
            <a:r>
              <a:rPr lang="fr-FR" sz="900" i="1" dirty="0">
                <a:latin typeface="Arial" panose="020B0604020202020204" pitchFamily="34" charset="0"/>
                <a:cs typeface="Arial" panose="020B0604020202020204" pitchFamily="34" charset="0"/>
              </a:rPr>
              <a:t>et al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., </a:t>
            </a:r>
            <a:r>
              <a:rPr lang="fr-FR" sz="900" i="1" dirty="0">
                <a:latin typeface="Arial" panose="020B0604020202020204" pitchFamily="34" charset="0"/>
                <a:cs typeface="Arial" panose="020B0604020202020204" pitchFamily="34" charset="0"/>
              </a:rPr>
              <a:t>Science 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(2012) »</a:t>
            </a:r>
          </a:p>
        </p:txBody>
      </p:sp>
      <p:sp>
        <p:nvSpPr>
          <p:cNvPr id="94" name="ZoneTexte 93">
            <a:extLst>
              <a:ext uri="{FF2B5EF4-FFF2-40B4-BE49-F238E27FC236}">
                <a16:creationId xmlns:a16="http://schemas.microsoft.com/office/drawing/2014/main" xmlns="" id="{617BB688-0635-4290-92D8-D0EB3729C2AB}"/>
              </a:ext>
            </a:extLst>
          </p:cNvPr>
          <p:cNvSpPr txBox="1"/>
          <p:nvPr/>
        </p:nvSpPr>
        <p:spPr>
          <a:xfrm>
            <a:off x="4522774" y="706635"/>
            <a:ext cx="3056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B</a:t>
            </a:r>
          </a:p>
        </p:txBody>
      </p:sp>
      <p:sp>
        <p:nvSpPr>
          <p:cNvPr id="95" name="ZoneTexte 94">
            <a:extLst>
              <a:ext uri="{FF2B5EF4-FFF2-40B4-BE49-F238E27FC236}">
                <a16:creationId xmlns:a16="http://schemas.microsoft.com/office/drawing/2014/main" xmlns="" id="{25FE842F-C9A6-4B63-8821-4D4E6B64180A}"/>
              </a:ext>
            </a:extLst>
          </p:cNvPr>
          <p:cNvSpPr txBox="1"/>
          <p:nvPr/>
        </p:nvSpPr>
        <p:spPr>
          <a:xfrm>
            <a:off x="193240" y="152562"/>
            <a:ext cx="68821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/>
              <a:t>Sup Figure 2. </a:t>
            </a:r>
            <a:r>
              <a:rPr lang="fr-FR" sz="1600" dirty="0" err="1"/>
              <a:t>Schematics</a:t>
            </a:r>
            <a:r>
              <a:rPr lang="fr-FR" sz="1600" dirty="0"/>
              <a:t> of </a:t>
            </a:r>
            <a:r>
              <a:rPr lang="fr-FR" sz="1600" dirty="0" err="1"/>
              <a:t>leptospiral</a:t>
            </a:r>
            <a:r>
              <a:rPr lang="fr-FR" sz="1600" dirty="0"/>
              <a:t> filament and </a:t>
            </a:r>
            <a:r>
              <a:rPr lang="fr-FR" sz="1600" dirty="0" err="1"/>
              <a:t>FliC</a:t>
            </a:r>
            <a:r>
              <a:rPr lang="fr-FR" sz="1600" dirty="0"/>
              <a:t> association </a:t>
            </a:r>
            <a:r>
              <a:rPr lang="fr-FR" sz="1600" dirty="0" err="1"/>
              <a:t>with</a:t>
            </a:r>
            <a:r>
              <a:rPr lang="fr-FR" sz="1600" dirty="0"/>
              <a:t> TLR5</a:t>
            </a:r>
          </a:p>
        </p:txBody>
      </p:sp>
      <p:grpSp>
        <p:nvGrpSpPr>
          <p:cNvPr id="70" name="Groupe 69">
            <a:extLst>
              <a:ext uri="{FF2B5EF4-FFF2-40B4-BE49-F238E27FC236}">
                <a16:creationId xmlns:a16="http://schemas.microsoft.com/office/drawing/2014/main" xmlns="" id="{4FE3CCA2-D45B-4A3F-A6BB-017B5A101F8B}"/>
              </a:ext>
            </a:extLst>
          </p:cNvPr>
          <p:cNvGrpSpPr/>
          <p:nvPr/>
        </p:nvGrpSpPr>
        <p:grpSpPr>
          <a:xfrm>
            <a:off x="-26404" y="967231"/>
            <a:ext cx="4183503" cy="1733292"/>
            <a:chOff x="1890540" y="1141981"/>
            <a:chExt cx="4135757" cy="1448312"/>
          </a:xfrm>
        </p:grpSpPr>
        <p:grpSp>
          <p:nvGrpSpPr>
            <p:cNvPr id="32" name="Groupe 31">
              <a:extLst>
                <a:ext uri="{FF2B5EF4-FFF2-40B4-BE49-F238E27FC236}">
                  <a16:creationId xmlns:a16="http://schemas.microsoft.com/office/drawing/2014/main" xmlns="" id="{F34C7192-CF04-47A8-BA17-3FB64D7D860E}"/>
                </a:ext>
              </a:extLst>
            </p:cNvPr>
            <p:cNvGrpSpPr/>
            <p:nvPr/>
          </p:nvGrpSpPr>
          <p:grpSpPr>
            <a:xfrm>
              <a:off x="3116937" y="1227019"/>
              <a:ext cx="1249219" cy="1363274"/>
              <a:chOff x="4670197" y="554352"/>
              <a:chExt cx="1462224" cy="1595730"/>
            </a:xfrm>
          </p:grpSpPr>
          <p:sp>
            <p:nvSpPr>
              <p:cNvPr id="3" name="Forme libre : forme 2">
                <a:extLst>
                  <a:ext uri="{FF2B5EF4-FFF2-40B4-BE49-F238E27FC236}">
                    <a16:creationId xmlns:a16="http://schemas.microsoft.com/office/drawing/2014/main" xmlns="" id="{D8683284-7D59-4F67-87BB-475298BBA3F5}"/>
                  </a:ext>
                </a:extLst>
              </p:cNvPr>
              <p:cNvSpPr/>
              <p:nvPr/>
            </p:nvSpPr>
            <p:spPr>
              <a:xfrm>
                <a:off x="4670197" y="614013"/>
                <a:ext cx="769899" cy="1536069"/>
              </a:xfrm>
              <a:custGeom>
                <a:avLst/>
                <a:gdLst>
                  <a:gd name="connsiteX0" fmla="*/ 200143 w 691107"/>
                  <a:gd name="connsiteY0" fmla="*/ 5112 h 1536069"/>
                  <a:gd name="connsiteX1" fmla="*/ 104893 w 691107"/>
                  <a:gd name="connsiteY1" fmla="*/ 100362 h 1536069"/>
                  <a:gd name="connsiteX2" fmla="*/ 38218 w 691107"/>
                  <a:gd name="connsiteY2" fmla="*/ 443262 h 1536069"/>
                  <a:gd name="connsiteX3" fmla="*/ 123943 w 691107"/>
                  <a:gd name="connsiteY3" fmla="*/ 548037 h 1536069"/>
                  <a:gd name="connsiteX4" fmla="*/ 142993 w 691107"/>
                  <a:gd name="connsiteY4" fmla="*/ 767112 h 1536069"/>
                  <a:gd name="connsiteX5" fmla="*/ 57268 w 691107"/>
                  <a:gd name="connsiteY5" fmla="*/ 881412 h 1536069"/>
                  <a:gd name="connsiteX6" fmla="*/ 118 w 691107"/>
                  <a:gd name="connsiteY6" fmla="*/ 1005237 h 1536069"/>
                  <a:gd name="connsiteX7" fmla="*/ 47743 w 691107"/>
                  <a:gd name="connsiteY7" fmla="*/ 1243362 h 1536069"/>
                  <a:gd name="connsiteX8" fmla="*/ 209668 w 691107"/>
                  <a:gd name="connsiteY8" fmla="*/ 1367187 h 1536069"/>
                  <a:gd name="connsiteX9" fmla="*/ 371593 w 691107"/>
                  <a:gd name="connsiteY9" fmla="*/ 1357662 h 1536069"/>
                  <a:gd name="connsiteX10" fmla="*/ 438268 w 691107"/>
                  <a:gd name="connsiteY10" fmla="*/ 1500537 h 1536069"/>
                  <a:gd name="connsiteX11" fmla="*/ 514468 w 691107"/>
                  <a:gd name="connsiteY11" fmla="*/ 1510062 h 1536069"/>
                  <a:gd name="connsiteX12" fmla="*/ 685918 w 691107"/>
                  <a:gd name="connsiteY12" fmla="*/ 1195737 h 1536069"/>
                  <a:gd name="connsiteX13" fmla="*/ 295393 w 691107"/>
                  <a:gd name="connsiteY13" fmla="*/ 957612 h 1536069"/>
                  <a:gd name="connsiteX14" fmla="*/ 314443 w 691107"/>
                  <a:gd name="connsiteY14" fmla="*/ 290862 h 1536069"/>
                  <a:gd name="connsiteX15" fmla="*/ 495418 w 691107"/>
                  <a:gd name="connsiteY15" fmla="*/ 290862 h 1536069"/>
                  <a:gd name="connsiteX16" fmla="*/ 609718 w 691107"/>
                  <a:gd name="connsiteY16" fmla="*/ 119412 h 1536069"/>
                  <a:gd name="connsiteX17" fmla="*/ 295393 w 691107"/>
                  <a:gd name="connsiteY17" fmla="*/ 24162 h 1536069"/>
                  <a:gd name="connsiteX18" fmla="*/ 200143 w 691107"/>
                  <a:gd name="connsiteY18" fmla="*/ 5112 h 1536069"/>
                  <a:gd name="connsiteX0" fmla="*/ 200143 w 691107"/>
                  <a:gd name="connsiteY0" fmla="*/ 5112 h 1536069"/>
                  <a:gd name="connsiteX1" fmla="*/ 104893 w 691107"/>
                  <a:gd name="connsiteY1" fmla="*/ 100362 h 1536069"/>
                  <a:gd name="connsiteX2" fmla="*/ 38218 w 691107"/>
                  <a:gd name="connsiteY2" fmla="*/ 443262 h 1536069"/>
                  <a:gd name="connsiteX3" fmla="*/ 190347 w 691107"/>
                  <a:gd name="connsiteY3" fmla="*/ 469368 h 1536069"/>
                  <a:gd name="connsiteX4" fmla="*/ 142993 w 691107"/>
                  <a:gd name="connsiteY4" fmla="*/ 767112 h 1536069"/>
                  <a:gd name="connsiteX5" fmla="*/ 57268 w 691107"/>
                  <a:gd name="connsiteY5" fmla="*/ 881412 h 1536069"/>
                  <a:gd name="connsiteX6" fmla="*/ 118 w 691107"/>
                  <a:gd name="connsiteY6" fmla="*/ 1005237 h 1536069"/>
                  <a:gd name="connsiteX7" fmla="*/ 47743 w 691107"/>
                  <a:gd name="connsiteY7" fmla="*/ 1243362 h 1536069"/>
                  <a:gd name="connsiteX8" fmla="*/ 209668 w 691107"/>
                  <a:gd name="connsiteY8" fmla="*/ 1367187 h 1536069"/>
                  <a:gd name="connsiteX9" fmla="*/ 371593 w 691107"/>
                  <a:gd name="connsiteY9" fmla="*/ 1357662 h 1536069"/>
                  <a:gd name="connsiteX10" fmla="*/ 438268 w 691107"/>
                  <a:gd name="connsiteY10" fmla="*/ 1500537 h 1536069"/>
                  <a:gd name="connsiteX11" fmla="*/ 514468 w 691107"/>
                  <a:gd name="connsiteY11" fmla="*/ 1510062 h 1536069"/>
                  <a:gd name="connsiteX12" fmla="*/ 685918 w 691107"/>
                  <a:gd name="connsiteY12" fmla="*/ 1195737 h 1536069"/>
                  <a:gd name="connsiteX13" fmla="*/ 295393 w 691107"/>
                  <a:gd name="connsiteY13" fmla="*/ 957612 h 1536069"/>
                  <a:gd name="connsiteX14" fmla="*/ 314443 w 691107"/>
                  <a:gd name="connsiteY14" fmla="*/ 290862 h 1536069"/>
                  <a:gd name="connsiteX15" fmla="*/ 495418 w 691107"/>
                  <a:gd name="connsiteY15" fmla="*/ 290862 h 1536069"/>
                  <a:gd name="connsiteX16" fmla="*/ 609718 w 691107"/>
                  <a:gd name="connsiteY16" fmla="*/ 119412 h 1536069"/>
                  <a:gd name="connsiteX17" fmla="*/ 295393 w 691107"/>
                  <a:gd name="connsiteY17" fmla="*/ 24162 h 1536069"/>
                  <a:gd name="connsiteX18" fmla="*/ 200143 w 691107"/>
                  <a:gd name="connsiteY18" fmla="*/ 5112 h 1536069"/>
                  <a:gd name="connsiteX0" fmla="*/ 200143 w 691107"/>
                  <a:gd name="connsiteY0" fmla="*/ 5112 h 1536069"/>
                  <a:gd name="connsiteX1" fmla="*/ 104893 w 691107"/>
                  <a:gd name="connsiteY1" fmla="*/ 100362 h 1536069"/>
                  <a:gd name="connsiteX2" fmla="*/ 42645 w 691107"/>
                  <a:gd name="connsiteY2" fmla="*/ 348031 h 1536069"/>
                  <a:gd name="connsiteX3" fmla="*/ 190347 w 691107"/>
                  <a:gd name="connsiteY3" fmla="*/ 469368 h 1536069"/>
                  <a:gd name="connsiteX4" fmla="*/ 142993 w 691107"/>
                  <a:gd name="connsiteY4" fmla="*/ 767112 h 1536069"/>
                  <a:gd name="connsiteX5" fmla="*/ 57268 w 691107"/>
                  <a:gd name="connsiteY5" fmla="*/ 881412 h 1536069"/>
                  <a:gd name="connsiteX6" fmla="*/ 118 w 691107"/>
                  <a:gd name="connsiteY6" fmla="*/ 1005237 h 1536069"/>
                  <a:gd name="connsiteX7" fmla="*/ 47743 w 691107"/>
                  <a:gd name="connsiteY7" fmla="*/ 1243362 h 1536069"/>
                  <a:gd name="connsiteX8" fmla="*/ 209668 w 691107"/>
                  <a:gd name="connsiteY8" fmla="*/ 1367187 h 1536069"/>
                  <a:gd name="connsiteX9" fmla="*/ 371593 w 691107"/>
                  <a:gd name="connsiteY9" fmla="*/ 1357662 h 1536069"/>
                  <a:gd name="connsiteX10" fmla="*/ 438268 w 691107"/>
                  <a:gd name="connsiteY10" fmla="*/ 1500537 h 1536069"/>
                  <a:gd name="connsiteX11" fmla="*/ 514468 w 691107"/>
                  <a:gd name="connsiteY11" fmla="*/ 1510062 h 1536069"/>
                  <a:gd name="connsiteX12" fmla="*/ 685918 w 691107"/>
                  <a:gd name="connsiteY12" fmla="*/ 1195737 h 1536069"/>
                  <a:gd name="connsiteX13" fmla="*/ 295393 w 691107"/>
                  <a:gd name="connsiteY13" fmla="*/ 957612 h 1536069"/>
                  <a:gd name="connsiteX14" fmla="*/ 314443 w 691107"/>
                  <a:gd name="connsiteY14" fmla="*/ 290862 h 1536069"/>
                  <a:gd name="connsiteX15" fmla="*/ 495418 w 691107"/>
                  <a:gd name="connsiteY15" fmla="*/ 290862 h 1536069"/>
                  <a:gd name="connsiteX16" fmla="*/ 609718 w 691107"/>
                  <a:gd name="connsiteY16" fmla="*/ 119412 h 1536069"/>
                  <a:gd name="connsiteX17" fmla="*/ 295393 w 691107"/>
                  <a:gd name="connsiteY17" fmla="*/ 24162 h 1536069"/>
                  <a:gd name="connsiteX18" fmla="*/ 200143 w 691107"/>
                  <a:gd name="connsiteY18" fmla="*/ 5112 h 1536069"/>
                  <a:gd name="connsiteX0" fmla="*/ 200143 w 691107"/>
                  <a:gd name="connsiteY0" fmla="*/ 5112 h 1536069"/>
                  <a:gd name="connsiteX1" fmla="*/ 104893 w 691107"/>
                  <a:gd name="connsiteY1" fmla="*/ 100362 h 1536069"/>
                  <a:gd name="connsiteX2" fmla="*/ 42645 w 691107"/>
                  <a:gd name="connsiteY2" fmla="*/ 348031 h 1536069"/>
                  <a:gd name="connsiteX3" fmla="*/ 190347 w 691107"/>
                  <a:gd name="connsiteY3" fmla="*/ 469368 h 1536069"/>
                  <a:gd name="connsiteX4" fmla="*/ 147420 w 691107"/>
                  <a:gd name="connsiteY4" fmla="*/ 912028 h 1536069"/>
                  <a:gd name="connsiteX5" fmla="*/ 57268 w 691107"/>
                  <a:gd name="connsiteY5" fmla="*/ 881412 h 1536069"/>
                  <a:gd name="connsiteX6" fmla="*/ 118 w 691107"/>
                  <a:gd name="connsiteY6" fmla="*/ 1005237 h 1536069"/>
                  <a:gd name="connsiteX7" fmla="*/ 47743 w 691107"/>
                  <a:gd name="connsiteY7" fmla="*/ 1243362 h 1536069"/>
                  <a:gd name="connsiteX8" fmla="*/ 209668 w 691107"/>
                  <a:gd name="connsiteY8" fmla="*/ 1367187 h 1536069"/>
                  <a:gd name="connsiteX9" fmla="*/ 371593 w 691107"/>
                  <a:gd name="connsiteY9" fmla="*/ 1357662 h 1536069"/>
                  <a:gd name="connsiteX10" fmla="*/ 438268 w 691107"/>
                  <a:gd name="connsiteY10" fmla="*/ 1500537 h 1536069"/>
                  <a:gd name="connsiteX11" fmla="*/ 514468 w 691107"/>
                  <a:gd name="connsiteY11" fmla="*/ 1510062 h 1536069"/>
                  <a:gd name="connsiteX12" fmla="*/ 685918 w 691107"/>
                  <a:gd name="connsiteY12" fmla="*/ 1195737 h 1536069"/>
                  <a:gd name="connsiteX13" fmla="*/ 295393 w 691107"/>
                  <a:gd name="connsiteY13" fmla="*/ 957612 h 1536069"/>
                  <a:gd name="connsiteX14" fmla="*/ 314443 w 691107"/>
                  <a:gd name="connsiteY14" fmla="*/ 290862 h 1536069"/>
                  <a:gd name="connsiteX15" fmla="*/ 495418 w 691107"/>
                  <a:gd name="connsiteY15" fmla="*/ 290862 h 1536069"/>
                  <a:gd name="connsiteX16" fmla="*/ 609718 w 691107"/>
                  <a:gd name="connsiteY16" fmla="*/ 119412 h 1536069"/>
                  <a:gd name="connsiteX17" fmla="*/ 295393 w 691107"/>
                  <a:gd name="connsiteY17" fmla="*/ 24162 h 1536069"/>
                  <a:gd name="connsiteX18" fmla="*/ 200143 w 691107"/>
                  <a:gd name="connsiteY18" fmla="*/ 5112 h 1536069"/>
                  <a:gd name="connsiteX0" fmla="*/ 200143 w 691107"/>
                  <a:gd name="connsiteY0" fmla="*/ 5112 h 1536069"/>
                  <a:gd name="connsiteX1" fmla="*/ 104893 w 691107"/>
                  <a:gd name="connsiteY1" fmla="*/ 100362 h 1536069"/>
                  <a:gd name="connsiteX2" fmla="*/ 42645 w 691107"/>
                  <a:gd name="connsiteY2" fmla="*/ 348031 h 1536069"/>
                  <a:gd name="connsiteX3" fmla="*/ 190347 w 691107"/>
                  <a:gd name="connsiteY3" fmla="*/ 469368 h 1536069"/>
                  <a:gd name="connsiteX4" fmla="*/ 147420 w 691107"/>
                  <a:gd name="connsiteY4" fmla="*/ 912028 h 1536069"/>
                  <a:gd name="connsiteX5" fmla="*/ 57269 w 691107"/>
                  <a:gd name="connsiteY5" fmla="*/ 989064 h 1536069"/>
                  <a:gd name="connsiteX6" fmla="*/ 118 w 691107"/>
                  <a:gd name="connsiteY6" fmla="*/ 1005237 h 1536069"/>
                  <a:gd name="connsiteX7" fmla="*/ 47743 w 691107"/>
                  <a:gd name="connsiteY7" fmla="*/ 1243362 h 1536069"/>
                  <a:gd name="connsiteX8" fmla="*/ 209668 w 691107"/>
                  <a:gd name="connsiteY8" fmla="*/ 1367187 h 1536069"/>
                  <a:gd name="connsiteX9" fmla="*/ 371593 w 691107"/>
                  <a:gd name="connsiteY9" fmla="*/ 1357662 h 1536069"/>
                  <a:gd name="connsiteX10" fmla="*/ 438268 w 691107"/>
                  <a:gd name="connsiteY10" fmla="*/ 1500537 h 1536069"/>
                  <a:gd name="connsiteX11" fmla="*/ 514468 w 691107"/>
                  <a:gd name="connsiteY11" fmla="*/ 1510062 h 1536069"/>
                  <a:gd name="connsiteX12" fmla="*/ 685918 w 691107"/>
                  <a:gd name="connsiteY12" fmla="*/ 1195737 h 1536069"/>
                  <a:gd name="connsiteX13" fmla="*/ 295393 w 691107"/>
                  <a:gd name="connsiteY13" fmla="*/ 957612 h 1536069"/>
                  <a:gd name="connsiteX14" fmla="*/ 314443 w 691107"/>
                  <a:gd name="connsiteY14" fmla="*/ 290862 h 1536069"/>
                  <a:gd name="connsiteX15" fmla="*/ 495418 w 691107"/>
                  <a:gd name="connsiteY15" fmla="*/ 290862 h 1536069"/>
                  <a:gd name="connsiteX16" fmla="*/ 609718 w 691107"/>
                  <a:gd name="connsiteY16" fmla="*/ 119412 h 1536069"/>
                  <a:gd name="connsiteX17" fmla="*/ 295393 w 691107"/>
                  <a:gd name="connsiteY17" fmla="*/ 24162 h 1536069"/>
                  <a:gd name="connsiteX18" fmla="*/ 200143 w 691107"/>
                  <a:gd name="connsiteY18" fmla="*/ 5112 h 1536069"/>
                  <a:gd name="connsiteX0" fmla="*/ 200143 w 691107"/>
                  <a:gd name="connsiteY0" fmla="*/ 5112 h 1536069"/>
                  <a:gd name="connsiteX1" fmla="*/ 104893 w 691107"/>
                  <a:gd name="connsiteY1" fmla="*/ 100362 h 1536069"/>
                  <a:gd name="connsiteX2" fmla="*/ 42645 w 691107"/>
                  <a:gd name="connsiteY2" fmla="*/ 348031 h 1536069"/>
                  <a:gd name="connsiteX3" fmla="*/ 190347 w 691107"/>
                  <a:gd name="connsiteY3" fmla="*/ 469368 h 1536069"/>
                  <a:gd name="connsiteX4" fmla="*/ 147420 w 691107"/>
                  <a:gd name="connsiteY4" fmla="*/ 912028 h 1536069"/>
                  <a:gd name="connsiteX5" fmla="*/ 57269 w 691107"/>
                  <a:gd name="connsiteY5" fmla="*/ 989064 h 1536069"/>
                  <a:gd name="connsiteX6" fmla="*/ 118 w 691107"/>
                  <a:gd name="connsiteY6" fmla="*/ 1117030 h 1536069"/>
                  <a:gd name="connsiteX7" fmla="*/ 47743 w 691107"/>
                  <a:gd name="connsiteY7" fmla="*/ 1243362 h 1536069"/>
                  <a:gd name="connsiteX8" fmla="*/ 209668 w 691107"/>
                  <a:gd name="connsiteY8" fmla="*/ 1367187 h 1536069"/>
                  <a:gd name="connsiteX9" fmla="*/ 371593 w 691107"/>
                  <a:gd name="connsiteY9" fmla="*/ 1357662 h 1536069"/>
                  <a:gd name="connsiteX10" fmla="*/ 438268 w 691107"/>
                  <a:gd name="connsiteY10" fmla="*/ 1500537 h 1536069"/>
                  <a:gd name="connsiteX11" fmla="*/ 514468 w 691107"/>
                  <a:gd name="connsiteY11" fmla="*/ 1510062 h 1536069"/>
                  <a:gd name="connsiteX12" fmla="*/ 685918 w 691107"/>
                  <a:gd name="connsiteY12" fmla="*/ 1195737 h 1536069"/>
                  <a:gd name="connsiteX13" fmla="*/ 295393 w 691107"/>
                  <a:gd name="connsiteY13" fmla="*/ 957612 h 1536069"/>
                  <a:gd name="connsiteX14" fmla="*/ 314443 w 691107"/>
                  <a:gd name="connsiteY14" fmla="*/ 290862 h 1536069"/>
                  <a:gd name="connsiteX15" fmla="*/ 495418 w 691107"/>
                  <a:gd name="connsiteY15" fmla="*/ 290862 h 1536069"/>
                  <a:gd name="connsiteX16" fmla="*/ 609718 w 691107"/>
                  <a:gd name="connsiteY16" fmla="*/ 119412 h 1536069"/>
                  <a:gd name="connsiteX17" fmla="*/ 295393 w 691107"/>
                  <a:gd name="connsiteY17" fmla="*/ 24162 h 1536069"/>
                  <a:gd name="connsiteX18" fmla="*/ 200143 w 691107"/>
                  <a:gd name="connsiteY18" fmla="*/ 5112 h 1536069"/>
                  <a:gd name="connsiteX0" fmla="*/ 200196 w 691160"/>
                  <a:gd name="connsiteY0" fmla="*/ 5112 h 1536069"/>
                  <a:gd name="connsiteX1" fmla="*/ 104946 w 691160"/>
                  <a:gd name="connsiteY1" fmla="*/ 100362 h 1536069"/>
                  <a:gd name="connsiteX2" fmla="*/ 42698 w 691160"/>
                  <a:gd name="connsiteY2" fmla="*/ 348031 h 1536069"/>
                  <a:gd name="connsiteX3" fmla="*/ 190400 w 691160"/>
                  <a:gd name="connsiteY3" fmla="*/ 469368 h 1536069"/>
                  <a:gd name="connsiteX4" fmla="*/ 147473 w 691160"/>
                  <a:gd name="connsiteY4" fmla="*/ 912028 h 1536069"/>
                  <a:gd name="connsiteX5" fmla="*/ 59534 w 691160"/>
                  <a:gd name="connsiteY5" fmla="*/ 1026328 h 1536069"/>
                  <a:gd name="connsiteX6" fmla="*/ 171 w 691160"/>
                  <a:gd name="connsiteY6" fmla="*/ 1117030 h 1536069"/>
                  <a:gd name="connsiteX7" fmla="*/ 47796 w 691160"/>
                  <a:gd name="connsiteY7" fmla="*/ 1243362 h 1536069"/>
                  <a:gd name="connsiteX8" fmla="*/ 209721 w 691160"/>
                  <a:gd name="connsiteY8" fmla="*/ 1367187 h 1536069"/>
                  <a:gd name="connsiteX9" fmla="*/ 371646 w 691160"/>
                  <a:gd name="connsiteY9" fmla="*/ 1357662 h 1536069"/>
                  <a:gd name="connsiteX10" fmla="*/ 438321 w 691160"/>
                  <a:gd name="connsiteY10" fmla="*/ 1500537 h 1536069"/>
                  <a:gd name="connsiteX11" fmla="*/ 514521 w 691160"/>
                  <a:gd name="connsiteY11" fmla="*/ 1510062 h 1536069"/>
                  <a:gd name="connsiteX12" fmla="*/ 685971 w 691160"/>
                  <a:gd name="connsiteY12" fmla="*/ 1195737 h 1536069"/>
                  <a:gd name="connsiteX13" fmla="*/ 295446 w 691160"/>
                  <a:gd name="connsiteY13" fmla="*/ 957612 h 1536069"/>
                  <a:gd name="connsiteX14" fmla="*/ 314496 w 691160"/>
                  <a:gd name="connsiteY14" fmla="*/ 290862 h 1536069"/>
                  <a:gd name="connsiteX15" fmla="*/ 495471 w 691160"/>
                  <a:gd name="connsiteY15" fmla="*/ 290862 h 1536069"/>
                  <a:gd name="connsiteX16" fmla="*/ 609771 w 691160"/>
                  <a:gd name="connsiteY16" fmla="*/ 119412 h 1536069"/>
                  <a:gd name="connsiteX17" fmla="*/ 295446 w 691160"/>
                  <a:gd name="connsiteY17" fmla="*/ 24162 h 1536069"/>
                  <a:gd name="connsiteX18" fmla="*/ 200196 w 691160"/>
                  <a:gd name="connsiteY18" fmla="*/ 5112 h 1536069"/>
                  <a:gd name="connsiteX0" fmla="*/ 204803 w 695767"/>
                  <a:gd name="connsiteY0" fmla="*/ 5112 h 1536069"/>
                  <a:gd name="connsiteX1" fmla="*/ 109553 w 695767"/>
                  <a:gd name="connsiteY1" fmla="*/ 100362 h 1536069"/>
                  <a:gd name="connsiteX2" fmla="*/ 47305 w 695767"/>
                  <a:gd name="connsiteY2" fmla="*/ 348031 h 1536069"/>
                  <a:gd name="connsiteX3" fmla="*/ 195007 w 695767"/>
                  <a:gd name="connsiteY3" fmla="*/ 469368 h 1536069"/>
                  <a:gd name="connsiteX4" fmla="*/ 152080 w 695767"/>
                  <a:gd name="connsiteY4" fmla="*/ 912028 h 1536069"/>
                  <a:gd name="connsiteX5" fmla="*/ 4778 w 695767"/>
                  <a:gd name="connsiteY5" fmla="*/ 1117030 h 1536069"/>
                  <a:gd name="connsiteX6" fmla="*/ 52403 w 695767"/>
                  <a:gd name="connsiteY6" fmla="*/ 1243362 h 1536069"/>
                  <a:gd name="connsiteX7" fmla="*/ 214328 w 695767"/>
                  <a:gd name="connsiteY7" fmla="*/ 1367187 h 1536069"/>
                  <a:gd name="connsiteX8" fmla="*/ 376253 w 695767"/>
                  <a:gd name="connsiteY8" fmla="*/ 1357662 h 1536069"/>
                  <a:gd name="connsiteX9" fmla="*/ 442928 w 695767"/>
                  <a:gd name="connsiteY9" fmla="*/ 1500537 h 1536069"/>
                  <a:gd name="connsiteX10" fmla="*/ 519128 w 695767"/>
                  <a:gd name="connsiteY10" fmla="*/ 1510062 h 1536069"/>
                  <a:gd name="connsiteX11" fmla="*/ 690578 w 695767"/>
                  <a:gd name="connsiteY11" fmla="*/ 1195737 h 1536069"/>
                  <a:gd name="connsiteX12" fmla="*/ 300053 w 695767"/>
                  <a:gd name="connsiteY12" fmla="*/ 957612 h 1536069"/>
                  <a:gd name="connsiteX13" fmla="*/ 319103 w 695767"/>
                  <a:gd name="connsiteY13" fmla="*/ 290862 h 1536069"/>
                  <a:gd name="connsiteX14" fmla="*/ 500078 w 695767"/>
                  <a:gd name="connsiteY14" fmla="*/ 290862 h 1536069"/>
                  <a:gd name="connsiteX15" fmla="*/ 614378 w 695767"/>
                  <a:gd name="connsiteY15" fmla="*/ 119412 h 1536069"/>
                  <a:gd name="connsiteX16" fmla="*/ 300053 w 695767"/>
                  <a:gd name="connsiteY16" fmla="*/ 24162 h 1536069"/>
                  <a:gd name="connsiteX17" fmla="*/ 204803 w 695767"/>
                  <a:gd name="connsiteY17" fmla="*/ 5112 h 153606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</a:cxnLst>
                <a:rect l="l" t="t" r="r" b="b"/>
                <a:pathLst>
                  <a:path w="695767" h="1536069">
                    <a:moveTo>
                      <a:pt x="204803" y="5112"/>
                    </a:moveTo>
                    <a:cubicBezTo>
                      <a:pt x="173053" y="17812"/>
                      <a:pt x="135803" y="43209"/>
                      <a:pt x="109553" y="100362"/>
                    </a:cubicBezTo>
                    <a:cubicBezTo>
                      <a:pt x="83303" y="157515"/>
                      <a:pt x="33063" y="286530"/>
                      <a:pt x="47305" y="348031"/>
                    </a:cubicBezTo>
                    <a:cubicBezTo>
                      <a:pt x="61547" y="409532"/>
                      <a:pt x="177545" y="375369"/>
                      <a:pt x="195007" y="469368"/>
                    </a:cubicBezTo>
                    <a:cubicBezTo>
                      <a:pt x="212469" y="563367"/>
                      <a:pt x="183785" y="804084"/>
                      <a:pt x="152080" y="912028"/>
                    </a:cubicBezTo>
                    <a:cubicBezTo>
                      <a:pt x="120375" y="1019972"/>
                      <a:pt x="21391" y="1061808"/>
                      <a:pt x="4778" y="1117030"/>
                    </a:cubicBezTo>
                    <a:cubicBezTo>
                      <a:pt x="-11835" y="1172252"/>
                      <a:pt x="17478" y="1201669"/>
                      <a:pt x="52403" y="1243362"/>
                    </a:cubicBezTo>
                    <a:cubicBezTo>
                      <a:pt x="87328" y="1285055"/>
                      <a:pt x="160353" y="1348137"/>
                      <a:pt x="214328" y="1367187"/>
                    </a:cubicBezTo>
                    <a:cubicBezTo>
                      <a:pt x="268303" y="1386237"/>
                      <a:pt x="338153" y="1335437"/>
                      <a:pt x="376253" y="1357662"/>
                    </a:cubicBezTo>
                    <a:cubicBezTo>
                      <a:pt x="414353" y="1379887"/>
                      <a:pt x="419116" y="1475137"/>
                      <a:pt x="442928" y="1500537"/>
                    </a:cubicBezTo>
                    <a:cubicBezTo>
                      <a:pt x="466741" y="1525937"/>
                      <a:pt x="477853" y="1560862"/>
                      <a:pt x="519128" y="1510062"/>
                    </a:cubicBezTo>
                    <a:cubicBezTo>
                      <a:pt x="560403" y="1459262"/>
                      <a:pt x="727090" y="1287812"/>
                      <a:pt x="690578" y="1195737"/>
                    </a:cubicBezTo>
                    <a:cubicBezTo>
                      <a:pt x="654066" y="1103662"/>
                      <a:pt x="361966" y="1108425"/>
                      <a:pt x="300053" y="957612"/>
                    </a:cubicBezTo>
                    <a:cubicBezTo>
                      <a:pt x="238141" y="806800"/>
                      <a:pt x="285766" y="401987"/>
                      <a:pt x="319103" y="290862"/>
                    </a:cubicBezTo>
                    <a:cubicBezTo>
                      <a:pt x="352441" y="179737"/>
                      <a:pt x="450866" y="319437"/>
                      <a:pt x="500078" y="290862"/>
                    </a:cubicBezTo>
                    <a:cubicBezTo>
                      <a:pt x="549291" y="262287"/>
                      <a:pt x="647715" y="163862"/>
                      <a:pt x="614378" y="119412"/>
                    </a:cubicBezTo>
                    <a:cubicBezTo>
                      <a:pt x="581041" y="74962"/>
                      <a:pt x="374665" y="43212"/>
                      <a:pt x="300053" y="24162"/>
                    </a:cubicBezTo>
                    <a:cubicBezTo>
                      <a:pt x="225441" y="5112"/>
                      <a:pt x="236553" y="-7588"/>
                      <a:pt x="204803" y="5112"/>
                    </a:cubicBezTo>
                    <a:close/>
                  </a:path>
                </a:pathLst>
              </a:custGeom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6" name="Groupe 25">
                <a:extLst>
                  <a:ext uri="{FF2B5EF4-FFF2-40B4-BE49-F238E27FC236}">
                    <a16:creationId xmlns:a16="http://schemas.microsoft.com/office/drawing/2014/main" xmlns="" id="{20ABE10B-9DEF-4747-BBBE-A0346AB1B83E}"/>
                  </a:ext>
                </a:extLst>
              </p:cNvPr>
              <p:cNvGrpSpPr/>
              <p:nvPr/>
            </p:nvGrpSpPr>
            <p:grpSpPr>
              <a:xfrm>
                <a:off x="5604034" y="602958"/>
                <a:ext cx="528387" cy="1430540"/>
                <a:chOff x="5626331" y="612897"/>
                <a:chExt cx="489012" cy="1323939"/>
              </a:xfrm>
              <a:solidFill>
                <a:srgbClr val="0066CC"/>
              </a:solidFill>
              <a:effectLst/>
            </p:grpSpPr>
            <p:sp>
              <p:nvSpPr>
                <p:cNvPr id="22" name="Forme libre : forme 21">
                  <a:extLst>
                    <a:ext uri="{FF2B5EF4-FFF2-40B4-BE49-F238E27FC236}">
                      <a16:creationId xmlns:a16="http://schemas.microsoft.com/office/drawing/2014/main" xmlns="" id="{464D2FA0-09F2-4340-887A-83DEC52D5AB1}"/>
                    </a:ext>
                  </a:extLst>
                </p:cNvPr>
                <p:cNvSpPr/>
                <p:nvPr/>
              </p:nvSpPr>
              <p:spPr>
                <a:xfrm>
                  <a:off x="5730517" y="612897"/>
                  <a:ext cx="265004" cy="333711"/>
                </a:xfrm>
                <a:custGeom>
                  <a:avLst/>
                  <a:gdLst>
                    <a:gd name="connsiteX0" fmla="*/ 7144 w 265004"/>
                    <a:gd name="connsiteY0" fmla="*/ 62065 h 333711"/>
                    <a:gd name="connsiteX1" fmla="*/ 35719 w 265004"/>
                    <a:gd name="connsiteY1" fmla="*/ 309715 h 333711"/>
                    <a:gd name="connsiteX2" fmla="*/ 264319 w 265004"/>
                    <a:gd name="connsiteY2" fmla="*/ 290665 h 333711"/>
                    <a:gd name="connsiteX3" fmla="*/ 102394 w 265004"/>
                    <a:gd name="connsiteY3" fmla="*/ 14440 h 333711"/>
                    <a:gd name="connsiteX4" fmla="*/ 7144 w 265004"/>
                    <a:gd name="connsiteY4" fmla="*/ 62065 h 33371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265004" h="333711">
                      <a:moveTo>
                        <a:pt x="7144" y="62065"/>
                      </a:moveTo>
                      <a:cubicBezTo>
                        <a:pt x="-3968" y="111277"/>
                        <a:pt x="-7143" y="271615"/>
                        <a:pt x="35719" y="309715"/>
                      </a:cubicBezTo>
                      <a:cubicBezTo>
                        <a:pt x="78581" y="347815"/>
                        <a:pt x="253207" y="339877"/>
                        <a:pt x="264319" y="290665"/>
                      </a:cubicBezTo>
                      <a:cubicBezTo>
                        <a:pt x="275431" y="241453"/>
                        <a:pt x="148431" y="49365"/>
                        <a:pt x="102394" y="14440"/>
                      </a:cubicBezTo>
                      <a:cubicBezTo>
                        <a:pt x="56357" y="-20485"/>
                        <a:pt x="18256" y="12853"/>
                        <a:pt x="7144" y="62065"/>
                      </a:cubicBezTo>
                      <a:close/>
                    </a:path>
                  </a:pathLst>
                </a:custGeom>
                <a:solidFill>
                  <a:srgbClr val="C00000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" name="Forme libre : forme 22">
                  <a:extLst>
                    <a:ext uri="{FF2B5EF4-FFF2-40B4-BE49-F238E27FC236}">
                      <a16:creationId xmlns:a16="http://schemas.microsoft.com/office/drawing/2014/main" xmlns="" id="{9A7E382F-3D89-4091-9F70-EA25A4713495}"/>
                    </a:ext>
                  </a:extLst>
                </p:cNvPr>
                <p:cNvSpPr/>
                <p:nvPr/>
              </p:nvSpPr>
              <p:spPr>
                <a:xfrm rot="1716915">
                  <a:off x="5850339" y="952689"/>
                  <a:ext cx="265004" cy="333711"/>
                </a:xfrm>
                <a:custGeom>
                  <a:avLst/>
                  <a:gdLst>
                    <a:gd name="connsiteX0" fmla="*/ 7144 w 265004"/>
                    <a:gd name="connsiteY0" fmla="*/ 62065 h 333711"/>
                    <a:gd name="connsiteX1" fmla="*/ 35719 w 265004"/>
                    <a:gd name="connsiteY1" fmla="*/ 309715 h 333711"/>
                    <a:gd name="connsiteX2" fmla="*/ 264319 w 265004"/>
                    <a:gd name="connsiteY2" fmla="*/ 290665 h 333711"/>
                    <a:gd name="connsiteX3" fmla="*/ 102394 w 265004"/>
                    <a:gd name="connsiteY3" fmla="*/ 14440 h 333711"/>
                    <a:gd name="connsiteX4" fmla="*/ 7144 w 265004"/>
                    <a:gd name="connsiteY4" fmla="*/ 62065 h 33371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265004" h="333711">
                      <a:moveTo>
                        <a:pt x="7144" y="62065"/>
                      </a:moveTo>
                      <a:cubicBezTo>
                        <a:pt x="-3968" y="111277"/>
                        <a:pt x="-7143" y="271615"/>
                        <a:pt x="35719" y="309715"/>
                      </a:cubicBezTo>
                      <a:cubicBezTo>
                        <a:pt x="78581" y="347815"/>
                        <a:pt x="253207" y="339877"/>
                        <a:pt x="264319" y="290665"/>
                      </a:cubicBezTo>
                      <a:cubicBezTo>
                        <a:pt x="275431" y="241453"/>
                        <a:pt x="148431" y="49365"/>
                        <a:pt x="102394" y="14440"/>
                      </a:cubicBezTo>
                      <a:cubicBezTo>
                        <a:pt x="56357" y="-20485"/>
                        <a:pt x="18256" y="12853"/>
                        <a:pt x="7144" y="62065"/>
                      </a:cubicBezTo>
                      <a:close/>
                    </a:path>
                  </a:pathLst>
                </a:custGeom>
                <a:solidFill>
                  <a:srgbClr val="C00000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" name="Forme libre : forme 23">
                  <a:extLst>
                    <a:ext uri="{FF2B5EF4-FFF2-40B4-BE49-F238E27FC236}">
                      <a16:creationId xmlns:a16="http://schemas.microsoft.com/office/drawing/2014/main" xmlns="" id="{C005E19B-9D08-4C8C-B269-1012ED02258C}"/>
                    </a:ext>
                  </a:extLst>
                </p:cNvPr>
                <p:cNvSpPr/>
                <p:nvPr/>
              </p:nvSpPr>
              <p:spPr>
                <a:xfrm rot="2567737">
                  <a:off x="5805649" y="1296317"/>
                  <a:ext cx="284377" cy="358107"/>
                </a:xfrm>
                <a:custGeom>
                  <a:avLst/>
                  <a:gdLst>
                    <a:gd name="connsiteX0" fmla="*/ 7144 w 265004"/>
                    <a:gd name="connsiteY0" fmla="*/ 62065 h 333711"/>
                    <a:gd name="connsiteX1" fmla="*/ 35719 w 265004"/>
                    <a:gd name="connsiteY1" fmla="*/ 309715 h 333711"/>
                    <a:gd name="connsiteX2" fmla="*/ 264319 w 265004"/>
                    <a:gd name="connsiteY2" fmla="*/ 290665 h 333711"/>
                    <a:gd name="connsiteX3" fmla="*/ 102394 w 265004"/>
                    <a:gd name="connsiteY3" fmla="*/ 14440 h 333711"/>
                    <a:gd name="connsiteX4" fmla="*/ 7144 w 265004"/>
                    <a:gd name="connsiteY4" fmla="*/ 62065 h 33371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265004" h="333711">
                      <a:moveTo>
                        <a:pt x="7144" y="62065"/>
                      </a:moveTo>
                      <a:cubicBezTo>
                        <a:pt x="-3968" y="111277"/>
                        <a:pt x="-7143" y="271615"/>
                        <a:pt x="35719" y="309715"/>
                      </a:cubicBezTo>
                      <a:cubicBezTo>
                        <a:pt x="78581" y="347815"/>
                        <a:pt x="253207" y="339877"/>
                        <a:pt x="264319" y="290665"/>
                      </a:cubicBezTo>
                      <a:cubicBezTo>
                        <a:pt x="275431" y="241453"/>
                        <a:pt x="148431" y="49365"/>
                        <a:pt x="102394" y="14440"/>
                      </a:cubicBezTo>
                      <a:cubicBezTo>
                        <a:pt x="56357" y="-20485"/>
                        <a:pt x="18256" y="12853"/>
                        <a:pt x="7144" y="62065"/>
                      </a:cubicBezTo>
                      <a:close/>
                    </a:path>
                  </a:pathLst>
                </a:custGeom>
                <a:solidFill>
                  <a:srgbClr val="C00000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" name="Forme libre : forme 24">
                  <a:extLst>
                    <a:ext uri="{FF2B5EF4-FFF2-40B4-BE49-F238E27FC236}">
                      <a16:creationId xmlns:a16="http://schemas.microsoft.com/office/drawing/2014/main" xmlns="" id="{CC7B4E10-67CB-4CAF-B0E7-99948739AC81}"/>
                    </a:ext>
                  </a:extLst>
                </p:cNvPr>
                <p:cNvSpPr/>
                <p:nvPr/>
              </p:nvSpPr>
              <p:spPr>
                <a:xfrm rot="4371748">
                  <a:off x="5660685" y="1637478"/>
                  <a:ext cx="265004" cy="333711"/>
                </a:xfrm>
                <a:custGeom>
                  <a:avLst/>
                  <a:gdLst>
                    <a:gd name="connsiteX0" fmla="*/ 7144 w 265004"/>
                    <a:gd name="connsiteY0" fmla="*/ 62065 h 333711"/>
                    <a:gd name="connsiteX1" fmla="*/ 35719 w 265004"/>
                    <a:gd name="connsiteY1" fmla="*/ 309715 h 333711"/>
                    <a:gd name="connsiteX2" fmla="*/ 264319 w 265004"/>
                    <a:gd name="connsiteY2" fmla="*/ 290665 h 333711"/>
                    <a:gd name="connsiteX3" fmla="*/ 102394 w 265004"/>
                    <a:gd name="connsiteY3" fmla="*/ 14440 h 333711"/>
                    <a:gd name="connsiteX4" fmla="*/ 7144 w 265004"/>
                    <a:gd name="connsiteY4" fmla="*/ 62065 h 33371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265004" h="333711">
                      <a:moveTo>
                        <a:pt x="7144" y="62065"/>
                      </a:moveTo>
                      <a:cubicBezTo>
                        <a:pt x="-3968" y="111277"/>
                        <a:pt x="-7143" y="271615"/>
                        <a:pt x="35719" y="309715"/>
                      </a:cubicBezTo>
                      <a:cubicBezTo>
                        <a:pt x="78581" y="347815"/>
                        <a:pt x="253207" y="339877"/>
                        <a:pt x="264319" y="290665"/>
                      </a:cubicBezTo>
                      <a:cubicBezTo>
                        <a:pt x="275431" y="241453"/>
                        <a:pt x="148431" y="49365"/>
                        <a:pt x="102394" y="14440"/>
                      </a:cubicBezTo>
                      <a:cubicBezTo>
                        <a:pt x="56357" y="-20485"/>
                        <a:pt x="18256" y="12853"/>
                        <a:pt x="7144" y="62065"/>
                      </a:cubicBezTo>
                      <a:close/>
                    </a:path>
                  </a:pathLst>
                </a:custGeom>
                <a:solidFill>
                  <a:srgbClr val="C00000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1" name="Groupe 20">
                <a:extLst>
                  <a:ext uri="{FF2B5EF4-FFF2-40B4-BE49-F238E27FC236}">
                    <a16:creationId xmlns:a16="http://schemas.microsoft.com/office/drawing/2014/main" xmlns="" id="{6A840D80-8C55-41D1-B1D8-A6B29F5CE43E}"/>
                  </a:ext>
                </a:extLst>
              </p:cNvPr>
              <p:cNvGrpSpPr/>
              <p:nvPr/>
            </p:nvGrpSpPr>
            <p:grpSpPr>
              <a:xfrm>
                <a:off x="5090567" y="554352"/>
                <a:ext cx="879431" cy="1447479"/>
                <a:chOff x="5090567" y="554352"/>
                <a:chExt cx="879431" cy="1447479"/>
              </a:xfrm>
              <a:solidFill>
                <a:srgbClr val="FFCC66"/>
              </a:solidFill>
              <a:effectLst/>
            </p:grpSpPr>
            <p:sp>
              <p:nvSpPr>
                <p:cNvPr id="11" name="Forme libre : forme 10">
                  <a:extLst>
                    <a:ext uri="{FF2B5EF4-FFF2-40B4-BE49-F238E27FC236}">
                      <a16:creationId xmlns:a16="http://schemas.microsoft.com/office/drawing/2014/main" xmlns="" id="{8963CB43-4C51-416C-95DA-01C86EBD6AED}"/>
                    </a:ext>
                  </a:extLst>
                </p:cNvPr>
                <p:cNvSpPr/>
                <p:nvPr/>
              </p:nvSpPr>
              <p:spPr>
                <a:xfrm rot="20535609">
                  <a:off x="5090567" y="1582894"/>
                  <a:ext cx="458706" cy="418937"/>
                </a:xfrm>
                <a:custGeom>
                  <a:avLst/>
                  <a:gdLst>
                    <a:gd name="connsiteX0" fmla="*/ 52083 w 458706"/>
                    <a:gd name="connsiteY0" fmla="*/ 94870 h 418937"/>
                    <a:gd name="connsiteX1" fmla="*/ 23508 w 458706"/>
                    <a:gd name="connsiteY1" fmla="*/ 294895 h 418937"/>
                    <a:gd name="connsiteX2" fmla="*/ 233058 w 458706"/>
                    <a:gd name="connsiteY2" fmla="*/ 418720 h 418937"/>
                    <a:gd name="connsiteX3" fmla="*/ 375933 w 458706"/>
                    <a:gd name="connsiteY3" fmla="*/ 266320 h 418937"/>
                    <a:gd name="connsiteX4" fmla="*/ 442608 w 458706"/>
                    <a:gd name="connsiteY4" fmla="*/ 9145 h 418937"/>
                    <a:gd name="connsiteX5" fmla="*/ 52083 w 458706"/>
                    <a:gd name="connsiteY5" fmla="*/ 94870 h 41893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458706" h="418937">
                      <a:moveTo>
                        <a:pt x="52083" y="94870"/>
                      </a:moveTo>
                      <a:cubicBezTo>
                        <a:pt x="-17767" y="142495"/>
                        <a:pt x="-6655" y="240920"/>
                        <a:pt x="23508" y="294895"/>
                      </a:cubicBezTo>
                      <a:cubicBezTo>
                        <a:pt x="53671" y="348870"/>
                        <a:pt x="174321" y="423483"/>
                        <a:pt x="233058" y="418720"/>
                      </a:cubicBezTo>
                      <a:cubicBezTo>
                        <a:pt x="291796" y="413958"/>
                        <a:pt x="341008" y="334583"/>
                        <a:pt x="375933" y="266320"/>
                      </a:cubicBezTo>
                      <a:cubicBezTo>
                        <a:pt x="410858" y="198057"/>
                        <a:pt x="493408" y="44070"/>
                        <a:pt x="442608" y="9145"/>
                      </a:cubicBezTo>
                      <a:cubicBezTo>
                        <a:pt x="391808" y="-25780"/>
                        <a:pt x="121933" y="47245"/>
                        <a:pt x="52083" y="94870"/>
                      </a:cubicBezTo>
                      <a:close/>
                    </a:path>
                  </a:pathLst>
                </a:custGeom>
                <a:solidFill>
                  <a:srgbClr val="FFC000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5" name="Groupe 14">
                  <a:extLst>
                    <a:ext uri="{FF2B5EF4-FFF2-40B4-BE49-F238E27FC236}">
                      <a16:creationId xmlns:a16="http://schemas.microsoft.com/office/drawing/2014/main" xmlns="" id="{6A2BCDB1-5638-473E-A897-DE95C8CFC17F}"/>
                    </a:ext>
                  </a:extLst>
                </p:cNvPr>
                <p:cNvGrpSpPr/>
                <p:nvPr/>
              </p:nvGrpSpPr>
              <p:grpSpPr>
                <a:xfrm>
                  <a:off x="5369793" y="554352"/>
                  <a:ext cx="600205" cy="1329071"/>
                  <a:chOff x="5369793" y="554352"/>
                  <a:chExt cx="600205" cy="1329071"/>
                </a:xfrm>
                <a:grpFill/>
              </p:grpSpPr>
              <p:sp>
                <p:nvSpPr>
                  <p:cNvPr id="17" name="Forme libre : forme 16">
                    <a:extLst>
                      <a:ext uri="{FF2B5EF4-FFF2-40B4-BE49-F238E27FC236}">
                        <a16:creationId xmlns:a16="http://schemas.microsoft.com/office/drawing/2014/main" xmlns="" id="{3A2D7530-CB4A-4FDD-B1A2-BF55448B4540}"/>
                      </a:ext>
                    </a:extLst>
                  </p:cNvPr>
                  <p:cNvSpPr/>
                  <p:nvPr/>
                </p:nvSpPr>
                <p:spPr>
                  <a:xfrm rot="19604041">
                    <a:off x="5456968" y="1464486"/>
                    <a:ext cx="458706" cy="418937"/>
                  </a:xfrm>
                  <a:custGeom>
                    <a:avLst/>
                    <a:gdLst>
                      <a:gd name="connsiteX0" fmla="*/ 52083 w 458706"/>
                      <a:gd name="connsiteY0" fmla="*/ 94870 h 418937"/>
                      <a:gd name="connsiteX1" fmla="*/ 23508 w 458706"/>
                      <a:gd name="connsiteY1" fmla="*/ 294895 h 418937"/>
                      <a:gd name="connsiteX2" fmla="*/ 233058 w 458706"/>
                      <a:gd name="connsiteY2" fmla="*/ 418720 h 418937"/>
                      <a:gd name="connsiteX3" fmla="*/ 375933 w 458706"/>
                      <a:gd name="connsiteY3" fmla="*/ 266320 h 418937"/>
                      <a:gd name="connsiteX4" fmla="*/ 442608 w 458706"/>
                      <a:gd name="connsiteY4" fmla="*/ 9145 h 418937"/>
                      <a:gd name="connsiteX5" fmla="*/ 52083 w 458706"/>
                      <a:gd name="connsiteY5" fmla="*/ 94870 h 418937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</a:cxnLst>
                    <a:rect l="l" t="t" r="r" b="b"/>
                    <a:pathLst>
                      <a:path w="458706" h="418937">
                        <a:moveTo>
                          <a:pt x="52083" y="94870"/>
                        </a:moveTo>
                        <a:cubicBezTo>
                          <a:pt x="-17767" y="142495"/>
                          <a:pt x="-6655" y="240920"/>
                          <a:pt x="23508" y="294895"/>
                        </a:cubicBezTo>
                        <a:cubicBezTo>
                          <a:pt x="53671" y="348870"/>
                          <a:pt x="174321" y="423483"/>
                          <a:pt x="233058" y="418720"/>
                        </a:cubicBezTo>
                        <a:cubicBezTo>
                          <a:pt x="291796" y="413958"/>
                          <a:pt x="341008" y="334583"/>
                          <a:pt x="375933" y="266320"/>
                        </a:cubicBezTo>
                        <a:cubicBezTo>
                          <a:pt x="410858" y="198057"/>
                          <a:pt x="493408" y="44070"/>
                          <a:pt x="442608" y="9145"/>
                        </a:cubicBezTo>
                        <a:cubicBezTo>
                          <a:pt x="391808" y="-25780"/>
                          <a:pt x="121933" y="47245"/>
                          <a:pt x="52083" y="94870"/>
                        </a:cubicBezTo>
                        <a:close/>
                      </a:path>
                    </a:pathLst>
                  </a:custGeom>
                  <a:solidFill>
                    <a:srgbClr val="FFC000"/>
                  </a:solidFill>
                  <a:ln>
                    <a:solidFill>
                      <a:schemeClr val="bg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12" name="Groupe 11">
                    <a:extLst>
                      <a:ext uri="{FF2B5EF4-FFF2-40B4-BE49-F238E27FC236}">
                        <a16:creationId xmlns:a16="http://schemas.microsoft.com/office/drawing/2014/main" xmlns="" id="{EB67B1D2-9B8E-459C-8342-20298730378B}"/>
                      </a:ext>
                    </a:extLst>
                  </p:cNvPr>
                  <p:cNvGrpSpPr/>
                  <p:nvPr/>
                </p:nvGrpSpPr>
                <p:grpSpPr>
                  <a:xfrm rot="15038602">
                    <a:off x="5257942" y="666203"/>
                    <a:ext cx="823907" cy="600205"/>
                    <a:chOff x="6190291" y="2960321"/>
                    <a:chExt cx="823907" cy="600205"/>
                  </a:xfrm>
                  <a:grpFill/>
                </p:grpSpPr>
                <p:sp>
                  <p:nvSpPr>
                    <p:cNvPr id="19" name="Forme libre : forme 18">
                      <a:extLst>
                        <a:ext uri="{FF2B5EF4-FFF2-40B4-BE49-F238E27FC236}">
                          <a16:creationId xmlns:a16="http://schemas.microsoft.com/office/drawing/2014/main" xmlns="" id="{FF66E5FF-76DB-4C66-9868-5E8D4BD8CF1B}"/>
                        </a:ext>
                      </a:extLst>
                    </p:cNvPr>
                    <p:cNvSpPr/>
                    <p:nvPr/>
                  </p:nvSpPr>
                  <p:spPr>
                    <a:xfrm rot="14893567">
                      <a:off x="6170407" y="3121704"/>
                      <a:ext cx="458706" cy="418937"/>
                    </a:xfrm>
                    <a:custGeom>
                      <a:avLst/>
                      <a:gdLst>
                        <a:gd name="connsiteX0" fmla="*/ 52083 w 458706"/>
                        <a:gd name="connsiteY0" fmla="*/ 94870 h 418937"/>
                        <a:gd name="connsiteX1" fmla="*/ 23508 w 458706"/>
                        <a:gd name="connsiteY1" fmla="*/ 294895 h 418937"/>
                        <a:gd name="connsiteX2" fmla="*/ 233058 w 458706"/>
                        <a:gd name="connsiteY2" fmla="*/ 418720 h 418937"/>
                        <a:gd name="connsiteX3" fmla="*/ 375933 w 458706"/>
                        <a:gd name="connsiteY3" fmla="*/ 266320 h 418937"/>
                        <a:gd name="connsiteX4" fmla="*/ 442608 w 458706"/>
                        <a:gd name="connsiteY4" fmla="*/ 9145 h 418937"/>
                        <a:gd name="connsiteX5" fmla="*/ 52083 w 458706"/>
                        <a:gd name="connsiteY5" fmla="*/ 94870 h 418937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</a:cxnLst>
                      <a:rect l="l" t="t" r="r" b="b"/>
                      <a:pathLst>
                        <a:path w="458706" h="418937">
                          <a:moveTo>
                            <a:pt x="52083" y="94870"/>
                          </a:moveTo>
                          <a:cubicBezTo>
                            <a:pt x="-17767" y="142495"/>
                            <a:pt x="-6655" y="240920"/>
                            <a:pt x="23508" y="294895"/>
                          </a:cubicBezTo>
                          <a:cubicBezTo>
                            <a:pt x="53671" y="348870"/>
                            <a:pt x="174321" y="423483"/>
                            <a:pt x="233058" y="418720"/>
                          </a:cubicBezTo>
                          <a:cubicBezTo>
                            <a:pt x="291796" y="413958"/>
                            <a:pt x="341008" y="334583"/>
                            <a:pt x="375933" y="266320"/>
                          </a:cubicBezTo>
                          <a:cubicBezTo>
                            <a:pt x="410858" y="198057"/>
                            <a:pt x="493408" y="44070"/>
                            <a:pt x="442608" y="9145"/>
                          </a:cubicBezTo>
                          <a:cubicBezTo>
                            <a:pt x="391808" y="-25780"/>
                            <a:pt x="121933" y="47245"/>
                            <a:pt x="52083" y="94870"/>
                          </a:cubicBezTo>
                          <a:close/>
                        </a:path>
                      </a:pathLst>
                    </a:custGeom>
                    <a:solidFill>
                      <a:srgbClr val="FFC000"/>
                    </a:solidFill>
                    <a:ln>
                      <a:solidFill>
                        <a:schemeClr val="bg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0" name="Forme libre : forme 19">
                      <a:extLst>
                        <a:ext uri="{FF2B5EF4-FFF2-40B4-BE49-F238E27FC236}">
                          <a16:creationId xmlns:a16="http://schemas.microsoft.com/office/drawing/2014/main" xmlns="" id="{0FD0CF8C-4212-492B-9B08-ABD6A19169DC}"/>
                        </a:ext>
                      </a:extLst>
                    </p:cNvPr>
                    <p:cNvSpPr/>
                    <p:nvPr/>
                  </p:nvSpPr>
                  <p:spPr>
                    <a:xfrm rot="12986360">
                      <a:off x="6555492" y="2960321"/>
                      <a:ext cx="458706" cy="418937"/>
                    </a:xfrm>
                    <a:custGeom>
                      <a:avLst/>
                      <a:gdLst>
                        <a:gd name="connsiteX0" fmla="*/ 52083 w 458706"/>
                        <a:gd name="connsiteY0" fmla="*/ 94870 h 418937"/>
                        <a:gd name="connsiteX1" fmla="*/ 23508 w 458706"/>
                        <a:gd name="connsiteY1" fmla="*/ 294895 h 418937"/>
                        <a:gd name="connsiteX2" fmla="*/ 233058 w 458706"/>
                        <a:gd name="connsiteY2" fmla="*/ 418720 h 418937"/>
                        <a:gd name="connsiteX3" fmla="*/ 375933 w 458706"/>
                        <a:gd name="connsiteY3" fmla="*/ 266320 h 418937"/>
                        <a:gd name="connsiteX4" fmla="*/ 442608 w 458706"/>
                        <a:gd name="connsiteY4" fmla="*/ 9145 h 418937"/>
                        <a:gd name="connsiteX5" fmla="*/ 52083 w 458706"/>
                        <a:gd name="connsiteY5" fmla="*/ 94870 h 418937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</a:cxnLst>
                      <a:rect l="l" t="t" r="r" b="b"/>
                      <a:pathLst>
                        <a:path w="458706" h="418937">
                          <a:moveTo>
                            <a:pt x="52083" y="94870"/>
                          </a:moveTo>
                          <a:cubicBezTo>
                            <a:pt x="-17767" y="142495"/>
                            <a:pt x="-6655" y="240920"/>
                            <a:pt x="23508" y="294895"/>
                          </a:cubicBezTo>
                          <a:cubicBezTo>
                            <a:pt x="53671" y="348870"/>
                            <a:pt x="174321" y="423483"/>
                            <a:pt x="233058" y="418720"/>
                          </a:cubicBezTo>
                          <a:cubicBezTo>
                            <a:pt x="291796" y="413958"/>
                            <a:pt x="341008" y="334583"/>
                            <a:pt x="375933" y="266320"/>
                          </a:cubicBezTo>
                          <a:cubicBezTo>
                            <a:pt x="410858" y="198057"/>
                            <a:pt x="493408" y="44070"/>
                            <a:pt x="442608" y="9145"/>
                          </a:cubicBezTo>
                          <a:cubicBezTo>
                            <a:pt x="391808" y="-25780"/>
                            <a:pt x="121933" y="47245"/>
                            <a:pt x="52083" y="94870"/>
                          </a:cubicBezTo>
                          <a:close/>
                        </a:path>
                      </a:pathLst>
                    </a:custGeom>
                    <a:solidFill>
                      <a:srgbClr val="FFC000"/>
                    </a:solidFill>
                    <a:ln>
                      <a:solidFill>
                        <a:schemeClr val="bg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</p:grpSp>
          <p:grpSp>
            <p:nvGrpSpPr>
              <p:cNvPr id="30" name="Groupe 29">
                <a:extLst>
                  <a:ext uri="{FF2B5EF4-FFF2-40B4-BE49-F238E27FC236}">
                    <a16:creationId xmlns:a16="http://schemas.microsoft.com/office/drawing/2014/main" xmlns="" id="{FA108869-23F5-403A-B7AE-72731CD9D296}"/>
                  </a:ext>
                </a:extLst>
              </p:cNvPr>
              <p:cNvGrpSpPr/>
              <p:nvPr/>
            </p:nvGrpSpPr>
            <p:grpSpPr>
              <a:xfrm>
                <a:off x="4850737" y="838394"/>
                <a:ext cx="1002274" cy="855416"/>
                <a:chOff x="4806982" y="850826"/>
                <a:chExt cx="935959" cy="798818"/>
              </a:xfrm>
              <a:effectLst/>
            </p:grpSpPr>
            <p:sp>
              <p:nvSpPr>
                <p:cNvPr id="5" name="Ellipse 4">
                  <a:extLst>
                    <a:ext uri="{FF2B5EF4-FFF2-40B4-BE49-F238E27FC236}">
                      <a16:creationId xmlns:a16="http://schemas.microsoft.com/office/drawing/2014/main" xmlns="" id="{21921F76-B615-4F35-A2AA-2DB1BC462A28}"/>
                    </a:ext>
                  </a:extLst>
                </p:cNvPr>
                <p:cNvSpPr/>
                <p:nvPr/>
              </p:nvSpPr>
              <p:spPr>
                <a:xfrm>
                  <a:off x="4806982" y="850826"/>
                  <a:ext cx="935959" cy="798818"/>
                </a:xfrm>
                <a:prstGeom prst="ellipse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" name="Ellipse 6">
                  <a:extLst>
                    <a:ext uri="{FF2B5EF4-FFF2-40B4-BE49-F238E27FC236}">
                      <a16:creationId xmlns:a16="http://schemas.microsoft.com/office/drawing/2014/main" xmlns="" id="{4BD242E8-6092-4B22-9329-3FA0960D7EEE}"/>
                    </a:ext>
                  </a:extLst>
                </p:cNvPr>
                <p:cNvSpPr/>
                <p:nvPr/>
              </p:nvSpPr>
              <p:spPr>
                <a:xfrm>
                  <a:off x="5090692" y="1095347"/>
                  <a:ext cx="368539" cy="309776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cxnSp>
          <p:nvCxnSpPr>
            <p:cNvPr id="34" name="Connecteur droit 33">
              <a:extLst>
                <a:ext uri="{FF2B5EF4-FFF2-40B4-BE49-F238E27FC236}">
                  <a16:creationId xmlns:a16="http://schemas.microsoft.com/office/drawing/2014/main" xmlns="" id="{A2D5CEE1-43A0-45B5-8C6E-D7394EAD486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978150" y="1807800"/>
              <a:ext cx="439516" cy="0"/>
            </a:xfrm>
            <a:prstGeom prst="line">
              <a:avLst/>
            </a:prstGeom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ZoneTexte 34">
              <a:extLst>
                <a:ext uri="{FF2B5EF4-FFF2-40B4-BE49-F238E27FC236}">
                  <a16:creationId xmlns:a16="http://schemas.microsoft.com/office/drawing/2014/main" xmlns="" id="{6E0EDECD-B789-4AFE-8599-1A3ABF591C77}"/>
                </a:ext>
              </a:extLst>
            </p:cNvPr>
            <p:cNvSpPr txBox="1"/>
            <p:nvPr/>
          </p:nvSpPr>
          <p:spPr>
            <a:xfrm>
              <a:off x="1890540" y="1539602"/>
              <a:ext cx="1119643" cy="6223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ORE</a:t>
              </a:r>
            </a:p>
            <a:p>
              <a:pPr algn="r"/>
              <a:r>
                <a:rPr lang="fr-FR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FlaB</a:t>
              </a:r>
              <a:endParaRPr lang="fr-FR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fr-FR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FlaB1,FlaB2,</a:t>
              </a:r>
            </a:p>
            <a:p>
              <a:pPr algn="r"/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FlaB3,FlaB3</a:t>
              </a:r>
            </a:p>
          </p:txBody>
        </p:sp>
        <p:cxnSp>
          <p:nvCxnSpPr>
            <p:cNvPr id="39" name="Connecteur droit 38">
              <a:extLst>
                <a:ext uri="{FF2B5EF4-FFF2-40B4-BE49-F238E27FC236}">
                  <a16:creationId xmlns:a16="http://schemas.microsoft.com/office/drawing/2014/main" xmlns="" id="{AFE5439A-1604-4B52-9F50-362076F7F7DC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492060" y="1416133"/>
              <a:ext cx="1114268" cy="6438"/>
            </a:xfrm>
            <a:prstGeom prst="line">
              <a:avLst/>
            </a:prstGeom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ZoneTexte 39">
              <a:extLst>
                <a:ext uri="{FF2B5EF4-FFF2-40B4-BE49-F238E27FC236}">
                  <a16:creationId xmlns:a16="http://schemas.microsoft.com/office/drawing/2014/main" xmlns="" id="{5C16D34E-5ACF-4B3E-94EE-C3FE53D0A908}"/>
                </a:ext>
              </a:extLst>
            </p:cNvPr>
            <p:cNvSpPr txBox="1"/>
            <p:nvPr/>
          </p:nvSpPr>
          <p:spPr>
            <a:xfrm>
              <a:off x="4579228" y="1141981"/>
              <a:ext cx="1447069" cy="10029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SHEATH</a:t>
              </a:r>
            </a:p>
            <a:p>
              <a:pPr algn="ctr"/>
              <a:endParaRPr lang="fr-FR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FR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FlaA</a:t>
              </a:r>
              <a:r>
                <a:rPr lang="fr-F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FlaA1, FlaA2</a:t>
              </a:r>
            </a:p>
            <a:p>
              <a:endParaRPr lang="fr-FR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fr-FR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FR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FcpA</a:t>
              </a:r>
              <a:endParaRPr lang="fr-FR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fr-FR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FR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FcpB</a:t>
              </a:r>
              <a:endParaRPr lang="fr-FR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5" name="Connecteur droit 44">
              <a:extLst>
                <a:ext uri="{FF2B5EF4-FFF2-40B4-BE49-F238E27FC236}">
                  <a16:creationId xmlns:a16="http://schemas.microsoft.com/office/drawing/2014/main" xmlns="" id="{8B8E9392-75B3-4134-A1D9-0A5801032C8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119496" y="1694591"/>
              <a:ext cx="483412" cy="113778"/>
            </a:xfrm>
            <a:prstGeom prst="line">
              <a:avLst/>
            </a:prstGeom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Connecteur droit 52">
              <a:extLst>
                <a:ext uri="{FF2B5EF4-FFF2-40B4-BE49-F238E27FC236}">
                  <a16:creationId xmlns:a16="http://schemas.microsoft.com/office/drawing/2014/main" xmlns="" id="{CF3E74E1-0CCD-4B10-BE3E-883621976F6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63073" y="2054014"/>
              <a:ext cx="442042" cy="0"/>
            </a:xfrm>
            <a:prstGeom prst="line">
              <a:avLst/>
            </a:prstGeom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0" name="Groupe 49">
            <a:extLst>
              <a:ext uri="{FF2B5EF4-FFF2-40B4-BE49-F238E27FC236}">
                <a16:creationId xmlns:a16="http://schemas.microsoft.com/office/drawing/2014/main" xmlns="" id="{68F8CB14-7054-4D7D-BCCC-BDD77487390E}"/>
              </a:ext>
            </a:extLst>
          </p:cNvPr>
          <p:cNvGrpSpPr/>
          <p:nvPr/>
        </p:nvGrpSpPr>
        <p:grpSpPr>
          <a:xfrm flipH="1">
            <a:off x="5486860" y="1141605"/>
            <a:ext cx="431770" cy="978503"/>
            <a:chOff x="5895742" y="1125764"/>
            <a:chExt cx="431770" cy="978503"/>
          </a:xfrm>
        </p:grpSpPr>
        <p:sp>
          <p:nvSpPr>
            <p:cNvPr id="51" name="Forme libre : forme 50">
              <a:extLst>
                <a:ext uri="{FF2B5EF4-FFF2-40B4-BE49-F238E27FC236}">
                  <a16:creationId xmlns:a16="http://schemas.microsoft.com/office/drawing/2014/main" xmlns="" id="{00B40D89-B06A-4E20-8EC9-977E0B459CB1}"/>
                </a:ext>
              </a:extLst>
            </p:cNvPr>
            <p:cNvSpPr/>
            <p:nvPr/>
          </p:nvSpPr>
          <p:spPr>
            <a:xfrm rot="2325573" flipH="1">
              <a:off x="6037485" y="1125764"/>
              <a:ext cx="279809" cy="517683"/>
            </a:xfrm>
            <a:custGeom>
              <a:avLst/>
              <a:gdLst>
                <a:gd name="connsiteX0" fmla="*/ 62304 w 379300"/>
                <a:gd name="connsiteY0" fmla="*/ 785593 h 805215"/>
                <a:gd name="connsiteX1" fmla="*/ 57542 w 379300"/>
                <a:gd name="connsiteY1" fmla="*/ 566518 h 805215"/>
                <a:gd name="connsiteX2" fmla="*/ 9917 w 379300"/>
                <a:gd name="connsiteY2" fmla="*/ 185518 h 805215"/>
                <a:gd name="connsiteX3" fmla="*/ 276617 w 379300"/>
                <a:gd name="connsiteY3" fmla="*/ 4543 h 805215"/>
                <a:gd name="connsiteX4" fmla="*/ 348054 w 379300"/>
                <a:gd name="connsiteY4" fmla="*/ 71218 h 805215"/>
                <a:gd name="connsiteX5" fmla="*/ 333767 w 379300"/>
                <a:gd name="connsiteY5" fmla="*/ 252193 h 805215"/>
                <a:gd name="connsiteX6" fmla="*/ 376629 w 379300"/>
                <a:gd name="connsiteY6" fmla="*/ 447456 h 805215"/>
                <a:gd name="connsiteX7" fmla="*/ 371867 w 379300"/>
                <a:gd name="connsiteY7" fmla="*/ 614143 h 805215"/>
                <a:gd name="connsiteX8" fmla="*/ 348054 w 379300"/>
                <a:gd name="connsiteY8" fmla="*/ 699868 h 805215"/>
                <a:gd name="connsiteX9" fmla="*/ 324242 w 379300"/>
                <a:gd name="connsiteY9" fmla="*/ 790356 h 805215"/>
                <a:gd name="connsiteX10" fmla="*/ 62304 w 379300"/>
                <a:gd name="connsiteY10" fmla="*/ 785593 h 805215"/>
                <a:gd name="connsiteX0" fmla="*/ 62304 w 378253"/>
                <a:gd name="connsiteY0" fmla="*/ 789101 h 808723"/>
                <a:gd name="connsiteX1" fmla="*/ 57542 w 378253"/>
                <a:gd name="connsiteY1" fmla="*/ 570026 h 808723"/>
                <a:gd name="connsiteX2" fmla="*/ 9917 w 378253"/>
                <a:gd name="connsiteY2" fmla="*/ 189026 h 808723"/>
                <a:gd name="connsiteX3" fmla="*/ 276617 w 378253"/>
                <a:gd name="connsiteY3" fmla="*/ 8051 h 808723"/>
                <a:gd name="connsiteX4" fmla="*/ 348054 w 378253"/>
                <a:gd name="connsiteY4" fmla="*/ 74726 h 808723"/>
                <a:gd name="connsiteX5" fmla="*/ 376629 w 378253"/>
                <a:gd name="connsiteY5" fmla="*/ 450964 h 808723"/>
                <a:gd name="connsiteX6" fmla="*/ 371867 w 378253"/>
                <a:gd name="connsiteY6" fmla="*/ 617651 h 808723"/>
                <a:gd name="connsiteX7" fmla="*/ 348054 w 378253"/>
                <a:gd name="connsiteY7" fmla="*/ 703376 h 808723"/>
                <a:gd name="connsiteX8" fmla="*/ 324242 w 378253"/>
                <a:gd name="connsiteY8" fmla="*/ 793864 h 808723"/>
                <a:gd name="connsiteX9" fmla="*/ 62304 w 378253"/>
                <a:gd name="connsiteY9" fmla="*/ 789101 h 808723"/>
                <a:gd name="connsiteX0" fmla="*/ 62304 w 379182"/>
                <a:gd name="connsiteY0" fmla="*/ 789101 h 816188"/>
                <a:gd name="connsiteX1" fmla="*/ 57542 w 379182"/>
                <a:gd name="connsiteY1" fmla="*/ 570026 h 816188"/>
                <a:gd name="connsiteX2" fmla="*/ 9917 w 379182"/>
                <a:gd name="connsiteY2" fmla="*/ 189026 h 816188"/>
                <a:gd name="connsiteX3" fmla="*/ 276617 w 379182"/>
                <a:gd name="connsiteY3" fmla="*/ 8051 h 816188"/>
                <a:gd name="connsiteX4" fmla="*/ 348054 w 379182"/>
                <a:gd name="connsiteY4" fmla="*/ 74726 h 816188"/>
                <a:gd name="connsiteX5" fmla="*/ 376629 w 379182"/>
                <a:gd name="connsiteY5" fmla="*/ 450964 h 816188"/>
                <a:gd name="connsiteX6" fmla="*/ 371867 w 379182"/>
                <a:gd name="connsiteY6" fmla="*/ 617651 h 816188"/>
                <a:gd name="connsiteX7" fmla="*/ 324242 w 379182"/>
                <a:gd name="connsiteY7" fmla="*/ 793864 h 816188"/>
                <a:gd name="connsiteX8" fmla="*/ 62304 w 379182"/>
                <a:gd name="connsiteY8" fmla="*/ 789101 h 8161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379182" h="816188">
                  <a:moveTo>
                    <a:pt x="62304" y="789101"/>
                  </a:moveTo>
                  <a:cubicBezTo>
                    <a:pt x="17854" y="751795"/>
                    <a:pt x="66273" y="670038"/>
                    <a:pt x="57542" y="570026"/>
                  </a:cubicBezTo>
                  <a:cubicBezTo>
                    <a:pt x="48811" y="470013"/>
                    <a:pt x="-26595" y="282688"/>
                    <a:pt x="9917" y="189026"/>
                  </a:cubicBezTo>
                  <a:cubicBezTo>
                    <a:pt x="46429" y="95364"/>
                    <a:pt x="220261" y="27101"/>
                    <a:pt x="276617" y="8051"/>
                  </a:cubicBezTo>
                  <a:cubicBezTo>
                    <a:pt x="332973" y="-10999"/>
                    <a:pt x="331385" y="907"/>
                    <a:pt x="348054" y="74726"/>
                  </a:cubicBezTo>
                  <a:cubicBezTo>
                    <a:pt x="364723" y="148545"/>
                    <a:pt x="372660" y="360477"/>
                    <a:pt x="376629" y="450964"/>
                  </a:cubicBezTo>
                  <a:cubicBezTo>
                    <a:pt x="380598" y="541451"/>
                    <a:pt x="380598" y="560501"/>
                    <a:pt x="371867" y="617651"/>
                  </a:cubicBezTo>
                  <a:cubicBezTo>
                    <a:pt x="363136" y="674801"/>
                    <a:pt x="375836" y="765289"/>
                    <a:pt x="324242" y="793864"/>
                  </a:cubicBezTo>
                  <a:cubicBezTo>
                    <a:pt x="272648" y="822439"/>
                    <a:pt x="106754" y="826407"/>
                    <a:pt x="62304" y="789101"/>
                  </a:cubicBezTo>
                  <a:close/>
                </a:path>
              </a:pathLst>
            </a:custGeom>
            <a:solidFill>
              <a:srgbClr val="A6A6A6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52" name="Forme libre : forme 51">
              <a:extLst>
                <a:ext uri="{FF2B5EF4-FFF2-40B4-BE49-F238E27FC236}">
                  <a16:creationId xmlns:a16="http://schemas.microsoft.com/office/drawing/2014/main" xmlns="" id="{674E9017-8962-43FF-8480-F98AA27AF08D}"/>
                </a:ext>
              </a:extLst>
            </p:cNvPr>
            <p:cNvSpPr/>
            <p:nvPr/>
          </p:nvSpPr>
          <p:spPr>
            <a:xfrm rot="339379" flipH="1">
              <a:off x="5895742" y="1500975"/>
              <a:ext cx="431770" cy="603292"/>
            </a:xfrm>
            <a:custGeom>
              <a:avLst/>
              <a:gdLst>
                <a:gd name="connsiteX0" fmla="*/ 106968 w 592856"/>
                <a:gd name="connsiteY0" fmla="*/ 650916 h 685860"/>
                <a:gd name="connsiteX1" fmla="*/ 249843 w 592856"/>
                <a:gd name="connsiteY1" fmla="*/ 536616 h 685860"/>
                <a:gd name="connsiteX2" fmla="*/ 364143 w 592856"/>
                <a:gd name="connsiteY2" fmla="*/ 417553 h 685860"/>
                <a:gd name="connsiteX3" fmla="*/ 592743 w 592856"/>
                <a:gd name="connsiteY3" fmla="*/ 31791 h 685860"/>
                <a:gd name="connsiteX4" fmla="*/ 392718 w 592856"/>
                <a:gd name="connsiteY4" fmla="*/ 27028 h 685860"/>
                <a:gd name="connsiteX5" fmla="*/ 240318 w 592856"/>
                <a:gd name="connsiteY5" fmla="*/ 69891 h 685860"/>
                <a:gd name="connsiteX6" fmla="*/ 54580 w 592856"/>
                <a:gd name="connsiteY6" fmla="*/ 422316 h 685860"/>
                <a:gd name="connsiteX7" fmla="*/ 2193 w 592856"/>
                <a:gd name="connsiteY7" fmla="*/ 669966 h 685860"/>
                <a:gd name="connsiteX8" fmla="*/ 106968 w 592856"/>
                <a:gd name="connsiteY8" fmla="*/ 650916 h 685860"/>
                <a:gd name="connsiteX0" fmla="*/ 106968 w 594286"/>
                <a:gd name="connsiteY0" fmla="*/ 649707 h 684651"/>
                <a:gd name="connsiteX1" fmla="*/ 249843 w 594286"/>
                <a:gd name="connsiteY1" fmla="*/ 535407 h 684651"/>
                <a:gd name="connsiteX2" fmla="*/ 364143 w 594286"/>
                <a:gd name="connsiteY2" fmla="*/ 416344 h 684651"/>
                <a:gd name="connsiteX3" fmla="*/ 592743 w 594286"/>
                <a:gd name="connsiteY3" fmla="*/ 30582 h 684651"/>
                <a:gd name="connsiteX4" fmla="*/ 240318 w 594286"/>
                <a:gd name="connsiteY4" fmla="*/ 68682 h 684651"/>
                <a:gd name="connsiteX5" fmla="*/ 54580 w 594286"/>
                <a:gd name="connsiteY5" fmla="*/ 421107 h 684651"/>
                <a:gd name="connsiteX6" fmla="*/ 2193 w 594286"/>
                <a:gd name="connsiteY6" fmla="*/ 668757 h 684651"/>
                <a:gd name="connsiteX7" fmla="*/ 106968 w 594286"/>
                <a:gd name="connsiteY7" fmla="*/ 649707 h 68465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594286" h="684651">
                  <a:moveTo>
                    <a:pt x="106968" y="649707"/>
                  </a:moveTo>
                  <a:cubicBezTo>
                    <a:pt x="148243" y="627482"/>
                    <a:pt x="206981" y="574301"/>
                    <a:pt x="249843" y="535407"/>
                  </a:cubicBezTo>
                  <a:cubicBezTo>
                    <a:pt x="292705" y="496513"/>
                    <a:pt x="306993" y="500481"/>
                    <a:pt x="364143" y="416344"/>
                  </a:cubicBezTo>
                  <a:cubicBezTo>
                    <a:pt x="421293" y="332207"/>
                    <a:pt x="613381" y="88526"/>
                    <a:pt x="592743" y="30582"/>
                  </a:cubicBezTo>
                  <a:cubicBezTo>
                    <a:pt x="572106" y="-27362"/>
                    <a:pt x="330012" y="3595"/>
                    <a:pt x="240318" y="68682"/>
                  </a:cubicBezTo>
                  <a:cubicBezTo>
                    <a:pt x="183962" y="134563"/>
                    <a:pt x="94267" y="321095"/>
                    <a:pt x="54580" y="421107"/>
                  </a:cubicBezTo>
                  <a:cubicBezTo>
                    <a:pt x="14893" y="521119"/>
                    <a:pt x="-7332" y="633038"/>
                    <a:pt x="2193" y="668757"/>
                  </a:cubicBezTo>
                  <a:cubicBezTo>
                    <a:pt x="11718" y="704476"/>
                    <a:pt x="65693" y="671932"/>
                    <a:pt x="106968" y="649707"/>
                  </a:cubicBezTo>
                  <a:close/>
                </a:path>
              </a:pathLst>
            </a:custGeom>
            <a:solidFill>
              <a:srgbClr val="A6A6A6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</p:grpSp>
      <p:sp>
        <p:nvSpPr>
          <p:cNvPr id="76" name="Forme libre : forme 75">
            <a:extLst>
              <a:ext uri="{FF2B5EF4-FFF2-40B4-BE49-F238E27FC236}">
                <a16:creationId xmlns:a16="http://schemas.microsoft.com/office/drawing/2014/main" xmlns="" id="{94C20D5E-A0D4-4DA9-B4AF-566F23E41E1A}"/>
              </a:ext>
            </a:extLst>
          </p:cNvPr>
          <p:cNvSpPr/>
          <p:nvPr/>
        </p:nvSpPr>
        <p:spPr>
          <a:xfrm>
            <a:off x="5136252" y="1553503"/>
            <a:ext cx="989893" cy="1196025"/>
          </a:xfrm>
          <a:custGeom>
            <a:avLst/>
            <a:gdLst>
              <a:gd name="connsiteX0" fmla="*/ 181262 w 1109760"/>
              <a:gd name="connsiteY0" fmla="*/ 624831 h 1204849"/>
              <a:gd name="connsiteX1" fmla="*/ 403512 w 1109760"/>
              <a:gd name="connsiteY1" fmla="*/ 320031 h 1204849"/>
              <a:gd name="connsiteX2" fmla="*/ 714662 w 1109760"/>
              <a:gd name="connsiteY2" fmla="*/ 281931 h 1204849"/>
              <a:gd name="connsiteX3" fmla="*/ 905162 w 1109760"/>
              <a:gd name="connsiteY3" fmla="*/ 389881 h 1204849"/>
              <a:gd name="connsiteX4" fmla="*/ 898812 w 1109760"/>
              <a:gd name="connsiteY4" fmla="*/ 1107431 h 1204849"/>
              <a:gd name="connsiteX5" fmla="*/ 1051212 w 1109760"/>
              <a:gd name="connsiteY5" fmla="*/ 1113781 h 1204849"/>
              <a:gd name="connsiteX6" fmla="*/ 1102012 w 1109760"/>
              <a:gd name="connsiteY6" fmla="*/ 326381 h 1204849"/>
              <a:gd name="connsiteX7" fmla="*/ 898812 w 1109760"/>
              <a:gd name="connsiteY7" fmla="*/ 78731 h 1204849"/>
              <a:gd name="connsiteX8" fmla="*/ 371762 w 1109760"/>
              <a:gd name="connsiteY8" fmla="*/ 15231 h 1204849"/>
              <a:gd name="connsiteX9" fmla="*/ 16162 w 1109760"/>
              <a:gd name="connsiteY9" fmla="*/ 332731 h 1204849"/>
              <a:gd name="connsiteX10" fmla="*/ 73312 w 1109760"/>
              <a:gd name="connsiteY10" fmla="*/ 574031 h 1204849"/>
              <a:gd name="connsiteX11" fmla="*/ 181262 w 1109760"/>
              <a:gd name="connsiteY11" fmla="*/ 624831 h 1204849"/>
              <a:gd name="connsiteX0" fmla="*/ 181262 w 1109760"/>
              <a:gd name="connsiteY0" fmla="*/ 624831 h 1204849"/>
              <a:gd name="connsiteX1" fmla="*/ 403512 w 1109760"/>
              <a:gd name="connsiteY1" fmla="*/ 320031 h 1204849"/>
              <a:gd name="connsiteX2" fmla="*/ 905162 w 1109760"/>
              <a:gd name="connsiteY2" fmla="*/ 389881 h 1204849"/>
              <a:gd name="connsiteX3" fmla="*/ 898812 w 1109760"/>
              <a:gd name="connsiteY3" fmla="*/ 1107431 h 1204849"/>
              <a:gd name="connsiteX4" fmla="*/ 1051212 w 1109760"/>
              <a:gd name="connsiteY4" fmla="*/ 1113781 h 1204849"/>
              <a:gd name="connsiteX5" fmla="*/ 1102012 w 1109760"/>
              <a:gd name="connsiteY5" fmla="*/ 326381 h 1204849"/>
              <a:gd name="connsiteX6" fmla="*/ 898812 w 1109760"/>
              <a:gd name="connsiteY6" fmla="*/ 78731 h 1204849"/>
              <a:gd name="connsiteX7" fmla="*/ 371762 w 1109760"/>
              <a:gd name="connsiteY7" fmla="*/ 15231 h 1204849"/>
              <a:gd name="connsiteX8" fmla="*/ 16162 w 1109760"/>
              <a:gd name="connsiteY8" fmla="*/ 332731 h 1204849"/>
              <a:gd name="connsiteX9" fmla="*/ 73312 w 1109760"/>
              <a:gd name="connsiteY9" fmla="*/ 574031 h 1204849"/>
              <a:gd name="connsiteX10" fmla="*/ 181262 w 1109760"/>
              <a:gd name="connsiteY10" fmla="*/ 624831 h 1204849"/>
              <a:gd name="connsiteX0" fmla="*/ 181262 w 1109760"/>
              <a:gd name="connsiteY0" fmla="*/ 624831 h 1208005"/>
              <a:gd name="connsiteX1" fmla="*/ 403512 w 1109760"/>
              <a:gd name="connsiteY1" fmla="*/ 320031 h 1208005"/>
              <a:gd name="connsiteX2" fmla="*/ 838487 w 1109760"/>
              <a:gd name="connsiteY2" fmla="*/ 337493 h 1208005"/>
              <a:gd name="connsiteX3" fmla="*/ 898812 w 1109760"/>
              <a:gd name="connsiteY3" fmla="*/ 1107431 h 1208005"/>
              <a:gd name="connsiteX4" fmla="*/ 1051212 w 1109760"/>
              <a:gd name="connsiteY4" fmla="*/ 1113781 h 1208005"/>
              <a:gd name="connsiteX5" fmla="*/ 1102012 w 1109760"/>
              <a:gd name="connsiteY5" fmla="*/ 326381 h 1208005"/>
              <a:gd name="connsiteX6" fmla="*/ 898812 w 1109760"/>
              <a:gd name="connsiteY6" fmla="*/ 78731 h 1208005"/>
              <a:gd name="connsiteX7" fmla="*/ 371762 w 1109760"/>
              <a:gd name="connsiteY7" fmla="*/ 15231 h 1208005"/>
              <a:gd name="connsiteX8" fmla="*/ 16162 w 1109760"/>
              <a:gd name="connsiteY8" fmla="*/ 332731 h 1208005"/>
              <a:gd name="connsiteX9" fmla="*/ 73312 w 1109760"/>
              <a:gd name="connsiteY9" fmla="*/ 574031 h 1208005"/>
              <a:gd name="connsiteX10" fmla="*/ 181262 w 1109760"/>
              <a:gd name="connsiteY10" fmla="*/ 624831 h 1208005"/>
              <a:gd name="connsiteX0" fmla="*/ 181262 w 1109760"/>
              <a:gd name="connsiteY0" fmla="*/ 624831 h 1208005"/>
              <a:gd name="connsiteX1" fmla="*/ 403512 w 1109760"/>
              <a:gd name="connsiteY1" fmla="*/ 320031 h 1208005"/>
              <a:gd name="connsiteX2" fmla="*/ 838487 w 1109760"/>
              <a:gd name="connsiteY2" fmla="*/ 337493 h 1208005"/>
              <a:gd name="connsiteX3" fmla="*/ 898812 w 1109760"/>
              <a:gd name="connsiteY3" fmla="*/ 1107431 h 1208005"/>
              <a:gd name="connsiteX4" fmla="*/ 1051212 w 1109760"/>
              <a:gd name="connsiteY4" fmla="*/ 1113781 h 1208005"/>
              <a:gd name="connsiteX5" fmla="*/ 1102012 w 1109760"/>
              <a:gd name="connsiteY5" fmla="*/ 326381 h 1208005"/>
              <a:gd name="connsiteX6" fmla="*/ 898812 w 1109760"/>
              <a:gd name="connsiteY6" fmla="*/ 78731 h 1208005"/>
              <a:gd name="connsiteX7" fmla="*/ 371762 w 1109760"/>
              <a:gd name="connsiteY7" fmla="*/ 15231 h 1208005"/>
              <a:gd name="connsiteX8" fmla="*/ 16162 w 1109760"/>
              <a:gd name="connsiteY8" fmla="*/ 332731 h 1208005"/>
              <a:gd name="connsiteX9" fmla="*/ 73312 w 1109760"/>
              <a:gd name="connsiteY9" fmla="*/ 574031 h 1208005"/>
              <a:gd name="connsiteX10" fmla="*/ 181262 w 1109760"/>
              <a:gd name="connsiteY10" fmla="*/ 624831 h 1208005"/>
              <a:gd name="connsiteX0" fmla="*/ 181262 w 1109760"/>
              <a:gd name="connsiteY0" fmla="*/ 624831 h 1206850"/>
              <a:gd name="connsiteX1" fmla="*/ 403512 w 1109760"/>
              <a:gd name="connsiteY1" fmla="*/ 320031 h 1206850"/>
              <a:gd name="connsiteX2" fmla="*/ 876587 w 1109760"/>
              <a:gd name="connsiteY2" fmla="*/ 356543 h 1206850"/>
              <a:gd name="connsiteX3" fmla="*/ 898812 w 1109760"/>
              <a:gd name="connsiteY3" fmla="*/ 1107431 h 1206850"/>
              <a:gd name="connsiteX4" fmla="*/ 1051212 w 1109760"/>
              <a:gd name="connsiteY4" fmla="*/ 1113781 h 1206850"/>
              <a:gd name="connsiteX5" fmla="*/ 1102012 w 1109760"/>
              <a:gd name="connsiteY5" fmla="*/ 326381 h 1206850"/>
              <a:gd name="connsiteX6" fmla="*/ 898812 w 1109760"/>
              <a:gd name="connsiteY6" fmla="*/ 78731 h 1206850"/>
              <a:gd name="connsiteX7" fmla="*/ 371762 w 1109760"/>
              <a:gd name="connsiteY7" fmla="*/ 15231 h 1206850"/>
              <a:gd name="connsiteX8" fmla="*/ 16162 w 1109760"/>
              <a:gd name="connsiteY8" fmla="*/ 332731 h 1206850"/>
              <a:gd name="connsiteX9" fmla="*/ 73312 w 1109760"/>
              <a:gd name="connsiteY9" fmla="*/ 574031 h 1206850"/>
              <a:gd name="connsiteX10" fmla="*/ 181262 w 1109760"/>
              <a:gd name="connsiteY10" fmla="*/ 624831 h 1206850"/>
              <a:gd name="connsiteX0" fmla="*/ 169944 w 1098442"/>
              <a:gd name="connsiteY0" fmla="*/ 624831 h 1206850"/>
              <a:gd name="connsiteX1" fmla="*/ 392194 w 1098442"/>
              <a:gd name="connsiteY1" fmla="*/ 320031 h 1206850"/>
              <a:gd name="connsiteX2" fmla="*/ 865269 w 1098442"/>
              <a:gd name="connsiteY2" fmla="*/ 356543 h 1206850"/>
              <a:gd name="connsiteX3" fmla="*/ 887494 w 1098442"/>
              <a:gd name="connsiteY3" fmla="*/ 1107431 h 1206850"/>
              <a:gd name="connsiteX4" fmla="*/ 1039894 w 1098442"/>
              <a:gd name="connsiteY4" fmla="*/ 1113781 h 1206850"/>
              <a:gd name="connsiteX5" fmla="*/ 1090694 w 1098442"/>
              <a:gd name="connsiteY5" fmla="*/ 326381 h 1206850"/>
              <a:gd name="connsiteX6" fmla="*/ 887494 w 1098442"/>
              <a:gd name="connsiteY6" fmla="*/ 78731 h 1206850"/>
              <a:gd name="connsiteX7" fmla="*/ 360444 w 1098442"/>
              <a:gd name="connsiteY7" fmla="*/ 15231 h 1206850"/>
              <a:gd name="connsiteX8" fmla="*/ 4844 w 1098442"/>
              <a:gd name="connsiteY8" fmla="*/ 332731 h 1206850"/>
              <a:gd name="connsiteX9" fmla="*/ 169944 w 1098442"/>
              <a:gd name="connsiteY9" fmla="*/ 624831 h 1206850"/>
              <a:gd name="connsiteX0" fmla="*/ 70966 w 999464"/>
              <a:gd name="connsiteY0" fmla="*/ 624161 h 1206180"/>
              <a:gd name="connsiteX1" fmla="*/ 293216 w 999464"/>
              <a:gd name="connsiteY1" fmla="*/ 319361 h 1206180"/>
              <a:gd name="connsiteX2" fmla="*/ 766291 w 999464"/>
              <a:gd name="connsiteY2" fmla="*/ 355873 h 1206180"/>
              <a:gd name="connsiteX3" fmla="*/ 788516 w 999464"/>
              <a:gd name="connsiteY3" fmla="*/ 1106761 h 1206180"/>
              <a:gd name="connsiteX4" fmla="*/ 940916 w 999464"/>
              <a:gd name="connsiteY4" fmla="*/ 1113111 h 1206180"/>
              <a:gd name="connsiteX5" fmla="*/ 991716 w 999464"/>
              <a:gd name="connsiteY5" fmla="*/ 325711 h 1206180"/>
              <a:gd name="connsiteX6" fmla="*/ 788516 w 999464"/>
              <a:gd name="connsiteY6" fmla="*/ 78061 h 1206180"/>
              <a:gd name="connsiteX7" fmla="*/ 261466 w 999464"/>
              <a:gd name="connsiteY7" fmla="*/ 14561 h 1206180"/>
              <a:gd name="connsiteX8" fmla="*/ 10641 w 999464"/>
              <a:gd name="connsiteY8" fmla="*/ 322536 h 1206180"/>
              <a:gd name="connsiteX9" fmla="*/ 70966 w 999464"/>
              <a:gd name="connsiteY9" fmla="*/ 624161 h 1206180"/>
              <a:gd name="connsiteX0" fmla="*/ 44821 w 1006656"/>
              <a:gd name="connsiteY0" fmla="*/ 571773 h 1206180"/>
              <a:gd name="connsiteX1" fmla="*/ 300408 w 1006656"/>
              <a:gd name="connsiteY1" fmla="*/ 319361 h 1206180"/>
              <a:gd name="connsiteX2" fmla="*/ 773483 w 1006656"/>
              <a:gd name="connsiteY2" fmla="*/ 355873 h 1206180"/>
              <a:gd name="connsiteX3" fmla="*/ 795708 w 1006656"/>
              <a:gd name="connsiteY3" fmla="*/ 1106761 h 1206180"/>
              <a:gd name="connsiteX4" fmla="*/ 948108 w 1006656"/>
              <a:gd name="connsiteY4" fmla="*/ 1113111 h 1206180"/>
              <a:gd name="connsiteX5" fmla="*/ 998908 w 1006656"/>
              <a:gd name="connsiteY5" fmla="*/ 325711 h 1206180"/>
              <a:gd name="connsiteX6" fmla="*/ 795708 w 1006656"/>
              <a:gd name="connsiteY6" fmla="*/ 78061 h 1206180"/>
              <a:gd name="connsiteX7" fmla="*/ 268658 w 1006656"/>
              <a:gd name="connsiteY7" fmla="*/ 14561 h 1206180"/>
              <a:gd name="connsiteX8" fmla="*/ 17833 w 1006656"/>
              <a:gd name="connsiteY8" fmla="*/ 322536 h 1206180"/>
              <a:gd name="connsiteX9" fmla="*/ 44821 w 1006656"/>
              <a:gd name="connsiteY9" fmla="*/ 571773 h 1206180"/>
              <a:gd name="connsiteX0" fmla="*/ 60979 w 1022814"/>
              <a:gd name="connsiteY0" fmla="*/ 571773 h 1206180"/>
              <a:gd name="connsiteX1" fmla="*/ 316566 w 1022814"/>
              <a:gd name="connsiteY1" fmla="*/ 319361 h 1206180"/>
              <a:gd name="connsiteX2" fmla="*/ 789641 w 1022814"/>
              <a:gd name="connsiteY2" fmla="*/ 355873 h 1206180"/>
              <a:gd name="connsiteX3" fmla="*/ 811866 w 1022814"/>
              <a:gd name="connsiteY3" fmla="*/ 1106761 h 1206180"/>
              <a:gd name="connsiteX4" fmla="*/ 964266 w 1022814"/>
              <a:gd name="connsiteY4" fmla="*/ 1113111 h 1206180"/>
              <a:gd name="connsiteX5" fmla="*/ 1015066 w 1022814"/>
              <a:gd name="connsiteY5" fmla="*/ 325711 h 1206180"/>
              <a:gd name="connsiteX6" fmla="*/ 811866 w 1022814"/>
              <a:gd name="connsiteY6" fmla="*/ 78061 h 1206180"/>
              <a:gd name="connsiteX7" fmla="*/ 284816 w 1022814"/>
              <a:gd name="connsiteY7" fmla="*/ 14561 h 1206180"/>
              <a:gd name="connsiteX8" fmla="*/ 33991 w 1022814"/>
              <a:gd name="connsiteY8" fmla="*/ 322536 h 1206180"/>
              <a:gd name="connsiteX9" fmla="*/ 60979 w 1022814"/>
              <a:gd name="connsiteY9" fmla="*/ 571773 h 1206180"/>
              <a:gd name="connsiteX0" fmla="*/ 60979 w 1022814"/>
              <a:gd name="connsiteY0" fmla="*/ 531159 h 1165566"/>
              <a:gd name="connsiteX1" fmla="*/ 316566 w 1022814"/>
              <a:gd name="connsiteY1" fmla="*/ 278747 h 1165566"/>
              <a:gd name="connsiteX2" fmla="*/ 789641 w 1022814"/>
              <a:gd name="connsiteY2" fmla="*/ 315259 h 1165566"/>
              <a:gd name="connsiteX3" fmla="*/ 811866 w 1022814"/>
              <a:gd name="connsiteY3" fmla="*/ 1066147 h 1165566"/>
              <a:gd name="connsiteX4" fmla="*/ 964266 w 1022814"/>
              <a:gd name="connsiteY4" fmla="*/ 1072497 h 1165566"/>
              <a:gd name="connsiteX5" fmla="*/ 1015066 w 1022814"/>
              <a:gd name="connsiteY5" fmla="*/ 285097 h 1165566"/>
              <a:gd name="connsiteX6" fmla="*/ 811866 w 1022814"/>
              <a:gd name="connsiteY6" fmla="*/ 37447 h 1165566"/>
              <a:gd name="connsiteX7" fmla="*/ 303866 w 1022814"/>
              <a:gd name="connsiteY7" fmla="*/ 26334 h 1165566"/>
              <a:gd name="connsiteX8" fmla="*/ 33991 w 1022814"/>
              <a:gd name="connsiteY8" fmla="*/ 281922 h 1165566"/>
              <a:gd name="connsiteX9" fmla="*/ 60979 w 1022814"/>
              <a:gd name="connsiteY9" fmla="*/ 531159 h 1165566"/>
              <a:gd name="connsiteX0" fmla="*/ 60979 w 1022814"/>
              <a:gd name="connsiteY0" fmla="*/ 531159 h 1165566"/>
              <a:gd name="connsiteX1" fmla="*/ 316566 w 1022814"/>
              <a:gd name="connsiteY1" fmla="*/ 278747 h 1165566"/>
              <a:gd name="connsiteX2" fmla="*/ 789641 w 1022814"/>
              <a:gd name="connsiteY2" fmla="*/ 315259 h 1165566"/>
              <a:gd name="connsiteX3" fmla="*/ 811866 w 1022814"/>
              <a:gd name="connsiteY3" fmla="*/ 1066147 h 1165566"/>
              <a:gd name="connsiteX4" fmla="*/ 964266 w 1022814"/>
              <a:gd name="connsiteY4" fmla="*/ 1072497 h 1165566"/>
              <a:gd name="connsiteX5" fmla="*/ 1015066 w 1022814"/>
              <a:gd name="connsiteY5" fmla="*/ 285097 h 1165566"/>
              <a:gd name="connsiteX6" fmla="*/ 811866 w 1022814"/>
              <a:gd name="connsiteY6" fmla="*/ 37447 h 1165566"/>
              <a:gd name="connsiteX7" fmla="*/ 303866 w 1022814"/>
              <a:gd name="connsiteY7" fmla="*/ 26334 h 1165566"/>
              <a:gd name="connsiteX8" fmla="*/ 33991 w 1022814"/>
              <a:gd name="connsiteY8" fmla="*/ 281922 h 1165566"/>
              <a:gd name="connsiteX9" fmla="*/ 60979 w 1022814"/>
              <a:gd name="connsiteY9" fmla="*/ 531159 h 1165566"/>
              <a:gd name="connsiteX0" fmla="*/ 66297 w 1028132"/>
              <a:gd name="connsiteY0" fmla="*/ 531159 h 1165566"/>
              <a:gd name="connsiteX1" fmla="*/ 321884 w 1028132"/>
              <a:gd name="connsiteY1" fmla="*/ 278747 h 1165566"/>
              <a:gd name="connsiteX2" fmla="*/ 794959 w 1028132"/>
              <a:gd name="connsiteY2" fmla="*/ 315259 h 1165566"/>
              <a:gd name="connsiteX3" fmla="*/ 817184 w 1028132"/>
              <a:gd name="connsiteY3" fmla="*/ 1066147 h 1165566"/>
              <a:gd name="connsiteX4" fmla="*/ 969584 w 1028132"/>
              <a:gd name="connsiteY4" fmla="*/ 1072497 h 1165566"/>
              <a:gd name="connsiteX5" fmla="*/ 1020384 w 1028132"/>
              <a:gd name="connsiteY5" fmla="*/ 285097 h 1165566"/>
              <a:gd name="connsiteX6" fmla="*/ 817184 w 1028132"/>
              <a:gd name="connsiteY6" fmla="*/ 37447 h 1165566"/>
              <a:gd name="connsiteX7" fmla="*/ 309184 w 1028132"/>
              <a:gd name="connsiteY7" fmla="*/ 26334 h 1165566"/>
              <a:gd name="connsiteX8" fmla="*/ 39309 w 1028132"/>
              <a:gd name="connsiteY8" fmla="*/ 281922 h 1165566"/>
              <a:gd name="connsiteX9" fmla="*/ 66297 w 1028132"/>
              <a:gd name="connsiteY9" fmla="*/ 531159 h 1165566"/>
              <a:gd name="connsiteX0" fmla="*/ 28 w 961863"/>
              <a:gd name="connsiteY0" fmla="*/ 531159 h 1165566"/>
              <a:gd name="connsiteX1" fmla="*/ 255615 w 961863"/>
              <a:gd name="connsiteY1" fmla="*/ 278747 h 1165566"/>
              <a:gd name="connsiteX2" fmla="*/ 728690 w 961863"/>
              <a:gd name="connsiteY2" fmla="*/ 315259 h 1165566"/>
              <a:gd name="connsiteX3" fmla="*/ 750915 w 961863"/>
              <a:gd name="connsiteY3" fmla="*/ 1066147 h 1165566"/>
              <a:gd name="connsiteX4" fmla="*/ 903315 w 961863"/>
              <a:gd name="connsiteY4" fmla="*/ 1072497 h 1165566"/>
              <a:gd name="connsiteX5" fmla="*/ 954115 w 961863"/>
              <a:gd name="connsiteY5" fmla="*/ 285097 h 1165566"/>
              <a:gd name="connsiteX6" fmla="*/ 750915 w 961863"/>
              <a:gd name="connsiteY6" fmla="*/ 37447 h 1165566"/>
              <a:gd name="connsiteX7" fmla="*/ 242915 w 961863"/>
              <a:gd name="connsiteY7" fmla="*/ 26334 h 1165566"/>
              <a:gd name="connsiteX8" fmla="*/ 28 w 961863"/>
              <a:gd name="connsiteY8" fmla="*/ 531159 h 1165566"/>
              <a:gd name="connsiteX0" fmla="*/ 25 w 976148"/>
              <a:gd name="connsiteY0" fmla="*/ 564224 h 1184344"/>
              <a:gd name="connsiteX1" fmla="*/ 269900 w 976148"/>
              <a:gd name="connsiteY1" fmla="*/ 297525 h 1184344"/>
              <a:gd name="connsiteX2" fmla="*/ 742975 w 976148"/>
              <a:gd name="connsiteY2" fmla="*/ 334037 h 1184344"/>
              <a:gd name="connsiteX3" fmla="*/ 765200 w 976148"/>
              <a:gd name="connsiteY3" fmla="*/ 1084925 h 1184344"/>
              <a:gd name="connsiteX4" fmla="*/ 917600 w 976148"/>
              <a:gd name="connsiteY4" fmla="*/ 1091275 h 1184344"/>
              <a:gd name="connsiteX5" fmla="*/ 968400 w 976148"/>
              <a:gd name="connsiteY5" fmla="*/ 303875 h 1184344"/>
              <a:gd name="connsiteX6" fmla="*/ 765200 w 976148"/>
              <a:gd name="connsiteY6" fmla="*/ 56225 h 1184344"/>
              <a:gd name="connsiteX7" fmla="*/ 257200 w 976148"/>
              <a:gd name="connsiteY7" fmla="*/ 45112 h 1184344"/>
              <a:gd name="connsiteX8" fmla="*/ 25 w 976148"/>
              <a:gd name="connsiteY8" fmla="*/ 564224 h 1184344"/>
              <a:gd name="connsiteX0" fmla="*/ 32195 w 1008318"/>
              <a:gd name="connsiteY0" fmla="*/ 564224 h 1184344"/>
              <a:gd name="connsiteX1" fmla="*/ 302070 w 1008318"/>
              <a:gd name="connsiteY1" fmla="*/ 297525 h 1184344"/>
              <a:gd name="connsiteX2" fmla="*/ 775145 w 1008318"/>
              <a:gd name="connsiteY2" fmla="*/ 334037 h 1184344"/>
              <a:gd name="connsiteX3" fmla="*/ 797370 w 1008318"/>
              <a:gd name="connsiteY3" fmla="*/ 1084925 h 1184344"/>
              <a:gd name="connsiteX4" fmla="*/ 949770 w 1008318"/>
              <a:gd name="connsiteY4" fmla="*/ 1091275 h 1184344"/>
              <a:gd name="connsiteX5" fmla="*/ 1000570 w 1008318"/>
              <a:gd name="connsiteY5" fmla="*/ 303875 h 1184344"/>
              <a:gd name="connsiteX6" fmla="*/ 797370 w 1008318"/>
              <a:gd name="connsiteY6" fmla="*/ 56225 h 1184344"/>
              <a:gd name="connsiteX7" fmla="*/ 289370 w 1008318"/>
              <a:gd name="connsiteY7" fmla="*/ 45112 h 1184344"/>
              <a:gd name="connsiteX8" fmla="*/ 32195 w 1008318"/>
              <a:gd name="connsiteY8" fmla="*/ 564224 h 1184344"/>
              <a:gd name="connsiteX0" fmla="*/ 1267 w 977390"/>
              <a:gd name="connsiteY0" fmla="*/ 564224 h 1184344"/>
              <a:gd name="connsiteX1" fmla="*/ 356867 w 977390"/>
              <a:gd name="connsiteY1" fmla="*/ 254662 h 1184344"/>
              <a:gd name="connsiteX2" fmla="*/ 744217 w 977390"/>
              <a:gd name="connsiteY2" fmla="*/ 334037 h 1184344"/>
              <a:gd name="connsiteX3" fmla="*/ 766442 w 977390"/>
              <a:gd name="connsiteY3" fmla="*/ 1084925 h 1184344"/>
              <a:gd name="connsiteX4" fmla="*/ 918842 w 977390"/>
              <a:gd name="connsiteY4" fmla="*/ 1091275 h 1184344"/>
              <a:gd name="connsiteX5" fmla="*/ 969642 w 977390"/>
              <a:gd name="connsiteY5" fmla="*/ 303875 h 1184344"/>
              <a:gd name="connsiteX6" fmla="*/ 766442 w 977390"/>
              <a:gd name="connsiteY6" fmla="*/ 56225 h 1184344"/>
              <a:gd name="connsiteX7" fmla="*/ 258442 w 977390"/>
              <a:gd name="connsiteY7" fmla="*/ 45112 h 1184344"/>
              <a:gd name="connsiteX8" fmla="*/ 1267 w 977390"/>
              <a:gd name="connsiteY8" fmla="*/ 564224 h 1184344"/>
              <a:gd name="connsiteX0" fmla="*/ 28708 w 1004831"/>
              <a:gd name="connsiteY0" fmla="*/ 564224 h 1184344"/>
              <a:gd name="connsiteX1" fmla="*/ 384308 w 1004831"/>
              <a:gd name="connsiteY1" fmla="*/ 254662 h 1184344"/>
              <a:gd name="connsiteX2" fmla="*/ 771658 w 1004831"/>
              <a:gd name="connsiteY2" fmla="*/ 334037 h 1184344"/>
              <a:gd name="connsiteX3" fmla="*/ 793883 w 1004831"/>
              <a:gd name="connsiteY3" fmla="*/ 1084925 h 1184344"/>
              <a:gd name="connsiteX4" fmla="*/ 946283 w 1004831"/>
              <a:gd name="connsiteY4" fmla="*/ 1091275 h 1184344"/>
              <a:gd name="connsiteX5" fmla="*/ 997083 w 1004831"/>
              <a:gd name="connsiteY5" fmla="*/ 303875 h 1184344"/>
              <a:gd name="connsiteX6" fmla="*/ 793883 w 1004831"/>
              <a:gd name="connsiteY6" fmla="*/ 56225 h 1184344"/>
              <a:gd name="connsiteX7" fmla="*/ 285883 w 1004831"/>
              <a:gd name="connsiteY7" fmla="*/ 45112 h 1184344"/>
              <a:gd name="connsiteX8" fmla="*/ 28708 w 1004831"/>
              <a:gd name="connsiteY8" fmla="*/ 564224 h 1184344"/>
              <a:gd name="connsiteX0" fmla="*/ 28708 w 1004831"/>
              <a:gd name="connsiteY0" fmla="*/ 564224 h 1184344"/>
              <a:gd name="connsiteX1" fmla="*/ 384308 w 1004831"/>
              <a:gd name="connsiteY1" fmla="*/ 254662 h 1184344"/>
              <a:gd name="connsiteX2" fmla="*/ 771658 w 1004831"/>
              <a:gd name="connsiteY2" fmla="*/ 334037 h 1184344"/>
              <a:gd name="connsiteX3" fmla="*/ 793883 w 1004831"/>
              <a:gd name="connsiteY3" fmla="*/ 1084925 h 1184344"/>
              <a:gd name="connsiteX4" fmla="*/ 946283 w 1004831"/>
              <a:gd name="connsiteY4" fmla="*/ 1091275 h 1184344"/>
              <a:gd name="connsiteX5" fmla="*/ 997083 w 1004831"/>
              <a:gd name="connsiteY5" fmla="*/ 303875 h 1184344"/>
              <a:gd name="connsiteX6" fmla="*/ 793883 w 1004831"/>
              <a:gd name="connsiteY6" fmla="*/ 56225 h 1184344"/>
              <a:gd name="connsiteX7" fmla="*/ 285883 w 1004831"/>
              <a:gd name="connsiteY7" fmla="*/ 45112 h 1184344"/>
              <a:gd name="connsiteX8" fmla="*/ 28708 w 1004831"/>
              <a:gd name="connsiteY8" fmla="*/ 564224 h 1184344"/>
              <a:gd name="connsiteX0" fmla="*/ 27614 w 1003737"/>
              <a:gd name="connsiteY0" fmla="*/ 558025 h 1178145"/>
              <a:gd name="connsiteX1" fmla="*/ 383214 w 1003737"/>
              <a:gd name="connsiteY1" fmla="*/ 248463 h 1178145"/>
              <a:gd name="connsiteX2" fmla="*/ 770564 w 1003737"/>
              <a:gd name="connsiteY2" fmla="*/ 327838 h 1178145"/>
              <a:gd name="connsiteX3" fmla="*/ 792789 w 1003737"/>
              <a:gd name="connsiteY3" fmla="*/ 1078726 h 1178145"/>
              <a:gd name="connsiteX4" fmla="*/ 945189 w 1003737"/>
              <a:gd name="connsiteY4" fmla="*/ 1085076 h 1178145"/>
              <a:gd name="connsiteX5" fmla="*/ 995989 w 1003737"/>
              <a:gd name="connsiteY5" fmla="*/ 297676 h 1178145"/>
              <a:gd name="connsiteX6" fmla="*/ 792789 w 1003737"/>
              <a:gd name="connsiteY6" fmla="*/ 50026 h 1178145"/>
              <a:gd name="connsiteX7" fmla="*/ 284789 w 1003737"/>
              <a:gd name="connsiteY7" fmla="*/ 38913 h 1178145"/>
              <a:gd name="connsiteX8" fmla="*/ 27614 w 1003737"/>
              <a:gd name="connsiteY8" fmla="*/ 558025 h 1178145"/>
              <a:gd name="connsiteX0" fmla="*/ 31579 w 1007702"/>
              <a:gd name="connsiteY0" fmla="*/ 564224 h 1184344"/>
              <a:gd name="connsiteX1" fmla="*/ 387179 w 1007702"/>
              <a:gd name="connsiteY1" fmla="*/ 254662 h 1184344"/>
              <a:gd name="connsiteX2" fmla="*/ 774529 w 1007702"/>
              <a:gd name="connsiteY2" fmla="*/ 334037 h 1184344"/>
              <a:gd name="connsiteX3" fmla="*/ 796754 w 1007702"/>
              <a:gd name="connsiteY3" fmla="*/ 1084925 h 1184344"/>
              <a:gd name="connsiteX4" fmla="*/ 949154 w 1007702"/>
              <a:gd name="connsiteY4" fmla="*/ 1091275 h 1184344"/>
              <a:gd name="connsiteX5" fmla="*/ 999954 w 1007702"/>
              <a:gd name="connsiteY5" fmla="*/ 303875 h 1184344"/>
              <a:gd name="connsiteX6" fmla="*/ 796754 w 1007702"/>
              <a:gd name="connsiteY6" fmla="*/ 56225 h 1184344"/>
              <a:gd name="connsiteX7" fmla="*/ 288754 w 1007702"/>
              <a:gd name="connsiteY7" fmla="*/ 45112 h 1184344"/>
              <a:gd name="connsiteX8" fmla="*/ 31579 w 1007702"/>
              <a:gd name="connsiteY8" fmla="*/ 564224 h 1184344"/>
              <a:gd name="connsiteX0" fmla="*/ 2502 w 978625"/>
              <a:gd name="connsiteY0" fmla="*/ 545503 h 1165623"/>
              <a:gd name="connsiteX1" fmla="*/ 358102 w 978625"/>
              <a:gd name="connsiteY1" fmla="*/ 235941 h 1165623"/>
              <a:gd name="connsiteX2" fmla="*/ 745452 w 978625"/>
              <a:gd name="connsiteY2" fmla="*/ 315316 h 1165623"/>
              <a:gd name="connsiteX3" fmla="*/ 767677 w 978625"/>
              <a:gd name="connsiteY3" fmla="*/ 1066204 h 1165623"/>
              <a:gd name="connsiteX4" fmla="*/ 920077 w 978625"/>
              <a:gd name="connsiteY4" fmla="*/ 1072554 h 1165623"/>
              <a:gd name="connsiteX5" fmla="*/ 970877 w 978625"/>
              <a:gd name="connsiteY5" fmla="*/ 285154 h 1165623"/>
              <a:gd name="connsiteX6" fmla="*/ 767677 w 978625"/>
              <a:gd name="connsiteY6" fmla="*/ 37504 h 1165623"/>
              <a:gd name="connsiteX7" fmla="*/ 240627 w 978625"/>
              <a:gd name="connsiteY7" fmla="*/ 54966 h 1165623"/>
              <a:gd name="connsiteX8" fmla="*/ 2502 w 978625"/>
              <a:gd name="connsiteY8" fmla="*/ 545503 h 1165623"/>
              <a:gd name="connsiteX0" fmla="*/ 34870 w 1010993"/>
              <a:gd name="connsiteY0" fmla="*/ 545503 h 1165623"/>
              <a:gd name="connsiteX1" fmla="*/ 390470 w 1010993"/>
              <a:gd name="connsiteY1" fmla="*/ 235941 h 1165623"/>
              <a:gd name="connsiteX2" fmla="*/ 777820 w 1010993"/>
              <a:gd name="connsiteY2" fmla="*/ 315316 h 1165623"/>
              <a:gd name="connsiteX3" fmla="*/ 800045 w 1010993"/>
              <a:gd name="connsiteY3" fmla="*/ 1066204 h 1165623"/>
              <a:gd name="connsiteX4" fmla="*/ 952445 w 1010993"/>
              <a:gd name="connsiteY4" fmla="*/ 1072554 h 1165623"/>
              <a:gd name="connsiteX5" fmla="*/ 1003245 w 1010993"/>
              <a:gd name="connsiteY5" fmla="*/ 285154 h 1165623"/>
              <a:gd name="connsiteX6" fmla="*/ 800045 w 1010993"/>
              <a:gd name="connsiteY6" fmla="*/ 37504 h 1165623"/>
              <a:gd name="connsiteX7" fmla="*/ 272995 w 1010993"/>
              <a:gd name="connsiteY7" fmla="*/ 54966 h 1165623"/>
              <a:gd name="connsiteX8" fmla="*/ 34870 w 1010993"/>
              <a:gd name="connsiteY8" fmla="*/ 545503 h 1165623"/>
              <a:gd name="connsiteX0" fmla="*/ 25644 w 1001767"/>
              <a:gd name="connsiteY0" fmla="*/ 545503 h 1165623"/>
              <a:gd name="connsiteX1" fmla="*/ 381244 w 1001767"/>
              <a:gd name="connsiteY1" fmla="*/ 235941 h 1165623"/>
              <a:gd name="connsiteX2" fmla="*/ 768594 w 1001767"/>
              <a:gd name="connsiteY2" fmla="*/ 315316 h 1165623"/>
              <a:gd name="connsiteX3" fmla="*/ 790819 w 1001767"/>
              <a:gd name="connsiteY3" fmla="*/ 1066204 h 1165623"/>
              <a:gd name="connsiteX4" fmla="*/ 943219 w 1001767"/>
              <a:gd name="connsiteY4" fmla="*/ 1072554 h 1165623"/>
              <a:gd name="connsiteX5" fmla="*/ 994019 w 1001767"/>
              <a:gd name="connsiteY5" fmla="*/ 285154 h 1165623"/>
              <a:gd name="connsiteX6" fmla="*/ 790819 w 1001767"/>
              <a:gd name="connsiteY6" fmla="*/ 37504 h 1165623"/>
              <a:gd name="connsiteX7" fmla="*/ 263769 w 1001767"/>
              <a:gd name="connsiteY7" fmla="*/ 54966 h 1165623"/>
              <a:gd name="connsiteX8" fmla="*/ 25644 w 1001767"/>
              <a:gd name="connsiteY8" fmla="*/ 545503 h 1165623"/>
              <a:gd name="connsiteX0" fmla="*/ 32997 w 1009120"/>
              <a:gd name="connsiteY0" fmla="*/ 545503 h 1165623"/>
              <a:gd name="connsiteX1" fmla="*/ 388597 w 1009120"/>
              <a:gd name="connsiteY1" fmla="*/ 235941 h 1165623"/>
              <a:gd name="connsiteX2" fmla="*/ 775947 w 1009120"/>
              <a:gd name="connsiteY2" fmla="*/ 315316 h 1165623"/>
              <a:gd name="connsiteX3" fmla="*/ 798172 w 1009120"/>
              <a:gd name="connsiteY3" fmla="*/ 1066204 h 1165623"/>
              <a:gd name="connsiteX4" fmla="*/ 950572 w 1009120"/>
              <a:gd name="connsiteY4" fmla="*/ 1072554 h 1165623"/>
              <a:gd name="connsiteX5" fmla="*/ 1001372 w 1009120"/>
              <a:gd name="connsiteY5" fmla="*/ 285154 h 1165623"/>
              <a:gd name="connsiteX6" fmla="*/ 798172 w 1009120"/>
              <a:gd name="connsiteY6" fmla="*/ 37504 h 1165623"/>
              <a:gd name="connsiteX7" fmla="*/ 271122 w 1009120"/>
              <a:gd name="connsiteY7" fmla="*/ 54966 h 1165623"/>
              <a:gd name="connsiteX8" fmla="*/ 32997 w 1009120"/>
              <a:gd name="connsiteY8" fmla="*/ 545503 h 1165623"/>
              <a:gd name="connsiteX0" fmla="*/ 27071 w 1041294"/>
              <a:gd name="connsiteY0" fmla="*/ 518458 h 1163978"/>
              <a:gd name="connsiteX1" fmla="*/ 420771 w 1041294"/>
              <a:gd name="connsiteY1" fmla="*/ 234296 h 1163978"/>
              <a:gd name="connsiteX2" fmla="*/ 808121 w 1041294"/>
              <a:gd name="connsiteY2" fmla="*/ 313671 h 1163978"/>
              <a:gd name="connsiteX3" fmla="*/ 830346 w 1041294"/>
              <a:gd name="connsiteY3" fmla="*/ 1064559 h 1163978"/>
              <a:gd name="connsiteX4" fmla="*/ 982746 w 1041294"/>
              <a:gd name="connsiteY4" fmla="*/ 1070909 h 1163978"/>
              <a:gd name="connsiteX5" fmla="*/ 1033546 w 1041294"/>
              <a:gd name="connsiteY5" fmla="*/ 283509 h 1163978"/>
              <a:gd name="connsiteX6" fmla="*/ 830346 w 1041294"/>
              <a:gd name="connsiteY6" fmla="*/ 35859 h 1163978"/>
              <a:gd name="connsiteX7" fmla="*/ 303296 w 1041294"/>
              <a:gd name="connsiteY7" fmla="*/ 53321 h 1163978"/>
              <a:gd name="connsiteX8" fmla="*/ 27071 w 1041294"/>
              <a:gd name="connsiteY8" fmla="*/ 518458 h 1163978"/>
              <a:gd name="connsiteX0" fmla="*/ 27071 w 1041294"/>
              <a:gd name="connsiteY0" fmla="*/ 518458 h 1163978"/>
              <a:gd name="connsiteX1" fmla="*/ 128627 w 1041294"/>
              <a:gd name="connsiteY1" fmla="*/ 481207 h 1163978"/>
              <a:gd name="connsiteX2" fmla="*/ 420771 w 1041294"/>
              <a:gd name="connsiteY2" fmla="*/ 234296 h 1163978"/>
              <a:gd name="connsiteX3" fmla="*/ 808121 w 1041294"/>
              <a:gd name="connsiteY3" fmla="*/ 313671 h 1163978"/>
              <a:gd name="connsiteX4" fmla="*/ 830346 w 1041294"/>
              <a:gd name="connsiteY4" fmla="*/ 1064559 h 1163978"/>
              <a:gd name="connsiteX5" fmla="*/ 982746 w 1041294"/>
              <a:gd name="connsiteY5" fmla="*/ 1070909 h 1163978"/>
              <a:gd name="connsiteX6" fmla="*/ 1033546 w 1041294"/>
              <a:gd name="connsiteY6" fmla="*/ 283509 h 1163978"/>
              <a:gd name="connsiteX7" fmla="*/ 830346 w 1041294"/>
              <a:gd name="connsiteY7" fmla="*/ 35859 h 1163978"/>
              <a:gd name="connsiteX8" fmla="*/ 303296 w 1041294"/>
              <a:gd name="connsiteY8" fmla="*/ 53321 h 1163978"/>
              <a:gd name="connsiteX9" fmla="*/ 27071 w 1041294"/>
              <a:gd name="connsiteY9" fmla="*/ 518458 h 1163978"/>
              <a:gd name="connsiteX0" fmla="*/ 4966 w 1019189"/>
              <a:gd name="connsiteY0" fmla="*/ 518458 h 1163978"/>
              <a:gd name="connsiteX1" fmla="*/ 125572 w 1019189"/>
              <a:gd name="connsiteY1" fmla="*/ 509782 h 1163978"/>
              <a:gd name="connsiteX2" fmla="*/ 398666 w 1019189"/>
              <a:gd name="connsiteY2" fmla="*/ 234296 h 1163978"/>
              <a:gd name="connsiteX3" fmla="*/ 786016 w 1019189"/>
              <a:gd name="connsiteY3" fmla="*/ 313671 h 1163978"/>
              <a:gd name="connsiteX4" fmla="*/ 808241 w 1019189"/>
              <a:gd name="connsiteY4" fmla="*/ 1064559 h 1163978"/>
              <a:gd name="connsiteX5" fmla="*/ 960641 w 1019189"/>
              <a:gd name="connsiteY5" fmla="*/ 1070909 h 1163978"/>
              <a:gd name="connsiteX6" fmla="*/ 1011441 w 1019189"/>
              <a:gd name="connsiteY6" fmla="*/ 283509 h 1163978"/>
              <a:gd name="connsiteX7" fmla="*/ 808241 w 1019189"/>
              <a:gd name="connsiteY7" fmla="*/ 35859 h 1163978"/>
              <a:gd name="connsiteX8" fmla="*/ 281191 w 1019189"/>
              <a:gd name="connsiteY8" fmla="*/ 53321 h 1163978"/>
              <a:gd name="connsiteX9" fmla="*/ 4966 w 1019189"/>
              <a:gd name="connsiteY9" fmla="*/ 518458 h 1163978"/>
              <a:gd name="connsiteX0" fmla="*/ 2845 w 1017068"/>
              <a:gd name="connsiteY0" fmla="*/ 518458 h 1163978"/>
              <a:gd name="connsiteX1" fmla="*/ 123451 w 1017068"/>
              <a:gd name="connsiteY1" fmla="*/ 509782 h 1163978"/>
              <a:gd name="connsiteX2" fmla="*/ 396545 w 1017068"/>
              <a:gd name="connsiteY2" fmla="*/ 234296 h 1163978"/>
              <a:gd name="connsiteX3" fmla="*/ 783895 w 1017068"/>
              <a:gd name="connsiteY3" fmla="*/ 313671 h 1163978"/>
              <a:gd name="connsiteX4" fmla="*/ 806120 w 1017068"/>
              <a:gd name="connsiteY4" fmla="*/ 1064559 h 1163978"/>
              <a:gd name="connsiteX5" fmla="*/ 958520 w 1017068"/>
              <a:gd name="connsiteY5" fmla="*/ 1070909 h 1163978"/>
              <a:gd name="connsiteX6" fmla="*/ 1009320 w 1017068"/>
              <a:gd name="connsiteY6" fmla="*/ 283509 h 1163978"/>
              <a:gd name="connsiteX7" fmla="*/ 806120 w 1017068"/>
              <a:gd name="connsiteY7" fmla="*/ 35859 h 1163978"/>
              <a:gd name="connsiteX8" fmla="*/ 279070 w 1017068"/>
              <a:gd name="connsiteY8" fmla="*/ 53321 h 1163978"/>
              <a:gd name="connsiteX9" fmla="*/ 2845 w 1017068"/>
              <a:gd name="connsiteY9" fmla="*/ 518458 h 1163978"/>
              <a:gd name="connsiteX0" fmla="*/ 2845 w 1017068"/>
              <a:gd name="connsiteY0" fmla="*/ 518458 h 1163978"/>
              <a:gd name="connsiteX1" fmla="*/ 123451 w 1017068"/>
              <a:gd name="connsiteY1" fmla="*/ 509782 h 1163978"/>
              <a:gd name="connsiteX2" fmla="*/ 396545 w 1017068"/>
              <a:gd name="connsiteY2" fmla="*/ 234296 h 1163978"/>
              <a:gd name="connsiteX3" fmla="*/ 783895 w 1017068"/>
              <a:gd name="connsiteY3" fmla="*/ 313671 h 1163978"/>
              <a:gd name="connsiteX4" fmla="*/ 806120 w 1017068"/>
              <a:gd name="connsiteY4" fmla="*/ 1064559 h 1163978"/>
              <a:gd name="connsiteX5" fmla="*/ 958520 w 1017068"/>
              <a:gd name="connsiteY5" fmla="*/ 1070909 h 1163978"/>
              <a:gd name="connsiteX6" fmla="*/ 1009320 w 1017068"/>
              <a:gd name="connsiteY6" fmla="*/ 283509 h 1163978"/>
              <a:gd name="connsiteX7" fmla="*/ 806120 w 1017068"/>
              <a:gd name="connsiteY7" fmla="*/ 35859 h 1163978"/>
              <a:gd name="connsiteX8" fmla="*/ 279070 w 1017068"/>
              <a:gd name="connsiteY8" fmla="*/ 53321 h 1163978"/>
              <a:gd name="connsiteX9" fmla="*/ 2845 w 1017068"/>
              <a:gd name="connsiteY9" fmla="*/ 518458 h 1163978"/>
              <a:gd name="connsiteX0" fmla="*/ 2307 w 1057805"/>
              <a:gd name="connsiteY0" fmla="*/ 491437 h 1162357"/>
              <a:gd name="connsiteX1" fmla="*/ 164188 w 1057805"/>
              <a:gd name="connsiteY1" fmla="*/ 508161 h 1162357"/>
              <a:gd name="connsiteX2" fmla="*/ 437282 w 1057805"/>
              <a:gd name="connsiteY2" fmla="*/ 232675 h 1162357"/>
              <a:gd name="connsiteX3" fmla="*/ 824632 w 1057805"/>
              <a:gd name="connsiteY3" fmla="*/ 312050 h 1162357"/>
              <a:gd name="connsiteX4" fmla="*/ 846857 w 1057805"/>
              <a:gd name="connsiteY4" fmla="*/ 1062938 h 1162357"/>
              <a:gd name="connsiteX5" fmla="*/ 999257 w 1057805"/>
              <a:gd name="connsiteY5" fmla="*/ 1069288 h 1162357"/>
              <a:gd name="connsiteX6" fmla="*/ 1050057 w 1057805"/>
              <a:gd name="connsiteY6" fmla="*/ 281888 h 1162357"/>
              <a:gd name="connsiteX7" fmla="*/ 846857 w 1057805"/>
              <a:gd name="connsiteY7" fmla="*/ 34238 h 1162357"/>
              <a:gd name="connsiteX8" fmla="*/ 319807 w 1057805"/>
              <a:gd name="connsiteY8" fmla="*/ 51700 h 1162357"/>
              <a:gd name="connsiteX9" fmla="*/ 2307 w 1057805"/>
              <a:gd name="connsiteY9" fmla="*/ 491437 h 1162357"/>
              <a:gd name="connsiteX0" fmla="*/ 1226 w 1056724"/>
              <a:gd name="connsiteY0" fmla="*/ 491437 h 1162357"/>
              <a:gd name="connsiteX1" fmla="*/ 163107 w 1056724"/>
              <a:gd name="connsiteY1" fmla="*/ 508161 h 1162357"/>
              <a:gd name="connsiteX2" fmla="*/ 436201 w 1056724"/>
              <a:gd name="connsiteY2" fmla="*/ 232675 h 1162357"/>
              <a:gd name="connsiteX3" fmla="*/ 823551 w 1056724"/>
              <a:gd name="connsiteY3" fmla="*/ 312050 h 1162357"/>
              <a:gd name="connsiteX4" fmla="*/ 845776 w 1056724"/>
              <a:gd name="connsiteY4" fmla="*/ 1062938 h 1162357"/>
              <a:gd name="connsiteX5" fmla="*/ 998176 w 1056724"/>
              <a:gd name="connsiteY5" fmla="*/ 1069288 h 1162357"/>
              <a:gd name="connsiteX6" fmla="*/ 1048976 w 1056724"/>
              <a:gd name="connsiteY6" fmla="*/ 281888 h 1162357"/>
              <a:gd name="connsiteX7" fmla="*/ 845776 w 1056724"/>
              <a:gd name="connsiteY7" fmla="*/ 34238 h 1162357"/>
              <a:gd name="connsiteX8" fmla="*/ 318726 w 1056724"/>
              <a:gd name="connsiteY8" fmla="*/ 51700 h 1162357"/>
              <a:gd name="connsiteX9" fmla="*/ 1226 w 1056724"/>
              <a:gd name="connsiteY9" fmla="*/ 491437 h 1162357"/>
              <a:gd name="connsiteX0" fmla="*/ 2682 w 1058180"/>
              <a:gd name="connsiteY0" fmla="*/ 491437 h 1162357"/>
              <a:gd name="connsiteX1" fmla="*/ 155038 w 1058180"/>
              <a:gd name="connsiteY1" fmla="*/ 524036 h 1162357"/>
              <a:gd name="connsiteX2" fmla="*/ 437657 w 1058180"/>
              <a:gd name="connsiteY2" fmla="*/ 232675 h 1162357"/>
              <a:gd name="connsiteX3" fmla="*/ 825007 w 1058180"/>
              <a:gd name="connsiteY3" fmla="*/ 312050 h 1162357"/>
              <a:gd name="connsiteX4" fmla="*/ 847232 w 1058180"/>
              <a:gd name="connsiteY4" fmla="*/ 1062938 h 1162357"/>
              <a:gd name="connsiteX5" fmla="*/ 999632 w 1058180"/>
              <a:gd name="connsiteY5" fmla="*/ 1069288 h 1162357"/>
              <a:gd name="connsiteX6" fmla="*/ 1050432 w 1058180"/>
              <a:gd name="connsiteY6" fmla="*/ 281888 h 1162357"/>
              <a:gd name="connsiteX7" fmla="*/ 847232 w 1058180"/>
              <a:gd name="connsiteY7" fmla="*/ 34238 h 1162357"/>
              <a:gd name="connsiteX8" fmla="*/ 320182 w 1058180"/>
              <a:gd name="connsiteY8" fmla="*/ 51700 h 1162357"/>
              <a:gd name="connsiteX9" fmla="*/ 2682 w 1058180"/>
              <a:gd name="connsiteY9" fmla="*/ 491437 h 1162357"/>
              <a:gd name="connsiteX0" fmla="*/ 3677 w 1002025"/>
              <a:gd name="connsiteY0" fmla="*/ 450959 h 1159979"/>
              <a:gd name="connsiteX1" fmla="*/ 98883 w 1002025"/>
              <a:gd name="connsiteY1" fmla="*/ 521658 h 1159979"/>
              <a:gd name="connsiteX2" fmla="*/ 381502 w 1002025"/>
              <a:gd name="connsiteY2" fmla="*/ 230297 h 1159979"/>
              <a:gd name="connsiteX3" fmla="*/ 768852 w 1002025"/>
              <a:gd name="connsiteY3" fmla="*/ 309672 h 1159979"/>
              <a:gd name="connsiteX4" fmla="*/ 791077 w 1002025"/>
              <a:gd name="connsiteY4" fmla="*/ 1060560 h 1159979"/>
              <a:gd name="connsiteX5" fmla="*/ 943477 w 1002025"/>
              <a:gd name="connsiteY5" fmla="*/ 1066910 h 1159979"/>
              <a:gd name="connsiteX6" fmla="*/ 994277 w 1002025"/>
              <a:gd name="connsiteY6" fmla="*/ 279510 h 1159979"/>
              <a:gd name="connsiteX7" fmla="*/ 791077 w 1002025"/>
              <a:gd name="connsiteY7" fmla="*/ 31860 h 1159979"/>
              <a:gd name="connsiteX8" fmla="*/ 264027 w 1002025"/>
              <a:gd name="connsiteY8" fmla="*/ 49322 h 1159979"/>
              <a:gd name="connsiteX9" fmla="*/ 3677 w 1002025"/>
              <a:gd name="connsiteY9" fmla="*/ 450959 h 1159979"/>
              <a:gd name="connsiteX0" fmla="*/ 3302 w 1001650"/>
              <a:gd name="connsiteY0" fmla="*/ 450959 h 1159979"/>
              <a:gd name="connsiteX1" fmla="*/ 104858 w 1001650"/>
              <a:gd name="connsiteY1" fmla="*/ 524833 h 1159979"/>
              <a:gd name="connsiteX2" fmla="*/ 381127 w 1001650"/>
              <a:gd name="connsiteY2" fmla="*/ 230297 h 1159979"/>
              <a:gd name="connsiteX3" fmla="*/ 768477 w 1001650"/>
              <a:gd name="connsiteY3" fmla="*/ 309672 h 1159979"/>
              <a:gd name="connsiteX4" fmla="*/ 790702 w 1001650"/>
              <a:gd name="connsiteY4" fmla="*/ 1060560 h 1159979"/>
              <a:gd name="connsiteX5" fmla="*/ 943102 w 1001650"/>
              <a:gd name="connsiteY5" fmla="*/ 1066910 h 1159979"/>
              <a:gd name="connsiteX6" fmla="*/ 993902 w 1001650"/>
              <a:gd name="connsiteY6" fmla="*/ 279510 h 1159979"/>
              <a:gd name="connsiteX7" fmla="*/ 790702 w 1001650"/>
              <a:gd name="connsiteY7" fmla="*/ 31860 h 1159979"/>
              <a:gd name="connsiteX8" fmla="*/ 263652 w 1001650"/>
              <a:gd name="connsiteY8" fmla="*/ 49322 h 1159979"/>
              <a:gd name="connsiteX9" fmla="*/ 3302 w 1001650"/>
              <a:gd name="connsiteY9" fmla="*/ 450959 h 1159979"/>
              <a:gd name="connsiteX0" fmla="*/ 2458 w 1000806"/>
              <a:gd name="connsiteY0" fmla="*/ 450959 h 1159979"/>
              <a:gd name="connsiteX1" fmla="*/ 120683 w 1000806"/>
              <a:gd name="connsiteY1" fmla="*/ 520071 h 1159979"/>
              <a:gd name="connsiteX2" fmla="*/ 380283 w 1000806"/>
              <a:gd name="connsiteY2" fmla="*/ 230297 h 1159979"/>
              <a:gd name="connsiteX3" fmla="*/ 767633 w 1000806"/>
              <a:gd name="connsiteY3" fmla="*/ 309672 h 1159979"/>
              <a:gd name="connsiteX4" fmla="*/ 789858 w 1000806"/>
              <a:gd name="connsiteY4" fmla="*/ 1060560 h 1159979"/>
              <a:gd name="connsiteX5" fmla="*/ 942258 w 1000806"/>
              <a:gd name="connsiteY5" fmla="*/ 1066910 h 1159979"/>
              <a:gd name="connsiteX6" fmla="*/ 993058 w 1000806"/>
              <a:gd name="connsiteY6" fmla="*/ 279510 h 1159979"/>
              <a:gd name="connsiteX7" fmla="*/ 789858 w 1000806"/>
              <a:gd name="connsiteY7" fmla="*/ 31860 h 1159979"/>
              <a:gd name="connsiteX8" fmla="*/ 262808 w 1000806"/>
              <a:gd name="connsiteY8" fmla="*/ 49322 h 1159979"/>
              <a:gd name="connsiteX9" fmla="*/ 2458 w 1000806"/>
              <a:gd name="connsiteY9" fmla="*/ 450959 h 1159979"/>
              <a:gd name="connsiteX0" fmla="*/ 3725 w 1002073"/>
              <a:gd name="connsiteY0" fmla="*/ 450959 h 1159979"/>
              <a:gd name="connsiteX1" fmla="*/ 98138 w 1002073"/>
              <a:gd name="connsiteY1" fmla="*/ 534359 h 1159979"/>
              <a:gd name="connsiteX2" fmla="*/ 381550 w 1002073"/>
              <a:gd name="connsiteY2" fmla="*/ 230297 h 1159979"/>
              <a:gd name="connsiteX3" fmla="*/ 768900 w 1002073"/>
              <a:gd name="connsiteY3" fmla="*/ 309672 h 1159979"/>
              <a:gd name="connsiteX4" fmla="*/ 791125 w 1002073"/>
              <a:gd name="connsiteY4" fmla="*/ 1060560 h 1159979"/>
              <a:gd name="connsiteX5" fmla="*/ 943525 w 1002073"/>
              <a:gd name="connsiteY5" fmla="*/ 1066910 h 1159979"/>
              <a:gd name="connsiteX6" fmla="*/ 994325 w 1002073"/>
              <a:gd name="connsiteY6" fmla="*/ 279510 h 1159979"/>
              <a:gd name="connsiteX7" fmla="*/ 791125 w 1002073"/>
              <a:gd name="connsiteY7" fmla="*/ 31860 h 1159979"/>
              <a:gd name="connsiteX8" fmla="*/ 264075 w 1002073"/>
              <a:gd name="connsiteY8" fmla="*/ 49322 h 1159979"/>
              <a:gd name="connsiteX9" fmla="*/ 3725 w 1002073"/>
              <a:gd name="connsiteY9" fmla="*/ 450959 h 1159979"/>
              <a:gd name="connsiteX0" fmla="*/ 3725 w 1002073"/>
              <a:gd name="connsiteY0" fmla="*/ 450959 h 1159979"/>
              <a:gd name="connsiteX1" fmla="*/ 98138 w 1002073"/>
              <a:gd name="connsiteY1" fmla="*/ 534359 h 1159979"/>
              <a:gd name="connsiteX2" fmla="*/ 381550 w 1002073"/>
              <a:gd name="connsiteY2" fmla="*/ 230297 h 1159979"/>
              <a:gd name="connsiteX3" fmla="*/ 768900 w 1002073"/>
              <a:gd name="connsiteY3" fmla="*/ 309672 h 1159979"/>
              <a:gd name="connsiteX4" fmla="*/ 791125 w 1002073"/>
              <a:gd name="connsiteY4" fmla="*/ 1060560 h 1159979"/>
              <a:gd name="connsiteX5" fmla="*/ 943525 w 1002073"/>
              <a:gd name="connsiteY5" fmla="*/ 1066910 h 1159979"/>
              <a:gd name="connsiteX6" fmla="*/ 994325 w 1002073"/>
              <a:gd name="connsiteY6" fmla="*/ 279510 h 1159979"/>
              <a:gd name="connsiteX7" fmla="*/ 791125 w 1002073"/>
              <a:gd name="connsiteY7" fmla="*/ 31860 h 1159979"/>
              <a:gd name="connsiteX8" fmla="*/ 264075 w 1002073"/>
              <a:gd name="connsiteY8" fmla="*/ 49322 h 1159979"/>
              <a:gd name="connsiteX9" fmla="*/ 3725 w 1002073"/>
              <a:gd name="connsiteY9" fmla="*/ 450959 h 1159979"/>
              <a:gd name="connsiteX0" fmla="*/ 5180 w 1003528"/>
              <a:gd name="connsiteY0" fmla="*/ 450959 h 1159979"/>
              <a:gd name="connsiteX1" fmla="*/ 99593 w 1003528"/>
              <a:gd name="connsiteY1" fmla="*/ 534359 h 1159979"/>
              <a:gd name="connsiteX2" fmla="*/ 383005 w 1003528"/>
              <a:gd name="connsiteY2" fmla="*/ 230297 h 1159979"/>
              <a:gd name="connsiteX3" fmla="*/ 770355 w 1003528"/>
              <a:gd name="connsiteY3" fmla="*/ 309672 h 1159979"/>
              <a:gd name="connsiteX4" fmla="*/ 792580 w 1003528"/>
              <a:gd name="connsiteY4" fmla="*/ 1060560 h 1159979"/>
              <a:gd name="connsiteX5" fmla="*/ 944980 w 1003528"/>
              <a:gd name="connsiteY5" fmla="*/ 1066910 h 1159979"/>
              <a:gd name="connsiteX6" fmla="*/ 995780 w 1003528"/>
              <a:gd name="connsiteY6" fmla="*/ 279510 h 1159979"/>
              <a:gd name="connsiteX7" fmla="*/ 792580 w 1003528"/>
              <a:gd name="connsiteY7" fmla="*/ 31860 h 1159979"/>
              <a:gd name="connsiteX8" fmla="*/ 265530 w 1003528"/>
              <a:gd name="connsiteY8" fmla="*/ 49322 h 1159979"/>
              <a:gd name="connsiteX9" fmla="*/ 5180 w 1003528"/>
              <a:gd name="connsiteY9" fmla="*/ 450959 h 1159979"/>
              <a:gd name="connsiteX0" fmla="*/ 3793 w 1002141"/>
              <a:gd name="connsiteY0" fmla="*/ 450959 h 1159979"/>
              <a:gd name="connsiteX1" fmla="*/ 114874 w 1002141"/>
              <a:gd name="connsiteY1" fmla="*/ 512928 h 1159979"/>
              <a:gd name="connsiteX2" fmla="*/ 381618 w 1002141"/>
              <a:gd name="connsiteY2" fmla="*/ 230297 h 1159979"/>
              <a:gd name="connsiteX3" fmla="*/ 768968 w 1002141"/>
              <a:gd name="connsiteY3" fmla="*/ 309672 h 1159979"/>
              <a:gd name="connsiteX4" fmla="*/ 791193 w 1002141"/>
              <a:gd name="connsiteY4" fmla="*/ 1060560 h 1159979"/>
              <a:gd name="connsiteX5" fmla="*/ 943593 w 1002141"/>
              <a:gd name="connsiteY5" fmla="*/ 1066910 h 1159979"/>
              <a:gd name="connsiteX6" fmla="*/ 994393 w 1002141"/>
              <a:gd name="connsiteY6" fmla="*/ 279510 h 1159979"/>
              <a:gd name="connsiteX7" fmla="*/ 791193 w 1002141"/>
              <a:gd name="connsiteY7" fmla="*/ 31860 h 1159979"/>
              <a:gd name="connsiteX8" fmla="*/ 264143 w 1002141"/>
              <a:gd name="connsiteY8" fmla="*/ 49322 h 1159979"/>
              <a:gd name="connsiteX9" fmla="*/ 3793 w 1002141"/>
              <a:gd name="connsiteY9" fmla="*/ 450959 h 115997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1002141" h="1159979">
                <a:moveTo>
                  <a:pt x="3793" y="450959"/>
                </a:moveTo>
                <a:cubicBezTo>
                  <a:pt x="-21085" y="528227"/>
                  <a:pt x="83389" y="540444"/>
                  <a:pt x="114874" y="512928"/>
                </a:cubicBezTo>
                <a:cubicBezTo>
                  <a:pt x="116991" y="516368"/>
                  <a:pt x="272602" y="264173"/>
                  <a:pt x="381618" y="230297"/>
                </a:cubicBezTo>
                <a:cubicBezTo>
                  <a:pt x="490634" y="196421"/>
                  <a:pt x="700706" y="171295"/>
                  <a:pt x="768968" y="309672"/>
                </a:cubicBezTo>
                <a:cubicBezTo>
                  <a:pt x="837230" y="448049"/>
                  <a:pt x="762089" y="934354"/>
                  <a:pt x="791193" y="1060560"/>
                </a:cubicBezTo>
                <a:cubicBezTo>
                  <a:pt x="820297" y="1186766"/>
                  <a:pt x="909726" y="1197085"/>
                  <a:pt x="943593" y="1066910"/>
                </a:cubicBezTo>
                <a:cubicBezTo>
                  <a:pt x="977460" y="936735"/>
                  <a:pt x="1019793" y="452018"/>
                  <a:pt x="994393" y="279510"/>
                </a:cubicBezTo>
                <a:cubicBezTo>
                  <a:pt x="968993" y="107002"/>
                  <a:pt x="912901" y="70225"/>
                  <a:pt x="791193" y="31860"/>
                </a:cubicBezTo>
                <a:cubicBezTo>
                  <a:pt x="669485" y="-6505"/>
                  <a:pt x="395376" y="-20528"/>
                  <a:pt x="264143" y="49322"/>
                </a:cubicBezTo>
                <a:cubicBezTo>
                  <a:pt x="132910" y="119172"/>
                  <a:pt x="28671" y="373691"/>
                  <a:pt x="3793" y="450959"/>
                </a:cubicBezTo>
                <a:close/>
              </a:path>
            </a:pathLst>
          </a:custGeom>
          <a:solidFill>
            <a:srgbClr val="002060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6389780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Image 8">
            <a:extLst>
              <a:ext uri="{FF2B5EF4-FFF2-40B4-BE49-F238E27FC236}">
                <a16:creationId xmlns:a16="http://schemas.microsoft.com/office/drawing/2014/main" xmlns="" id="{C0A297CC-B2AF-4747-BA65-E515C5B0422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1656" y="3583087"/>
            <a:ext cx="5211575" cy="1528422"/>
          </a:xfrm>
          <a:prstGeom prst="rect">
            <a:avLst/>
          </a:prstGeom>
        </p:spPr>
      </p:pic>
      <p:sp>
        <p:nvSpPr>
          <p:cNvPr id="6" name="ZoneTexte 5"/>
          <p:cNvSpPr txBox="1"/>
          <p:nvPr/>
        </p:nvSpPr>
        <p:spPr>
          <a:xfrm>
            <a:off x="604779" y="2947078"/>
            <a:ext cx="72362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Adapted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 « A </a:t>
            </a:r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conserved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 TLR5 binding and activation hot spot on </a:t>
            </a:r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flagellin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. Song </a:t>
            </a:r>
            <a:r>
              <a:rPr lang="fr-FR" sz="900" i="1" dirty="0">
                <a:latin typeface="Arial" panose="020B0604020202020204" pitchFamily="34" charset="0"/>
                <a:cs typeface="Arial" panose="020B0604020202020204" pitchFamily="34" charset="0"/>
              </a:rPr>
              <a:t>et al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., </a:t>
            </a:r>
            <a:r>
              <a:rPr lang="fr-FR" sz="900" i="1" dirty="0" err="1">
                <a:latin typeface="Arial" panose="020B0604020202020204" pitchFamily="34" charset="0"/>
                <a:cs typeface="Arial" panose="020B0604020202020204" pitchFamily="34" charset="0"/>
              </a:rPr>
              <a:t>Sci</a:t>
            </a:r>
            <a:r>
              <a:rPr lang="fr-FR" sz="900" i="1" dirty="0">
                <a:latin typeface="Arial" panose="020B0604020202020204" pitchFamily="34" charset="0"/>
                <a:cs typeface="Arial" panose="020B0604020202020204" pitchFamily="34" charset="0"/>
              </a:rPr>
              <a:t>. Reports 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(2017) »</a:t>
            </a:r>
          </a:p>
        </p:txBody>
      </p:sp>
      <p:sp>
        <p:nvSpPr>
          <p:cNvPr id="2" name="ZoneTexte 1"/>
          <p:cNvSpPr txBox="1"/>
          <p:nvPr/>
        </p:nvSpPr>
        <p:spPr>
          <a:xfrm>
            <a:off x="193240" y="152562"/>
            <a:ext cx="57499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/>
              <a:t>Sup Figure 3. </a:t>
            </a:r>
            <a:r>
              <a:rPr lang="fr-FR" sz="1600" dirty="0"/>
              <a:t>TLR5 </a:t>
            </a:r>
            <a:r>
              <a:rPr lang="fr-FR" sz="1600" dirty="0" err="1"/>
              <a:t>binding</a:t>
            </a:r>
            <a:r>
              <a:rPr lang="fr-FR" sz="1600" dirty="0"/>
              <a:t> and consensus sites in </a:t>
            </a:r>
            <a:r>
              <a:rPr lang="fr-FR" sz="1600" dirty="0" err="1"/>
              <a:t>different</a:t>
            </a:r>
            <a:r>
              <a:rPr lang="fr-FR" sz="1600" dirty="0"/>
              <a:t> </a:t>
            </a:r>
            <a:r>
              <a:rPr lang="fr-FR" sz="1600" dirty="0" err="1"/>
              <a:t>species</a:t>
            </a:r>
            <a:endParaRPr lang="fr-FR" sz="1600" dirty="0"/>
          </a:p>
        </p:txBody>
      </p:sp>
      <p:pic>
        <p:nvPicPr>
          <p:cNvPr id="20" name="Image 19" descr="Une image contenant intérieur, assis, jeu, différent&#10;&#10;Description générée automatiquement">
            <a:extLst>
              <a:ext uri="{FF2B5EF4-FFF2-40B4-BE49-F238E27FC236}">
                <a16:creationId xmlns:a16="http://schemas.microsoft.com/office/drawing/2014/main" xmlns="" id="{C3FDAF36-AA04-40E9-9B55-19261910FDA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4779" y="896293"/>
            <a:ext cx="5314592" cy="1991189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xmlns="" id="{9546C210-8818-44CF-997F-D77CEA2CDA6F}"/>
              </a:ext>
            </a:extLst>
          </p:cNvPr>
          <p:cNvSpPr txBox="1"/>
          <p:nvPr/>
        </p:nvSpPr>
        <p:spPr>
          <a:xfrm>
            <a:off x="355093" y="712553"/>
            <a:ext cx="3056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A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xmlns="" id="{C28C2246-DC22-49A6-9747-556189E5DFAF}"/>
              </a:ext>
            </a:extLst>
          </p:cNvPr>
          <p:cNvSpPr txBox="1"/>
          <p:nvPr/>
        </p:nvSpPr>
        <p:spPr>
          <a:xfrm>
            <a:off x="355093" y="3583087"/>
            <a:ext cx="3056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6235357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193240" y="152562"/>
            <a:ext cx="35871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/>
              <a:t>Sup Figure 4. </a:t>
            </a:r>
            <a:r>
              <a:rPr lang="fr-FR" sz="1600" dirty="0"/>
              <a:t>Glycosylation sites on </a:t>
            </a:r>
            <a:r>
              <a:rPr lang="fr-FR" sz="1600" dirty="0" err="1"/>
              <a:t>FlaBs</a:t>
            </a:r>
            <a:endParaRPr lang="fr-FR" sz="1600" dirty="0"/>
          </a:p>
        </p:txBody>
      </p:sp>
      <p:sp>
        <p:nvSpPr>
          <p:cNvPr id="3" name="ZoneTexte 2"/>
          <p:cNvSpPr txBox="1"/>
          <p:nvPr/>
        </p:nvSpPr>
        <p:spPr>
          <a:xfrm>
            <a:off x="414453" y="84756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ZoneTexte 4"/>
          <p:cNvSpPr txBox="1"/>
          <p:nvPr/>
        </p:nvSpPr>
        <p:spPr>
          <a:xfrm>
            <a:off x="3243826" y="84756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" name="ZoneTexte 7"/>
          <p:cNvSpPr txBox="1"/>
          <p:nvPr/>
        </p:nvSpPr>
        <p:spPr>
          <a:xfrm>
            <a:off x="414453" y="351666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0" name="Image 9" descr="Une image contenant vert, sombre, lumière, noir&#10;&#10;Description générée automatiquement">
            <a:extLst>
              <a:ext uri="{FF2B5EF4-FFF2-40B4-BE49-F238E27FC236}">
                <a16:creationId xmlns:a16="http://schemas.microsoft.com/office/drawing/2014/main" xmlns="" id="{4F01246D-A414-477C-A080-F4E2F2DC398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8811"/>
          <a:stretch/>
        </p:blipFill>
        <p:spPr>
          <a:xfrm>
            <a:off x="590142" y="4019414"/>
            <a:ext cx="2307001" cy="1872442"/>
          </a:xfrm>
          <a:prstGeom prst="rect">
            <a:avLst/>
          </a:prstGeom>
        </p:spPr>
      </p:pic>
      <p:pic>
        <p:nvPicPr>
          <p:cNvPr id="12" name="Image 11" descr="Une image contenant sombre, table, lumière, volant&#10;&#10;Description générée automatiquement">
            <a:extLst>
              <a:ext uri="{FF2B5EF4-FFF2-40B4-BE49-F238E27FC236}">
                <a16:creationId xmlns:a16="http://schemas.microsoft.com/office/drawing/2014/main" xmlns="" id="{F61F4DDB-76D9-402C-B315-AE391AFFF93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8811"/>
          <a:stretch/>
        </p:blipFill>
        <p:spPr>
          <a:xfrm>
            <a:off x="598567" y="1319044"/>
            <a:ext cx="2307001" cy="1872442"/>
          </a:xfrm>
          <a:prstGeom prst="rect">
            <a:avLst/>
          </a:prstGeom>
        </p:spPr>
      </p:pic>
      <p:sp>
        <p:nvSpPr>
          <p:cNvPr id="13" name="ZoneTexte 12">
            <a:extLst>
              <a:ext uri="{FF2B5EF4-FFF2-40B4-BE49-F238E27FC236}">
                <a16:creationId xmlns:a16="http://schemas.microsoft.com/office/drawing/2014/main" xmlns="" id="{1F41BC3C-F3AA-445F-A963-02C871EFDFCF}"/>
              </a:ext>
            </a:extLst>
          </p:cNvPr>
          <p:cNvSpPr txBox="1"/>
          <p:nvPr/>
        </p:nvSpPr>
        <p:spPr>
          <a:xfrm>
            <a:off x="598567" y="888644"/>
            <a:ext cx="229857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i="1" dirty="0">
                <a:latin typeface="Arial" panose="020B0604020202020204" pitchFamily="34" charset="0"/>
                <a:cs typeface="Arial" panose="020B0604020202020204" pitchFamily="34" charset="0"/>
              </a:rPr>
              <a:t>Treponema pallidum</a:t>
            </a:r>
          </a:p>
          <a:p>
            <a:pPr algn="ctr"/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FlaB1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xmlns="" id="{B6BB64F4-2748-4C36-8404-BBDF7EF77E8F}"/>
              </a:ext>
            </a:extLst>
          </p:cNvPr>
          <p:cNvSpPr txBox="1"/>
          <p:nvPr/>
        </p:nvSpPr>
        <p:spPr>
          <a:xfrm>
            <a:off x="609234" y="3595841"/>
            <a:ext cx="229857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i="1" dirty="0">
                <a:latin typeface="Arial" panose="020B0604020202020204" pitchFamily="34" charset="0"/>
                <a:cs typeface="Arial" panose="020B0604020202020204" pitchFamily="34" charset="0"/>
              </a:rPr>
              <a:t>Leptospira interrogans</a:t>
            </a:r>
          </a:p>
          <a:p>
            <a:pPr algn="ctr"/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FlaB1</a:t>
            </a:r>
          </a:p>
        </p:txBody>
      </p:sp>
      <p:pic>
        <p:nvPicPr>
          <p:cNvPr id="11" name="Image 10">
            <a:extLst>
              <a:ext uri="{FF2B5EF4-FFF2-40B4-BE49-F238E27FC236}">
                <a16:creationId xmlns:a16="http://schemas.microsoft.com/office/drawing/2014/main" xmlns="" id="{99264DFC-C703-4D5C-A94A-C236C7582D3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17762"/>
          <a:stretch/>
        </p:blipFill>
        <p:spPr>
          <a:xfrm>
            <a:off x="3430145" y="751624"/>
            <a:ext cx="4323471" cy="3129132"/>
          </a:xfrm>
          <a:prstGeom prst="rect">
            <a:avLst/>
          </a:prstGeom>
        </p:spPr>
      </p:pic>
      <p:sp>
        <p:nvSpPr>
          <p:cNvPr id="17" name="ZoneTexte 16">
            <a:extLst>
              <a:ext uri="{FF2B5EF4-FFF2-40B4-BE49-F238E27FC236}">
                <a16:creationId xmlns:a16="http://schemas.microsoft.com/office/drawing/2014/main" xmlns="" id="{4C48B6B3-902F-49EF-B606-ACCDEFE3A76A}"/>
              </a:ext>
            </a:extLst>
          </p:cNvPr>
          <p:cNvSpPr txBox="1"/>
          <p:nvPr/>
        </p:nvSpPr>
        <p:spPr>
          <a:xfrm>
            <a:off x="3238971" y="419362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fr-F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xmlns="" id="{07EFB881-188E-4DCF-9595-D7985BB977E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30145" y="4203821"/>
            <a:ext cx="5234333" cy="18066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4392786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417</Words>
  <Application>Microsoft Macintosh PowerPoint</Application>
  <PresentationFormat>Présentation à l'écran (4:3)</PresentationFormat>
  <Paragraphs>166</Paragraphs>
  <Slides>5</Slides>
  <Notes>4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5</vt:i4>
      </vt:variant>
    </vt:vector>
  </HeadingPairs>
  <TitlesOfParts>
    <vt:vector size="6" baseType="lpstr"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Institut Pasteu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ETEA CETEA</dc:creator>
  <cp:lastModifiedBy>CETEA CETEA</cp:lastModifiedBy>
  <cp:revision>2</cp:revision>
  <dcterms:created xsi:type="dcterms:W3CDTF">2020-05-20T14:06:49Z</dcterms:created>
  <dcterms:modified xsi:type="dcterms:W3CDTF">2020-05-20T14:21:11Z</dcterms:modified>
</cp:coreProperties>
</file>